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61" r:id="rId1"/>
  </p:sldMasterIdLst>
  <p:notesMasterIdLst>
    <p:notesMasterId r:id="rId14"/>
  </p:notesMasterIdLst>
  <p:handoutMasterIdLst>
    <p:handoutMasterId r:id="rId15"/>
  </p:handoutMasterIdLst>
  <p:sldIdLst>
    <p:sldId id="291" r:id="rId2"/>
    <p:sldId id="292" r:id="rId3"/>
    <p:sldId id="293" r:id="rId4"/>
    <p:sldId id="294" r:id="rId5"/>
    <p:sldId id="295" r:id="rId6"/>
    <p:sldId id="296" r:id="rId7"/>
    <p:sldId id="297" r:id="rId8"/>
    <p:sldId id="298" r:id="rId9"/>
    <p:sldId id="299" r:id="rId10"/>
    <p:sldId id="300" r:id="rId11"/>
    <p:sldId id="301" r:id="rId12"/>
    <p:sldId id="302" r:id="rId13"/>
  </p:sldIdLst>
  <p:sldSz cx="12192000" cy="6858000"/>
  <p:notesSz cx="9926638" cy="6797675"/>
  <p:defaultTextStyle>
    <a:defPPr>
      <a:defRPr lang="de-DE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MS PGothic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1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EC3DC"/>
    <a:srgbClr val="DEE5F6"/>
    <a:srgbClr val="003C76"/>
    <a:srgbClr val="FFC8A3"/>
    <a:srgbClr val="FF6600"/>
    <a:srgbClr val="D7E5F5"/>
    <a:srgbClr val="CBD7F1"/>
    <a:srgbClr val="ECF0FA"/>
    <a:srgbClr val="80A1C9"/>
    <a:srgbClr val="C1002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2A1E1C-AE40-4942-96A7-856CA17C2B1E}" v="322" dt="2023-10-11T08:49:08.30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1" autoAdjust="0"/>
    <p:restoredTop sz="94675" autoAdjust="0"/>
  </p:normalViewPr>
  <p:slideViewPr>
    <p:cSldViewPr>
      <p:cViewPr>
        <p:scale>
          <a:sx n="80" d="100"/>
          <a:sy n="80" d="100"/>
        </p:scale>
        <p:origin x="1200" y="636"/>
      </p:cViewPr>
      <p:guideLst>
        <p:guide orient="horz" pos="1518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ximilian Haack" userId="4ef3a4a526e72e60" providerId="LiveId" clId="{AD2A1E1C-AE40-4942-96A7-856CA17C2B1E}"/>
    <pc:docChg chg="undo custSel addSld delSld modSld sldOrd">
      <pc:chgData name="Maximilian Haack" userId="4ef3a4a526e72e60" providerId="LiveId" clId="{AD2A1E1C-AE40-4942-96A7-856CA17C2B1E}" dt="2023-10-11T08:49:08.301" v="1117"/>
      <pc:docMkLst>
        <pc:docMk/>
      </pc:docMkLst>
      <pc:sldChg chg="addSp delSp modSp mod">
        <pc:chgData name="Maximilian Haack" userId="4ef3a4a526e72e60" providerId="LiveId" clId="{AD2A1E1C-AE40-4942-96A7-856CA17C2B1E}" dt="2023-10-11T08:45:03.466" v="1082"/>
        <pc:sldMkLst>
          <pc:docMk/>
          <pc:sldMk cId="715051012" sldId="291"/>
        </pc:sldMkLst>
        <pc:spChg chg="mod">
          <ac:chgData name="Maximilian Haack" userId="4ef3a4a526e72e60" providerId="LiveId" clId="{AD2A1E1C-AE40-4942-96A7-856CA17C2B1E}" dt="2023-10-11T08:13:57.055" v="144" actId="20577"/>
          <ac:spMkLst>
            <pc:docMk/>
            <pc:sldMk cId="715051012" sldId="291"/>
            <ac:spMk id="2" creationId="{D0A753C3-2854-A481-50D6-198CD9660128}"/>
          </ac:spMkLst>
        </pc:spChg>
        <pc:spChg chg="del mod">
          <ac:chgData name="Maximilian Haack" userId="4ef3a4a526e72e60" providerId="LiveId" clId="{AD2A1E1C-AE40-4942-96A7-856CA17C2B1E}" dt="2023-10-11T08:12:25.884" v="40" actId="478"/>
          <ac:spMkLst>
            <pc:docMk/>
            <pc:sldMk cId="715051012" sldId="291"/>
            <ac:spMk id="3" creationId="{7BE5B8C8-4D7A-7CCE-DB25-672414E756AF}"/>
          </ac:spMkLst>
        </pc:spChg>
        <pc:spChg chg="add del mod">
          <ac:chgData name="Maximilian Haack" userId="4ef3a4a526e72e60" providerId="LiveId" clId="{AD2A1E1C-AE40-4942-96A7-856CA17C2B1E}" dt="2023-10-11T08:12:26.979" v="41" actId="478"/>
          <ac:spMkLst>
            <pc:docMk/>
            <pc:sldMk cId="715051012" sldId="291"/>
            <ac:spMk id="4" creationId="{57EE352A-8BB4-AC57-1300-C1240689ADE6}"/>
          </ac:spMkLst>
        </pc:spChg>
        <pc:spChg chg="add del mod">
          <ac:chgData name="Maximilian Haack" userId="4ef3a4a526e72e60" providerId="LiveId" clId="{AD2A1E1C-AE40-4942-96A7-856CA17C2B1E}" dt="2023-10-11T08:13:15.196" v="67" actId="478"/>
          <ac:spMkLst>
            <pc:docMk/>
            <pc:sldMk cId="715051012" sldId="291"/>
            <ac:spMk id="5" creationId="{2E542E28-0651-5252-BF73-6C8FF3CEBB97}"/>
          </ac:spMkLst>
        </pc:spChg>
        <pc:spChg chg="del">
          <ac:chgData name="Maximilian Haack" userId="4ef3a4a526e72e60" providerId="LiveId" clId="{AD2A1E1C-AE40-4942-96A7-856CA17C2B1E}" dt="2023-10-11T08:11:47.115" v="1" actId="478"/>
          <ac:spMkLst>
            <pc:docMk/>
            <pc:sldMk cId="715051012" sldId="291"/>
            <ac:spMk id="7" creationId="{FD41CC24-6D12-169A-5BB6-8056BBDA9C42}"/>
          </ac:spMkLst>
        </pc:spChg>
        <pc:spChg chg="add mod">
          <ac:chgData name="Maximilian Haack" userId="4ef3a4a526e72e60" providerId="LiveId" clId="{AD2A1E1C-AE40-4942-96A7-856CA17C2B1E}" dt="2023-10-11T08:13:45.534" v="141" actId="20577"/>
          <ac:spMkLst>
            <pc:docMk/>
            <pc:sldMk cId="715051012" sldId="291"/>
            <ac:spMk id="8" creationId="{18CCBF23-F1B9-B0B5-E0ED-CE1E0D1E2EFB}"/>
          </ac:spMkLst>
        </pc:spChg>
        <pc:picChg chg="del">
          <ac:chgData name="Maximilian Haack" userId="4ef3a4a526e72e60" providerId="LiveId" clId="{AD2A1E1C-AE40-4942-96A7-856CA17C2B1E}" dt="2023-10-11T08:11:44.699" v="0" actId="478"/>
          <ac:picMkLst>
            <pc:docMk/>
            <pc:sldMk cId="715051012" sldId="291"/>
            <ac:picMk id="6" creationId="{A4B75DFD-8B4F-C494-1FC2-A7DF9687A4BE}"/>
          </ac:picMkLst>
        </pc:picChg>
        <pc:picChg chg="add mod">
          <ac:chgData name="Maximilian Haack" userId="4ef3a4a526e72e60" providerId="LiveId" clId="{AD2A1E1C-AE40-4942-96A7-856CA17C2B1E}" dt="2023-10-11T08:45:03.466" v="1082"/>
          <ac:picMkLst>
            <pc:docMk/>
            <pc:sldMk cId="715051012" sldId="291"/>
            <ac:picMk id="9" creationId="{2F4BDB41-3A8C-7C25-A7EA-8625248D00DB}"/>
          </ac:picMkLst>
        </pc:picChg>
        <pc:picChg chg="add mod">
          <ac:chgData name="Maximilian Haack" userId="4ef3a4a526e72e60" providerId="LiveId" clId="{AD2A1E1C-AE40-4942-96A7-856CA17C2B1E}" dt="2023-10-11T08:45:03.466" v="1082"/>
          <ac:picMkLst>
            <pc:docMk/>
            <pc:sldMk cId="715051012" sldId="291"/>
            <ac:picMk id="10" creationId="{5ECE0D24-BDE3-6396-27F5-AA03CCEE6444}"/>
          </ac:picMkLst>
        </pc:picChg>
        <pc:picChg chg="add mod">
          <ac:chgData name="Maximilian Haack" userId="4ef3a4a526e72e60" providerId="LiveId" clId="{AD2A1E1C-AE40-4942-96A7-856CA17C2B1E}" dt="2023-10-11T08:45:03.466" v="1082"/>
          <ac:picMkLst>
            <pc:docMk/>
            <pc:sldMk cId="715051012" sldId="291"/>
            <ac:picMk id="11" creationId="{212875B9-DF84-D581-7E54-A2219C999685}"/>
          </ac:picMkLst>
        </pc:picChg>
        <pc:picChg chg="add mod">
          <ac:chgData name="Maximilian Haack" userId="4ef3a4a526e72e60" providerId="LiveId" clId="{AD2A1E1C-AE40-4942-96A7-856CA17C2B1E}" dt="2023-10-11T08:45:03.466" v="1082"/>
          <ac:picMkLst>
            <pc:docMk/>
            <pc:sldMk cId="715051012" sldId="291"/>
            <ac:picMk id="12" creationId="{C84ED256-9ACA-09BC-CFCA-FF5D8CF9AB97}"/>
          </ac:picMkLst>
        </pc:picChg>
      </pc:sldChg>
      <pc:sldChg chg="del">
        <pc:chgData name="Maximilian Haack" userId="4ef3a4a526e72e60" providerId="LiveId" clId="{AD2A1E1C-AE40-4942-96A7-856CA17C2B1E}" dt="2023-10-11T08:14:01.522" v="145" actId="47"/>
        <pc:sldMkLst>
          <pc:docMk/>
          <pc:sldMk cId="1909863606" sldId="292"/>
        </pc:sldMkLst>
      </pc:sldChg>
      <pc:sldChg chg="addSp modSp new mod modAnim">
        <pc:chgData name="Maximilian Haack" userId="4ef3a4a526e72e60" providerId="LiveId" clId="{AD2A1E1C-AE40-4942-96A7-856CA17C2B1E}" dt="2023-10-11T08:47:20.349" v="1100"/>
        <pc:sldMkLst>
          <pc:docMk/>
          <pc:sldMk cId="3543435393" sldId="292"/>
        </pc:sldMkLst>
        <pc:spChg chg="mod">
          <ac:chgData name="Maximilian Haack" userId="4ef3a4a526e72e60" providerId="LiveId" clId="{AD2A1E1C-AE40-4942-96A7-856CA17C2B1E}" dt="2023-10-11T08:14:21.268" v="155"/>
          <ac:spMkLst>
            <pc:docMk/>
            <pc:sldMk cId="3543435393" sldId="292"/>
            <ac:spMk id="2" creationId="{D63B18F7-7B99-C1F5-5113-3CFBA5920E90}"/>
          </ac:spMkLst>
        </pc:spChg>
        <pc:spChg chg="mod">
          <ac:chgData name="Maximilian Haack" userId="4ef3a4a526e72e60" providerId="LiveId" clId="{AD2A1E1C-AE40-4942-96A7-856CA17C2B1E}" dt="2023-10-11T08:33:44.658" v="696" actId="21"/>
          <ac:spMkLst>
            <pc:docMk/>
            <pc:sldMk cId="3543435393" sldId="292"/>
            <ac:spMk id="3" creationId="{5DDB54DA-E3A6-4325-2C2C-F125AA729C8A}"/>
          </ac:spMkLst>
        </pc:spChg>
        <pc:spChg chg="mod">
          <ac:chgData name="Maximilian Haack" userId="4ef3a4a526e72e60" providerId="LiveId" clId="{AD2A1E1C-AE40-4942-96A7-856CA17C2B1E}" dt="2023-10-11T08:15:10.392" v="168" actId="1076"/>
          <ac:spMkLst>
            <pc:docMk/>
            <pc:sldMk cId="3543435393" sldId="292"/>
            <ac:spMk id="4" creationId="{9E0C921F-AF42-4252-8141-14175673C5D2}"/>
          </ac:spMkLst>
        </pc:spChg>
        <pc:picChg chg="add mod">
          <ac:chgData name="Maximilian Haack" userId="4ef3a4a526e72e60" providerId="LiveId" clId="{AD2A1E1C-AE40-4942-96A7-856CA17C2B1E}" dt="2023-10-11T08:45:39.139" v="1085" actId="1076"/>
          <ac:picMkLst>
            <pc:docMk/>
            <pc:sldMk cId="3543435393" sldId="292"/>
            <ac:picMk id="5" creationId="{84A2819D-F3C5-3F27-DD42-DC7895332B5D}"/>
          </ac:picMkLst>
        </pc:picChg>
        <pc:picChg chg="add mod">
          <ac:chgData name="Maximilian Haack" userId="4ef3a4a526e72e60" providerId="LiveId" clId="{AD2A1E1C-AE40-4942-96A7-856CA17C2B1E}" dt="2023-10-11T08:45:46.203" v="1086" actId="1076"/>
          <ac:picMkLst>
            <pc:docMk/>
            <pc:sldMk cId="3543435393" sldId="292"/>
            <ac:picMk id="6" creationId="{3E0CD9C6-D776-A06F-A1E6-A0BB2164F55B}"/>
          </ac:picMkLst>
        </pc:picChg>
        <pc:picChg chg="add mod">
          <ac:chgData name="Maximilian Haack" userId="4ef3a4a526e72e60" providerId="LiveId" clId="{AD2A1E1C-AE40-4942-96A7-856CA17C2B1E}" dt="2023-10-11T08:45:49.781" v="1087" actId="1076"/>
          <ac:picMkLst>
            <pc:docMk/>
            <pc:sldMk cId="3543435393" sldId="292"/>
            <ac:picMk id="7" creationId="{9A4156EA-E881-0EA3-5F7D-3E0FCB8599BF}"/>
          </ac:picMkLst>
        </pc:picChg>
      </pc:sldChg>
      <pc:sldChg chg="addSp modSp add mod modAnim">
        <pc:chgData name="Maximilian Haack" userId="4ef3a4a526e72e60" providerId="LiveId" clId="{AD2A1E1C-AE40-4942-96A7-856CA17C2B1E}" dt="2023-10-11T08:47:38.675" v="1102"/>
        <pc:sldMkLst>
          <pc:docMk/>
          <pc:sldMk cId="1724299471" sldId="293"/>
        </pc:sldMkLst>
        <pc:spChg chg="mod">
          <ac:chgData name="Maximilian Haack" userId="4ef3a4a526e72e60" providerId="LiveId" clId="{AD2A1E1C-AE40-4942-96A7-856CA17C2B1E}" dt="2023-10-11T08:15:34.992" v="170"/>
          <ac:spMkLst>
            <pc:docMk/>
            <pc:sldMk cId="1724299471" sldId="293"/>
            <ac:spMk id="2" creationId="{D63B18F7-7B99-C1F5-5113-3CFBA5920E90}"/>
          </ac:spMkLst>
        </pc:spChg>
        <pc:spChg chg="mod">
          <ac:chgData name="Maximilian Haack" userId="4ef3a4a526e72e60" providerId="LiveId" clId="{AD2A1E1C-AE40-4942-96A7-856CA17C2B1E}" dt="2023-10-11T08:34:30.606" v="726" actId="6549"/>
          <ac:spMkLst>
            <pc:docMk/>
            <pc:sldMk cId="1724299471" sldId="293"/>
            <ac:spMk id="3" creationId="{5DDB54DA-E3A6-4325-2C2C-F125AA729C8A}"/>
          </ac:spMkLst>
        </pc:spChg>
        <pc:picChg chg="add mod">
          <ac:chgData name="Maximilian Haack" userId="4ef3a4a526e72e60" providerId="LiveId" clId="{AD2A1E1C-AE40-4942-96A7-856CA17C2B1E}" dt="2023-10-11T08:45:55.500" v="1088"/>
          <ac:picMkLst>
            <pc:docMk/>
            <pc:sldMk cId="1724299471" sldId="293"/>
            <ac:picMk id="5" creationId="{2B001872-2EE8-5787-22D0-7A2BFA7F3C2B}"/>
          </ac:picMkLst>
        </pc:picChg>
        <pc:picChg chg="add mod">
          <ac:chgData name="Maximilian Haack" userId="4ef3a4a526e72e60" providerId="LiveId" clId="{AD2A1E1C-AE40-4942-96A7-856CA17C2B1E}" dt="2023-10-11T08:45:55.500" v="1088"/>
          <ac:picMkLst>
            <pc:docMk/>
            <pc:sldMk cId="1724299471" sldId="293"/>
            <ac:picMk id="6" creationId="{B2C642E5-0AD8-0D76-A655-A3AFC5266271}"/>
          </ac:picMkLst>
        </pc:picChg>
        <pc:picChg chg="add mod">
          <ac:chgData name="Maximilian Haack" userId="4ef3a4a526e72e60" providerId="LiveId" clId="{AD2A1E1C-AE40-4942-96A7-856CA17C2B1E}" dt="2023-10-11T08:45:55.500" v="1088"/>
          <ac:picMkLst>
            <pc:docMk/>
            <pc:sldMk cId="1724299471" sldId="293"/>
            <ac:picMk id="7" creationId="{F3F4117D-E1D9-2AE4-9B14-2F13611A6E3B}"/>
          </ac:picMkLst>
        </pc:picChg>
      </pc:sldChg>
      <pc:sldChg chg="del">
        <pc:chgData name="Maximilian Haack" userId="4ef3a4a526e72e60" providerId="LiveId" clId="{AD2A1E1C-AE40-4942-96A7-856CA17C2B1E}" dt="2023-10-11T08:14:01.827" v="146" actId="47"/>
        <pc:sldMkLst>
          <pc:docMk/>
          <pc:sldMk cId="2915873918" sldId="293"/>
        </pc:sldMkLst>
      </pc:sldChg>
      <pc:sldChg chg="addSp modSp add mod modAnim">
        <pc:chgData name="Maximilian Haack" userId="4ef3a4a526e72e60" providerId="LiveId" clId="{AD2A1E1C-AE40-4942-96A7-856CA17C2B1E}" dt="2023-10-11T08:47:57.483" v="1106"/>
        <pc:sldMkLst>
          <pc:docMk/>
          <pc:sldMk cId="2596028674" sldId="294"/>
        </pc:sldMkLst>
        <pc:spChg chg="mod">
          <ac:chgData name="Maximilian Haack" userId="4ef3a4a526e72e60" providerId="LiveId" clId="{AD2A1E1C-AE40-4942-96A7-856CA17C2B1E}" dt="2023-10-11T08:16:26.563" v="199" actId="20577"/>
          <ac:spMkLst>
            <pc:docMk/>
            <pc:sldMk cId="2596028674" sldId="294"/>
            <ac:spMk id="2" creationId="{D63B18F7-7B99-C1F5-5113-3CFBA5920E90}"/>
          </ac:spMkLst>
        </pc:spChg>
        <pc:spChg chg="mod">
          <ac:chgData name="Maximilian Haack" userId="4ef3a4a526e72e60" providerId="LiveId" clId="{AD2A1E1C-AE40-4942-96A7-856CA17C2B1E}" dt="2023-10-11T08:37:07.354" v="872" actId="20577"/>
          <ac:spMkLst>
            <pc:docMk/>
            <pc:sldMk cId="2596028674" sldId="294"/>
            <ac:spMk id="3" creationId="{5DDB54DA-E3A6-4325-2C2C-F125AA729C8A}"/>
          </ac:spMkLst>
        </pc:spChg>
        <pc:picChg chg="add mod">
          <ac:chgData name="Maximilian Haack" userId="4ef3a4a526e72e60" providerId="LiveId" clId="{AD2A1E1C-AE40-4942-96A7-856CA17C2B1E}" dt="2023-10-11T08:45:56.308" v="1089"/>
          <ac:picMkLst>
            <pc:docMk/>
            <pc:sldMk cId="2596028674" sldId="294"/>
            <ac:picMk id="5" creationId="{380512F8-41A9-8D7B-64B8-C02E288B38D2}"/>
          </ac:picMkLst>
        </pc:picChg>
        <pc:picChg chg="add mod">
          <ac:chgData name="Maximilian Haack" userId="4ef3a4a526e72e60" providerId="LiveId" clId="{AD2A1E1C-AE40-4942-96A7-856CA17C2B1E}" dt="2023-10-11T08:45:56.308" v="1089"/>
          <ac:picMkLst>
            <pc:docMk/>
            <pc:sldMk cId="2596028674" sldId="294"/>
            <ac:picMk id="6" creationId="{3D369D74-0C9F-DF19-A040-2637995B3313}"/>
          </ac:picMkLst>
        </pc:picChg>
        <pc:picChg chg="add mod">
          <ac:chgData name="Maximilian Haack" userId="4ef3a4a526e72e60" providerId="LiveId" clId="{AD2A1E1C-AE40-4942-96A7-856CA17C2B1E}" dt="2023-10-11T08:45:56.308" v="1089"/>
          <ac:picMkLst>
            <pc:docMk/>
            <pc:sldMk cId="2596028674" sldId="294"/>
            <ac:picMk id="7" creationId="{0F1C0615-F34A-4E1F-F54F-D689AF1A64D3}"/>
          </ac:picMkLst>
        </pc:picChg>
      </pc:sldChg>
      <pc:sldChg chg="del">
        <pc:chgData name="Maximilian Haack" userId="4ef3a4a526e72e60" providerId="LiveId" clId="{AD2A1E1C-AE40-4942-96A7-856CA17C2B1E}" dt="2023-10-11T08:14:02.777" v="147" actId="47"/>
        <pc:sldMkLst>
          <pc:docMk/>
          <pc:sldMk cId="3387011968" sldId="294"/>
        </pc:sldMkLst>
      </pc:sldChg>
      <pc:sldChg chg="addSp modSp add mod modAnim">
        <pc:chgData name="Maximilian Haack" userId="4ef3a4a526e72e60" providerId="LiveId" clId="{AD2A1E1C-AE40-4942-96A7-856CA17C2B1E}" dt="2023-10-11T08:48:09.516" v="1108"/>
        <pc:sldMkLst>
          <pc:docMk/>
          <pc:sldMk cId="3971868680" sldId="295"/>
        </pc:sldMkLst>
        <pc:spChg chg="mod">
          <ac:chgData name="Maximilian Haack" userId="4ef3a4a526e72e60" providerId="LiveId" clId="{AD2A1E1C-AE40-4942-96A7-856CA17C2B1E}" dt="2023-10-11T08:16:51.569" v="204"/>
          <ac:spMkLst>
            <pc:docMk/>
            <pc:sldMk cId="3971868680" sldId="295"/>
            <ac:spMk id="2" creationId="{D63B18F7-7B99-C1F5-5113-3CFBA5920E90}"/>
          </ac:spMkLst>
        </pc:spChg>
        <pc:spChg chg="mod">
          <ac:chgData name="Maximilian Haack" userId="4ef3a4a526e72e60" providerId="LiveId" clId="{AD2A1E1C-AE40-4942-96A7-856CA17C2B1E}" dt="2023-10-11T08:38:37.253" v="985" actId="20577"/>
          <ac:spMkLst>
            <pc:docMk/>
            <pc:sldMk cId="3971868680" sldId="295"/>
            <ac:spMk id="3" creationId="{5DDB54DA-E3A6-4325-2C2C-F125AA729C8A}"/>
          </ac:spMkLst>
        </pc:spChg>
        <pc:picChg chg="add mod">
          <ac:chgData name="Maximilian Haack" userId="4ef3a4a526e72e60" providerId="LiveId" clId="{AD2A1E1C-AE40-4942-96A7-856CA17C2B1E}" dt="2023-10-11T08:45:57.011" v="1090"/>
          <ac:picMkLst>
            <pc:docMk/>
            <pc:sldMk cId="3971868680" sldId="295"/>
            <ac:picMk id="5" creationId="{949A4E2E-5462-9201-0E61-9EA16774C332}"/>
          </ac:picMkLst>
        </pc:picChg>
        <pc:picChg chg="add mod">
          <ac:chgData name="Maximilian Haack" userId="4ef3a4a526e72e60" providerId="LiveId" clId="{AD2A1E1C-AE40-4942-96A7-856CA17C2B1E}" dt="2023-10-11T08:45:57.011" v="1090"/>
          <ac:picMkLst>
            <pc:docMk/>
            <pc:sldMk cId="3971868680" sldId="295"/>
            <ac:picMk id="6" creationId="{55FB91D7-FF31-1691-2317-82F282DCB415}"/>
          </ac:picMkLst>
        </pc:picChg>
        <pc:picChg chg="add mod">
          <ac:chgData name="Maximilian Haack" userId="4ef3a4a526e72e60" providerId="LiveId" clId="{AD2A1E1C-AE40-4942-96A7-856CA17C2B1E}" dt="2023-10-11T08:45:57.011" v="1090"/>
          <ac:picMkLst>
            <pc:docMk/>
            <pc:sldMk cId="3971868680" sldId="295"/>
            <ac:picMk id="7" creationId="{9F035F3D-F417-A1EE-EAE4-8B0FA04F7E3A}"/>
          </ac:picMkLst>
        </pc:picChg>
      </pc:sldChg>
      <pc:sldChg chg="addSp modSp add mod modAnim">
        <pc:chgData name="Maximilian Haack" userId="4ef3a4a526e72e60" providerId="LiveId" clId="{AD2A1E1C-AE40-4942-96A7-856CA17C2B1E}" dt="2023-10-11T08:48:27.964" v="1110"/>
        <pc:sldMkLst>
          <pc:docMk/>
          <pc:sldMk cId="2437267059" sldId="296"/>
        </pc:sldMkLst>
        <pc:spChg chg="mod">
          <ac:chgData name="Maximilian Haack" userId="4ef3a4a526e72e60" providerId="LiveId" clId="{AD2A1E1C-AE40-4942-96A7-856CA17C2B1E}" dt="2023-10-11T08:17:22.650" v="207"/>
          <ac:spMkLst>
            <pc:docMk/>
            <pc:sldMk cId="2437267059" sldId="296"/>
            <ac:spMk id="2" creationId="{D63B18F7-7B99-C1F5-5113-3CFBA5920E90}"/>
          </ac:spMkLst>
        </pc:spChg>
        <pc:spChg chg="mod">
          <ac:chgData name="Maximilian Haack" userId="4ef3a4a526e72e60" providerId="LiveId" clId="{AD2A1E1C-AE40-4942-96A7-856CA17C2B1E}" dt="2023-10-11T08:40:51.643" v="1050" actId="12"/>
          <ac:spMkLst>
            <pc:docMk/>
            <pc:sldMk cId="2437267059" sldId="296"/>
            <ac:spMk id="3" creationId="{5DDB54DA-E3A6-4325-2C2C-F125AA729C8A}"/>
          </ac:spMkLst>
        </pc:spChg>
        <pc:picChg chg="add mod">
          <ac:chgData name="Maximilian Haack" userId="4ef3a4a526e72e60" providerId="LiveId" clId="{AD2A1E1C-AE40-4942-96A7-856CA17C2B1E}" dt="2023-10-11T08:45:57.708" v="1091"/>
          <ac:picMkLst>
            <pc:docMk/>
            <pc:sldMk cId="2437267059" sldId="296"/>
            <ac:picMk id="5" creationId="{DA504A15-406D-915C-1313-5FC8D45AC5B4}"/>
          </ac:picMkLst>
        </pc:picChg>
        <pc:picChg chg="add mod">
          <ac:chgData name="Maximilian Haack" userId="4ef3a4a526e72e60" providerId="LiveId" clId="{AD2A1E1C-AE40-4942-96A7-856CA17C2B1E}" dt="2023-10-11T08:45:57.708" v="1091"/>
          <ac:picMkLst>
            <pc:docMk/>
            <pc:sldMk cId="2437267059" sldId="296"/>
            <ac:picMk id="6" creationId="{669A70A6-A568-6E1C-98EB-39B46BE475EF}"/>
          </ac:picMkLst>
        </pc:picChg>
        <pc:picChg chg="add mod">
          <ac:chgData name="Maximilian Haack" userId="4ef3a4a526e72e60" providerId="LiveId" clId="{AD2A1E1C-AE40-4942-96A7-856CA17C2B1E}" dt="2023-10-11T08:45:57.708" v="1091"/>
          <ac:picMkLst>
            <pc:docMk/>
            <pc:sldMk cId="2437267059" sldId="296"/>
            <ac:picMk id="7" creationId="{B1B2B288-9F31-6CB8-5224-0715F4303A0F}"/>
          </ac:picMkLst>
        </pc:picChg>
      </pc:sldChg>
      <pc:sldChg chg="addSp modSp add mod modAnim">
        <pc:chgData name="Maximilian Haack" userId="4ef3a4a526e72e60" providerId="LiveId" clId="{AD2A1E1C-AE40-4942-96A7-856CA17C2B1E}" dt="2023-10-11T08:48:38.123" v="1112"/>
        <pc:sldMkLst>
          <pc:docMk/>
          <pc:sldMk cId="632011206" sldId="297"/>
        </pc:sldMkLst>
        <pc:spChg chg="mod">
          <ac:chgData name="Maximilian Haack" userId="4ef3a4a526e72e60" providerId="LiveId" clId="{AD2A1E1C-AE40-4942-96A7-856CA17C2B1E}" dt="2023-10-11T08:18:17.879" v="222" actId="5793"/>
          <ac:spMkLst>
            <pc:docMk/>
            <pc:sldMk cId="632011206" sldId="297"/>
            <ac:spMk id="2" creationId="{D63B18F7-7B99-C1F5-5113-3CFBA5920E90}"/>
          </ac:spMkLst>
        </pc:spChg>
        <pc:spChg chg="mod">
          <ac:chgData name="Maximilian Haack" userId="4ef3a4a526e72e60" providerId="LiveId" clId="{AD2A1E1C-AE40-4942-96A7-856CA17C2B1E}" dt="2023-10-11T08:40:57.851" v="1051" actId="12"/>
          <ac:spMkLst>
            <pc:docMk/>
            <pc:sldMk cId="632011206" sldId="297"/>
            <ac:spMk id="3" creationId="{5DDB54DA-E3A6-4325-2C2C-F125AA729C8A}"/>
          </ac:spMkLst>
        </pc:spChg>
        <pc:picChg chg="add mod">
          <ac:chgData name="Maximilian Haack" userId="4ef3a4a526e72e60" providerId="LiveId" clId="{AD2A1E1C-AE40-4942-96A7-856CA17C2B1E}" dt="2023-10-11T08:45:58.869" v="1092"/>
          <ac:picMkLst>
            <pc:docMk/>
            <pc:sldMk cId="632011206" sldId="297"/>
            <ac:picMk id="5" creationId="{742D882C-4C56-DC9F-1915-D1BBB49910D4}"/>
          </ac:picMkLst>
        </pc:picChg>
        <pc:picChg chg="add mod">
          <ac:chgData name="Maximilian Haack" userId="4ef3a4a526e72e60" providerId="LiveId" clId="{AD2A1E1C-AE40-4942-96A7-856CA17C2B1E}" dt="2023-10-11T08:45:58.869" v="1092"/>
          <ac:picMkLst>
            <pc:docMk/>
            <pc:sldMk cId="632011206" sldId="297"/>
            <ac:picMk id="6" creationId="{22E182C6-DD14-C436-EC05-DBA5D8BDAA1F}"/>
          </ac:picMkLst>
        </pc:picChg>
        <pc:picChg chg="add mod">
          <ac:chgData name="Maximilian Haack" userId="4ef3a4a526e72e60" providerId="LiveId" clId="{AD2A1E1C-AE40-4942-96A7-856CA17C2B1E}" dt="2023-10-11T08:45:58.869" v="1092"/>
          <ac:picMkLst>
            <pc:docMk/>
            <pc:sldMk cId="632011206" sldId="297"/>
            <ac:picMk id="7" creationId="{8BBC543F-78B8-BAF5-3736-EC522936D67D}"/>
          </ac:picMkLst>
        </pc:picChg>
      </pc:sldChg>
      <pc:sldChg chg="addSp delSp modSp add mod modAnim">
        <pc:chgData name="Maximilian Haack" userId="4ef3a4a526e72e60" providerId="LiveId" clId="{AD2A1E1C-AE40-4942-96A7-856CA17C2B1E}" dt="2023-10-11T08:46:00.188" v="1093"/>
        <pc:sldMkLst>
          <pc:docMk/>
          <pc:sldMk cId="2796896614" sldId="298"/>
        </pc:sldMkLst>
        <pc:spChg chg="mod">
          <ac:chgData name="Maximilian Haack" userId="4ef3a4a526e72e60" providerId="LiveId" clId="{AD2A1E1C-AE40-4942-96A7-856CA17C2B1E}" dt="2023-10-11T08:19:40.511" v="292" actId="26606"/>
          <ac:spMkLst>
            <pc:docMk/>
            <pc:sldMk cId="2796896614" sldId="298"/>
            <ac:spMk id="2" creationId="{D63B18F7-7B99-C1F5-5113-3CFBA5920E90}"/>
          </ac:spMkLst>
        </pc:spChg>
        <pc:spChg chg="del mod">
          <ac:chgData name="Maximilian Haack" userId="4ef3a4a526e72e60" providerId="LiveId" clId="{AD2A1E1C-AE40-4942-96A7-856CA17C2B1E}" dt="2023-10-11T08:19:33.437" v="291"/>
          <ac:spMkLst>
            <pc:docMk/>
            <pc:sldMk cId="2796896614" sldId="298"/>
            <ac:spMk id="3" creationId="{5DDB54DA-E3A6-4325-2C2C-F125AA729C8A}"/>
          </ac:spMkLst>
        </pc:spChg>
        <pc:spChg chg="mod ord">
          <ac:chgData name="Maximilian Haack" userId="4ef3a4a526e72e60" providerId="LiveId" clId="{AD2A1E1C-AE40-4942-96A7-856CA17C2B1E}" dt="2023-10-11T08:19:40.511" v="292" actId="26606"/>
          <ac:spMkLst>
            <pc:docMk/>
            <pc:sldMk cId="2796896614" sldId="298"/>
            <ac:spMk id="4" creationId="{9E0C921F-AF42-4252-8141-14175673C5D2}"/>
          </ac:spMkLst>
        </pc:spChg>
        <pc:spChg chg="add mod">
          <ac:chgData name="Maximilian Haack" userId="4ef3a4a526e72e60" providerId="LiveId" clId="{AD2A1E1C-AE40-4942-96A7-856CA17C2B1E}" dt="2023-10-11T08:20:26.301" v="299" actId="207"/>
          <ac:spMkLst>
            <pc:docMk/>
            <pc:sldMk cId="2796896614" sldId="298"/>
            <ac:spMk id="6" creationId="{12FB120E-CA8D-3ABE-F453-DE3032AC8E9E}"/>
          </ac:spMkLst>
        </pc:spChg>
        <pc:picChg chg="add mod">
          <ac:chgData name="Maximilian Haack" userId="4ef3a4a526e72e60" providerId="LiveId" clId="{AD2A1E1C-AE40-4942-96A7-856CA17C2B1E}" dt="2023-10-11T08:20:44.231" v="300" actId="1076"/>
          <ac:picMkLst>
            <pc:docMk/>
            <pc:sldMk cId="2796896614" sldId="298"/>
            <ac:picMk id="5" creationId="{A232AAA3-4143-32AA-C1F1-12EAD571F536}"/>
          </ac:picMkLst>
        </pc:picChg>
        <pc:picChg chg="add mod">
          <ac:chgData name="Maximilian Haack" userId="4ef3a4a526e72e60" providerId="LiveId" clId="{AD2A1E1C-AE40-4942-96A7-856CA17C2B1E}" dt="2023-10-11T08:46:00.188" v="1093"/>
          <ac:picMkLst>
            <pc:docMk/>
            <pc:sldMk cId="2796896614" sldId="298"/>
            <ac:picMk id="7" creationId="{713ED113-65C0-89DC-4EAD-E1F9A2D61095}"/>
          </ac:picMkLst>
        </pc:picChg>
        <pc:picChg chg="add mod">
          <ac:chgData name="Maximilian Haack" userId="4ef3a4a526e72e60" providerId="LiveId" clId="{AD2A1E1C-AE40-4942-96A7-856CA17C2B1E}" dt="2023-10-11T08:46:00.188" v="1093"/>
          <ac:picMkLst>
            <pc:docMk/>
            <pc:sldMk cId="2796896614" sldId="298"/>
            <ac:picMk id="8" creationId="{9BF32E20-4627-D6B5-4513-42775FF2FA4F}"/>
          </ac:picMkLst>
        </pc:picChg>
        <pc:picChg chg="add mod">
          <ac:chgData name="Maximilian Haack" userId="4ef3a4a526e72e60" providerId="LiveId" clId="{AD2A1E1C-AE40-4942-96A7-856CA17C2B1E}" dt="2023-10-11T08:46:00.188" v="1093"/>
          <ac:picMkLst>
            <pc:docMk/>
            <pc:sldMk cId="2796896614" sldId="298"/>
            <ac:picMk id="9" creationId="{D503F772-880A-6BC7-C753-F8BE48AFB71B}"/>
          </ac:picMkLst>
        </pc:picChg>
      </pc:sldChg>
      <pc:sldChg chg="addSp modSp add mod ord modAnim">
        <pc:chgData name="Maximilian Haack" userId="4ef3a4a526e72e60" providerId="LiveId" clId="{AD2A1E1C-AE40-4942-96A7-856CA17C2B1E}" dt="2023-10-11T08:48:52.355" v="1114"/>
        <pc:sldMkLst>
          <pc:docMk/>
          <pc:sldMk cId="290014328" sldId="299"/>
        </pc:sldMkLst>
        <pc:spChg chg="mod">
          <ac:chgData name="Maximilian Haack" userId="4ef3a4a526e72e60" providerId="LiveId" clId="{AD2A1E1C-AE40-4942-96A7-856CA17C2B1E}" dt="2023-10-11T08:21:14.240" v="340" actId="20577"/>
          <ac:spMkLst>
            <pc:docMk/>
            <pc:sldMk cId="290014328" sldId="299"/>
            <ac:spMk id="2" creationId="{D63B18F7-7B99-C1F5-5113-3CFBA5920E90}"/>
          </ac:spMkLst>
        </pc:spChg>
        <pc:spChg chg="mod">
          <ac:chgData name="Maximilian Haack" userId="4ef3a4a526e72e60" providerId="LiveId" clId="{AD2A1E1C-AE40-4942-96A7-856CA17C2B1E}" dt="2023-10-11T08:41:08.775" v="1053" actId="12"/>
          <ac:spMkLst>
            <pc:docMk/>
            <pc:sldMk cId="290014328" sldId="299"/>
            <ac:spMk id="3" creationId="{5DDB54DA-E3A6-4325-2C2C-F125AA729C8A}"/>
          </ac:spMkLst>
        </pc:spChg>
        <pc:picChg chg="add mod">
          <ac:chgData name="Maximilian Haack" userId="4ef3a4a526e72e60" providerId="LiveId" clId="{AD2A1E1C-AE40-4942-96A7-856CA17C2B1E}" dt="2023-10-11T08:46:01.206" v="1094"/>
          <ac:picMkLst>
            <pc:docMk/>
            <pc:sldMk cId="290014328" sldId="299"/>
            <ac:picMk id="5" creationId="{6227B7A9-057E-0A53-4FCC-F5AEB9953A41}"/>
          </ac:picMkLst>
        </pc:picChg>
        <pc:picChg chg="add mod">
          <ac:chgData name="Maximilian Haack" userId="4ef3a4a526e72e60" providerId="LiveId" clId="{AD2A1E1C-AE40-4942-96A7-856CA17C2B1E}" dt="2023-10-11T08:46:01.206" v="1094"/>
          <ac:picMkLst>
            <pc:docMk/>
            <pc:sldMk cId="290014328" sldId="299"/>
            <ac:picMk id="6" creationId="{AE7C04F8-FD5F-21D6-6385-8BE5013E53CB}"/>
          </ac:picMkLst>
        </pc:picChg>
        <pc:picChg chg="add mod">
          <ac:chgData name="Maximilian Haack" userId="4ef3a4a526e72e60" providerId="LiveId" clId="{AD2A1E1C-AE40-4942-96A7-856CA17C2B1E}" dt="2023-10-11T08:46:01.206" v="1094"/>
          <ac:picMkLst>
            <pc:docMk/>
            <pc:sldMk cId="290014328" sldId="299"/>
            <ac:picMk id="7" creationId="{9822C850-B83C-6BE4-22B1-FDEEE4A51B2B}"/>
          </ac:picMkLst>
        </pc:picChg>
      </pc:sldChg>
      <pc:sldChg chg="del">
        <pc:chgData name="Maximilian Haack" userId="4ef3a4a526e72e60" providerId="LiveId" clId="{AD2A1E1C-AE40-4942-96A7-856CA17C2B1E}" dt="2023-10-11T08:14:05.031" v="153" actId="47"/>
        <pc:sldMkLst>
          <pc:docMk/>
          <pc:sldMk cId="3668443679" sldId="299"/>
        </pc:sldMkLst>
      </pc:sldChg>
      <pc:sldChg chg="del">
        <pc:chgData name="Maximilian Haack" userId="4ef3a4a526e72e60" providerId="LiveId" clId="{AD2A1E1C-AE40-4942-96A7-856CA17C2B1E}" dt="2023-10-11T08:14:02.801" v="149" actId="47"/>
        <pc:sldMkLst>
          <pc:docMk/>
          <pc:sldMk cId="389854890" sldId="300"/>
        </pc:sldMkLst>
      </pc:sldChg>
      <pc:sldChg chg="addSp modSp add mod modAnim">
        <pc:chgData name="Maximilian Haack" userId="4ef3a4a526e72e60" providerId="LiveId" clId="{AD2A1E1C-AE40-4942-96A7-856CA17C2B1E}" dt="2023-10-11T08:49:02.594" v="1116"/>
        <pc:sldMkLst>
          <pc:docMk/>
          <pc:sldMk cId="884257397" sldId="300"/>
        </pc:sldMkLst>
        <pc:spChg chg="mod">
          <ac:chgData name="Maximilian Haack" userId="4ef3a4a526e72e60" providerId="LiveId" clId="{AD2A1E1C-AE40-4942-96A7-856CA17C2B1E}" dt="2023-10-11T08:22:23.172" v="358" actId="120"/>
          <ac:spMkLst>
            <pc:docMk/>
            <pc:sldMk cId="884257397" sldId="300"/>
            <ac:spMk id="2" creationId="{D63B18F7-7B99-C1F5-5113-3CFBA5920E90}"/>
          </ac:spMkLst>
        </pc:spChg>
        <pc:spChg chg="mod">
          <ac:chgData name="Maximilian Haack" userId="4ef3a4a526e72e60" providerId="LiveId" clId="{AD2A1E1C-AE40-4942-96A7-856CA17C2B1E}" dt="2023-10-11T08:22:47.151" v="363" actId="20577"/>
          <ac:spMkLst>
            <pc:docMk/>
            <pc:sldMk cId="884257397" sldId="300"/>
            <ac:spMk id="3" creationId="{5DDB54DA-E3A6-4325-2C2C-F125AA729C8A}"/>
          </ac:spMkLst>
        </pc:spChg>
        <pc:picChg chg="add mod">
          <ac:chgData name="Maximilian Haack" userId="4ef3a4a526e72e60" providerId="LiveId" clId="{AD2A1E1C-AE40-4942-96A7-856CA17C2B1E}" dt="2023-10-11T08:46:02.260" v="1095"/>
          <ac:picMkLst>
            <pc:docMk/>
            <pc:sldMk cId="884257397" sldId="300"/>
            <ac:picMk id="5" creationId="{F3EF094B-2BC4-97F6-C5C1-F7CFA0197486}"/>
          </ac:picMkLst>
        </pc:picChg>
        <pc:picChg chg="add mod">
          <ac:chgData name="Maximilian Haack" userId="4ef3a4a526e72e60" providerId="LiveId" clId="{AD2A1E1C-AE40-4942-96A7-856CA17C2B1E}" dt="2023-10-11T08:46:02.260" v="1095"/>
          <ac:picMkLst>
            <pc:docMk/>
            <pc:sldMk cId="884257397" sldId="300"/>
            <ac:picMk id="6" creationId="{A88507EB-79B0-BE85-733D-1294D43FB36C}"/>
          </ac:picMkLst>
        </pc:picChg>
        <pc:picChg chg="add mod">
          <ac:chgData name="Maximilian Haack" userId="4ef3a4a526e72e60" providerId="LiveId" clId="{AD2A1E1C-AE40-4942-96A7-856CA17C2B1E}" dt="2023-10-11T08:46:02.260" v="1095"/>
          <ac:picMkLst>
            <pc:docMk/>
            <pc:sldMk cId="884257397" sldId="300"/>
            <ac:picMk id="7" creationId="{60889F80-8C7F-DB04-31D4-D8433D260C4B}"/>
          </ac:picMkLst>
        </pc:picChg>
      </pc:sldChg>
      <pc:sldChg chg="del">
        <pc:chgData name="Maximilian Haack" userId="4ef3a4a526e72e60" providerId="LiveId" clId="{AD2A1E1C-AE40-4942-96A7-856CA17C2B1E}" dt="2023-10-11T08:14:02.812" v="150" actId="47"/>
        <pc:sldMkLst>
          <pc:docMk/>
          <pc:sldMk cId="2274294669" sldId="301"/>
        </pc:sldMkLst>
      </pc:sldChg>
      <pc:sldChg chg="addSp delSp modSp add mod ord modAnim">
        <pc:chgData name="Maximilian Haack" userId="4ef3a4a526e72e60" providerId="LiveId" clId="{AD2A1E1C-AE40-4942-96A7-856CA17C2B1E}" dt="2023-10-11T08:49:08.301" v="1117"/>
        <pc:sldMkLst>
          <pc:docMk/>
          <pc:sldMk cId="3165844271" sldId="301"/>
        </pc:sldMkLst>
        <pc:spChg chg="mod">
          <ac:chgData name="Maximilian Haack" userId="4ef3a4a526e72e60" providerId="LiveId" clId="{AD2A1E1C-AE40-4942-96A7-856CA17C2B1E}" dt="2023-10-11T08:23:28.261" v="420" actId="20577"/>
          <ac:spMkLst>
            <pc:docMk/>
            <pc:sldMk cId="3165844271" sldId="301"/>
            <ac:spMk id="2" creationId="{D63B18F7-7B99-C1F5-5113-3CFBA5920E90}"/>
          </ac:spMkLst>
        </pc:spChg>
        <pc:spChg chg="del mod">
          <ac:chgData name="Maximilian Haack" userId="4ef3a4a526e72e60" providerId="LiveId" clId="{AD2A1E1C-AE40-4942-96A7-856CA17C2B1E}" dt="2023-10-11T08:24:08.427" v="422" actId="1032"/>
          <ac:spMkLst>
            <pc:docMk/>
            <pc:sldMk cId="3165844271" sldId="301"/>
            <ac:spMk id="3" creationId="{5DDB54DA-E3A6-4325-2C2C-F125AA729C8A}"/>
          </ac:spMkLst>
        </pc:spChg>
        <pc:graphicFrameChg chg="add mod modGraphic">
          <ac:chgData name="Maximilian Haack" userId="4ef3a4a526e72e60" providerId="LiveId" clId="{AD2A1E1C-AE40-4942-96A7-856CA17C2B1E}" dt="2023-10-11T08:29:37.114" v="682"/>
          <ac:graphicFrameMkLst>
            <pc:docMk/>
            <pc:sldMk cId="3165844271" sldId="301"/>
            <ac:graphicFrameMk id="5" creationId="{FC219F13-A8CB-37F4-518F-650AE12F1B2C}"/>
          </ac:graphicFrameMkLst>
        </pc:graphicFrameChg>
        <pc:picChg chg="add mod">
          <ac:chgData name="Maximilian Haack" userId="4ef3a4a526e72e60" providerId="LiveId" clId="{AD2A1E1C-AE40-4942-96A7-856CA17C2B1E}" dt="2023-10-11T08:46:03.684" v="1096"/>
          <ac:picMkLst>
            <pc:docMk/>
            <pc:sldMk cId="3165844271" sldId="301"/>
            <ac:picMk id="6" creationId="{4CEC9F6F-9D74-7198-E284-37C85E8D26F1}"/>
          </ac:picMkLst>
        </pc:picChg>
        <pc:picChg chg="add mod">
          <ac:chgData name="Maximilian Haack" userId="4ef3a4a526e72e60" providerId="LiveId" clId="{AD2A1E1C-AE40-4942-96A7-856CA17C2B1E}" dt="2023-10-11T08:46:03.684" v="1096"/>
          <ac:picMkLst>
            <pc:docMk/>
            <pc:sldMk cId="3165844271" sldId="301"/>
            <ac:picMk id="7" creationId="{FAC34715-1B21-BC6B-89E9-45387764EFF8}"/>
          </ac:picMkLst>
        </pc:picChg>
        <pc:picChg chg="add mod">
          <ac:chgData name="Maximilian Haack" userId="4ef3a4a526e72e60" providerId="LiveId" clId="{AD2A1E1C-AE40-4942-96A7-856CA17C2B1E}" dt="2023-10-11T08:46:03.684" v="1096"/>
          <ac:picMkLst>
            <pc:docMk/>
            <pc:sldMk cId="3165844271" sldId="301"/>
            <ac:picMk id="8" creationId="{11862510-F04D-CEE0-793E-E15CB537F18A}"/>
          </ac:picMkLst>
        </pc:picChg>
      </pc:sldChg>
      <pc:sldChg chg="addSp delSp modSp add mod ord">
        <pc:chgData name="Maximilian Haack" userId="4ef3a4a526e72e60" providerId="LiveId" clId="{AD2A1E1C-AE40-4942-96A7-856CA17C2B1E}" dt="2023-10-11T08:44:53.449" v="1081" actId="207"/>
        <pc:sldMkLst>
          <pc:docMk/>
          <pc:sldMk cId="358093711" sldId="302"/>
        </pc:sldMkLst>
        <pc:spChg chg="mod">
          <ac:chgData name="Maximilian Haack" userId="4ef3a4a526e72e60" providerId="LiveId" clId="{AD2A1E1C-AE40-4942-96A7-856CA17C2B1E}" dt="2023-10-11T08:44:53.449" v="1081" actId="207"/>
          <ac:spMkLst>
            <pc:docMk/>
            <pc:sldMk cId="358093711" sldId="302"/>
            <ac:spMk id="2" creationId="{D0A753C3-2854-A481-50D6-198CD9660128}"/>
          </ac:spMkLst>
        </pc:spChg>
        <pc:spChg chg="del">
          <ac:chgData name="Maximilian Haack" userId="4ef3a4a526e72e60" providerId="LiveId" clId="{AD2A1E1C-AE40-4942-96A7-856CA17C2B1E}" dt="2023-10-11T08:30:26.911" v="691" actId="478"/>
          <ac:spMkLst>
            <pc:docMk/>
            <pc:sldMk cId="358093711" sldId="302"/>
            <ac:spMk id="8" creationId="{18CCBF23-F1B9-B0B5-E0ED-CE1E0D1E2EFB}"/>
          </ac:spMkLst>
        </pc:spChg>
        <pc:picChg chg="add mod">
          <ac:chgData name="Maximilian Haack" userId="4ef3a4a526e72e60" providerId="LiveId" clId="{AD2A1E1C-AE40-4942-96A7-856CA17C2B1E}" dt="2023-10-11T08:31:56.708" v="695" actId="14100"/>
          <ac:picMkLst>
            <pc:docMk/>
            <pc:sldMk cId="358093711" sldId="302"/>
            <ac:picMk id="4" creationId="{8E737E8B-34C1-A774-F86A-671F84028709}"/>
          </ac:picMkLst>
        </pc:picChg>
        <pc:picChg chg="add mod">
          <ac:chgData name="Maximilian Haack" userId="4ef3a4a526e72e60" providerId="LiveId" clId="{AD2A1E1C-AE40-4942-96A7-856CA17C2B1E}" dt="2023-10-11T08:43:52.094" v="1070" actId="1076"/>
          <ac:picMkLst>
            <pc:docMk/>
            <pc:sldMk cId="358093711" sldId="302"/>
            <ac:picMk id="5" creationId="{C4D3DDCB-5B5D-96D1-C58B-DF8A95F93ECC}"/>
          </ac:picMkLst>
        </pc:picChg>
        <pc:picChg chg="add mod">
          <ac:chgData name="Maximilian Haack" userId="4ef3a4a526e72e60" providerId="LiveId" clId="{AD2A1E1C-AE40-4942-96A7-856CA17C2B1E}" dt="2023-10-11T08:44:11.821" v="1075" actId="1076"/>
          <ac:picMkLst>
            <pc:docMk/>
            <pc:sldMk cId="358093711" sldId="302"/>
            <ac:picMk id="6" creationId="{02B76035-5C88-53E7-8B41-AA2469EEBDCD}"/>
          </ac:picMkLst>
        </pc:picChg>
        <pc:picChg chg="add mod">
          <ac:chgData name="Maximilian Haack" userId="4ef3a4a526e72e60" providerId="LiveId" clId="{AD2A1E1C-AE40-4942-96A7-856CA17C2B1E}" dt="2023-10-11T08:44:11.821" v="1075" actId="1076"/>
          <ac:picMkLst>
            <pc:docMk/>
            <pc:sldMk cId="358093711" sldId="302"/>
            <ac:picMk id="7" creationId="{79ABD4C7-C16A-F317-04AE-33DDC6DCDA92}"/>
          </ac:picMkLst>
        </pc:picChg>
      </pc:sldChg>
      <pc:sldChg chg="del">
        <pc:chgData name="Maximilian Haack" userId="4ef3a4a526e72e60" providerId="LiveId" clId="{AD2A1E1C-AE40-4942-96A7-856CA17C2B1E}" dt="2023-10-11T08:14:03.145" v="151" actId="47"/>
        <pc:sldMkLst>
          <pc:docMk/>
          <pc:sldMk cId="2616373104" sldId="302"/>
        </pc:sldMkLst>
      </pc:sldChg>
      <pc:sldChg chg="add del ord">
        <pc:chgData name="Maximilian Haack" userId="4ef3a4a526e72e60" providerId="LiveId" clId="{AD2A1E1C-AE40-4942-96A7-856CA17C2B1E}" dt="2023-10-11T08:30:11.110" v="686" actId="47"/>
        <pc:sldMkLst>
          <pc:docMk/>
          <pc:sldMk cId="3502807254" sldId="302"/>
        </pc:sldMkLst>
      </pc:sldChg>
      <pc:sldChg chg="del">
        <pc:chgData name="Maximilian Haack" userId="4ef3a4a526e72e60" providerId="LiveId" clId="{AD2A1E1C-AE40-4942-96A7-856CA17C2B1E}" dt="2023-10-11T08:14:04.616" v="152" actId="47"/>
        <pc:sldMkLst>
          <pc:docMk/>
          <pc:sldMk cId="512806614" sldId="303"/>
        </pc:sldMkLst>
      </pc:sldChg>
      <pc:sldChg chg="del">
        <pc:chgData name="Maximilian Haack" userId="4ef3a4a526e72e60" providerId="LiveId" clId="{AD2A1E1C-AE40-4942-96A7-856CA17C2B1E}" dt="2023-10-11T08:14:02.787" v="148" actId="47"/>
        <pc:sldMkLst>
          <pc:docMk/>
          <pc:sldMk cId="1945606515" sldId="304"/>
        </pc:sldMkLst>
      </pc:sld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0D2516F9-36E8-43F7-8178-2A479A61C9CC}" type="doc">
      <dgm:prSet loTypeId="urn:microsoft.com/office/officeart/2005/8/layout/hierarchy3" loCatId="hierarchy" qsTypeId="urn:microsoft.com/office/officeart/2005/8/quickstyle/3d1" qsCatId="3D" csTypeId="urn:microsoft.com/office/officeart/2005/8/colors/accent0_1" csCatId="mainScheme" phldr="1"/>
      <dgm:spPr/>
      <dgm:t>
        <a:bodyPr/>
        <a:lstStyle/>
        <a:p>
          <a:endParaRPr lang="de-DE"/>
        </a:p>
      </dgm:t>
    </dgm:pt>
    <dgm:pt modelId="{00A3F489-AE79-441E-AFB1-74C5B85ADB18}">
      <dgm:prSet phldrT="[Text]"/>
      <dgm:spPr>
        <a:solidFill>
          <a:srgbClr val="AEC3DC"/>
        </a:solidFill>
      </dgm:spPr>
      <dgm:t>
        <a:bodyPr/>
        <a:lstStyle/>
        <a:p>
          <a:r>
            <a:rPr lang="de-DE" dirty="0">
              <a:solidFill>
                <a:srgbClr val="003C76"/>
              </a:solidFill>
            </a:rPr>
            <a:t>Niedriges Risiko</a:t>
          </a:r>
        </a:p>
      </dgm:t>
    </dgm:pt>
    <dgm:pt modelId="{CE76459C-FDCC-475F-8A55-A616D6CEE1E7}" type="parTrans" cxnId="{8D99C27D-B0C4-4D01-846F-83B3163F3A8B}">
      <dgm:prSet/>
      <dgm:spPr/>
      <dgm:t>
        <a:bodyPr/>
        <a:lstStyle/>
        <a:p>
          <a:endParaRPr lang="de-DE">
            <a:solidFill>
              <a:srgbClr val="003C76"/>
            </a:solidFill>
          </a:endParaRPr>
        </a:p>
      </dgm:t>
    </dgm:pt>
    <dgm:pt modelId="{1F664FFA-97CF-4A2C-9624-90645E333DBF}" type="sibTrans" cxnId="{8D99C27D-B0C4-4D01-846F-83B3163F3A8B}">
      <dgm:prSet/>
      <dgm:spPr/>
      <dgm:t>
        <a:bodyPr/>
        <a:lstStyle/>
        <a:p>
          <a:endParaRPr lang="de-DE">
            <a:solidFill>
              <a:srgbClr val="003C76"/>
            </a:solidFill>
          </a:endParaRPr>
        </a:p>
      </dgm:t>
    </dgm:pt>
    <dgm:pt modelId="{A3EB205A-7335-417D-8C0D-7D38B19603BA}">
      <dgm:prSet phldrT="[Text]" custT="1"/>
      <dgm:spPr/>
      <dgm:t>
        <a:bodyPr/>
        <a:lstStyle/>
        <a:p>
          <a:r>
            <a:rPr lang="de-DE" sz="1400" b="1" dirty="0">
              <a:solidFill>
                <a:srgbClr val="003C76"/>
              </a:solidFill>
            </a:rPr>
            <a:t>Aktive Überwachung</a:t>
          </a:r>
        </a:p>
      </dgm:t>
    </dgm:pt>
    <dgm:pt modelId="{E739AE60-1174-437C-A0FA-BF4E99B047C3}" type="parTrans" cxnId="{E84A5951-480D-4194-8BD1-53379A085982}">
      <dgm:prSet/>
      <dgm:spPr/>
      <dgm:t>
        <a:bodyPr/>
        <a:lstStyle/>
        <a:p>
          <a:endParaRPr lang="de-DE">
            <a:solidFill>
              <a:srgbClr val="003C76"/>
            </a:solidFill>
          </a:endParaRPr>
        </a:p>
      </dgm:t>
    </dgm:pt>
    <dgm:pt modelId="{06F37383-589F-4B51-90E7-A4A48A88A9C2}" type="sibTrans" cxnId="{E84A5951-480D-4194-8BD1-53379A085982}">
      <dgm:prSet/>
      <dgm:spPr/>
      <dgm:t>
        <a:bodyPr/>
        <a:lstStyle/>
        <a:p>
          <a:endParaRPr lang="de-DE">
            <a:solidFill>
              <a:srgbClr val="003C76"/>
            </a:solidFill>
          </a:endParaRPr>
        </a:p>
      </dgm:t>
    </dgm:pt>
    <dgm:pt modelId="{787A8881-D0CD-433C-9882-933C5DE20F34}">
      <dgm:prSet phldrT="[Text]"/>
      <dgm:spPr>
        <a:solidFill>
          <a:srgbClr val="AEC3DC"/>
        </a:solidFill>
      </dgm:spPr>
      <dgm:t>
        <a:bodyPr/>
        <a:lstStyle/>
        <a:p>
          <a:r>
            <a:rPr lang="de-DE" dirty="0">
              <a:solidFill>
                <a:srgbClr val="003C76"/>
              </a:solidFill>
            </a:rPr>
            <a:t>Mittleres Risiko</a:t>
          </a:r>
        </a:p>
      </dgm:t>
    </dgm:pt>
    <dgm:pt modelId="{74FEB521-8F09-4DE9-BAA0-D5BAC2B0C43B}" type="parTrans" cxnId="{8E6E0D81-1305-4ACA-B8A3-B06070058CE3}">
      <dgm:prSet/>
      <dgm:spPr/>
      <dgm:t>
        <a:bodyPr/>
        <a:lstStyle/>
        <a:p>
          <a:endParaRPr lang="de-DE">
            <a:solidFill>
              <a:srgbClr val="003C76"/>
            </a:solidFill>
          </a:endParaRPr>
        </a:p>
      </dgm:t>
    </dgm:pt>
    <dgm:pt modelId="{09DE215A-91C4-4781-B12A-020AFCA821BA}" type="sibTrans" cxnId="{8E6E0D81-1305-4ACA-B8A3-B06070058CE3}">
      <dgm:prSet/>
      <dgm:spPr/>
      <dgm:t>
        <a:bodyPr/>
        <a:lstStyle/>
        <a:p>
          <a:endParaRPr lang="de-DE">
            <a:solidFill>
              <a:srgbClr val="003C76"/>
            </a:solidFill>
          </a:endParaRPr>
        </a:p>
      </dgm:t>
    </dgm:pt>
    <dgm:pt modelId="{D0EE089E-A3F3-4804-AEBC-B313C665609B}">
      <dgm:prSet phldrT="[Text]" custT="1"/>
      <dgm:spPr/>
      <dgm:t>
        <a:bodyPr/>
        <a:lstStyle/>
        <a:p>
          <a:r>
            <a:rPr lang="de-DE" sz="1400" b="1" dirty="0" err="1">
              <a:solidFill>
                <a:srgbClr val="003C76"/>
              </a:solidFill>
            </a:rPr>
            <a:t>Staging</a:t>
          </a:r>
          <a:r>
            <a:rPr lang="de-DE" sz="1400" b="1" dirty="0">
              <a:solidFill>
                <a:srgbClr val="003C76"/>
              </a:solidFill>
            </a:rPr>
            <a:t> CT + Skelett-szintigraphie / PSMA-PET</a:t>
          </a:r>
        </a:p>
      </dgm:t>
    </dgm:pt>
    <dgm:pt modelId="{8AE97119-D071-4F96-9019-2A87154A1761}" type="parTrans" cxnId="{38FE7065-DA02-4AF2-A513-70660B8B4E7C}">
      <dgm:prSet/>
      <dgm:spPr/>
      <dgm:t>
        <a:bodyPr/>
        <a:lstStyle/>
        <a:p>
          <a:endParaRPr lang="de-DE">
            <a:solidFill>
              <a:srgbClr val="003C76"/>
            </a:solidFill>
          </a:endParaRPr>
        </a:p>
      </dgm:t>
    </dgm:pt>
    <dgm:pt modelId="{EA7CD7C5-F9B3-45CA-858A-024DB6399A9D}" type="sibTrans" cxnId="{38FE7065-DA02-4AF2-A513-70660B8B4E7C}">
      <dgm:prSet/>
      <dgm:spPr/>
      <dgm:t>
        <a:bodyPr/>
        <a:lstStyle/>
        <a:p>
          <a:endParaRPr lang="de-DE">
            <a:solidFill>
              <a:srgbClr val="003C76"/>
            </a:solidFill>
          </a:endParaRPr>
        </a:p>
      </dgm:t>
    </dgm:pt>
    <dgm:pt modelId="{CA6714CE-CED3-4C37-BB20-8E99A704C543}">
      <dgm:prSet phldrT="[Text]"/>
      <dgm:spPr>
        <a:solidFill>
          <a:srgbClr val="AEC3DC"/>
        </a:solidFill>
      </dgm:spPr>
      <dgm:t>
        <a:bodyPr/>
        <a:lstStyle/>
        <a:p>
          <a:r>
            <a:rPr lang="de-DE" dirty="0">
              <a:solidFill>
                <a:srgbClr val="003C76"/>
              </a:solidFill>
            </a:rPr>
            <a:t>Hohes Risiko</a:t>
          </a:r>
        </a:p>
      </dgm:t>
    </dgm:pt>
    <dgm:pt modelId="{46E51098-8B4B-496F-82CE-86C1E2858374}" type="parTrans" cxnId="{A6F7DD14-F666-418F-BECD-A6DC6920ADBB}">
      <dgm:prSet/>
      <dgm:spPr/>
      <dgm:t>
        <a:bodyPr/>
        <a:lstStyle/>
        <a:p>
          <a:endParaRPr lang="de-DE"/>
        </a:p>
      </dgm:t>
    </dgm:pt>
    <dgm:pt modelId="{43A0F979-237F-4A6F-9A0A-D1F4CB66773E}" type="sibTrans" cxnId="{A6F7DD14-F666-418F-BECD-A6DC6920ADBB}">
      <dgm:prSet/>
      <dgm:spPr/>
      <dgm:t>
        <a:bodyPr/>
        <a:lstStyle/>
        <a:p>
          <a:endParaRPr lang="de-DE"/>
        </a:p>
      </dgm:t>
    </dgm:pt>
    <dgm:pt modelId="{26ABD6DE-4BBA-417C-828E-A953F5A131DA}">
      <dgm:prSet phldrT="[Text]" custT="1"/>
      <dgm:spPr/>
      <dgm:t>
        <a:bodyPr/>
        <a:lstStyle/>
        <a:p>
          <a:r>
            <a:rPr lang="de-DE" sz="1400" b="1">
              <a:solidFill>
                <a:srgbClr val="003C76"/>
              </a:solidFill>
            </a:rPr>
            <a:t>Operative Prostata-Entfernung</a:t>
          </a:r>
          <a:endParaRPr lang="de-DE" sz="1400" b="1" dirty="0">
            <a:solidFill>
              <a:srgbClr val="003C76"/>
            </a:solidFill>
          </a:endParaRPr>
        </a:p>
      </dgm:t>
    </dgm:pt>
    <dgm:pt modelId="{3C7A37AD-7696-433D-878B-26CA31FF8D36}" type="parTrans" cxnId="{D5A3F5E5-55F6-4621-80F8-D340691ADD37}">
      <dgm:prSet/>
      <dgm:spPr/>
      <dgm:t>
        <a:bodyPr/>
        <a:lstStyle/>
        <a:p>
          <a:endParaRPr lang="de-DE"/>
        </a:p>
      </dgm:t>
    </dgm:pt>
    <dgm:pt modelId="{19600381-52E9-4B71-92A2-CDD56438AF90}" type="sibTrans" cxnId="{D5A3F5E5-55F6-4621-80F8-D340691ADD37}">
      <dgm:prSet/>
      <dgm:spPr/>
      <dgm:t>
        <a:bodyPr/>
        <a:lstStyle/>
        <a:p>
          <a:endParaRPr lang="de-DE"/>
        </a:p>
      </dgm:t>
    </dgm:pt>
    <dgm:pt modelId="{44A35BEF-2B08-498A-A112-64C1E5AAC70B}">
      <dgm:prSet phldrT="[Text]" custT="1"/>
      <dgm:spPr/>
      <dgm:t>
        <a:bodyPr/>
        <a:lstStyle/>
        <a:p>
          <a:r>
            <a:rPr lang="de-DE" sz="1400" b="1" dirty="0">
              <a:solidFill>
                <a:srgbClr val="003C76"/>
              </a:solidFill>
            </a:rPr>
            <a:t>Bestrahlung</a:t>
          </a:r>
        </a:p>
      </dgm:t>
    </dgm:pt>
    <dgm:pt modelId="{0906F88E-847E-4F62-B076-A3FF580D98DF}" type="parTrans" cxnId="{E441F7DC-5EEB-4A49-BE78-DAFBBBC5F2F8}">
      <dgm:prSet/>
      <dgm:spPr/>
      <dgm:t>
        <a:bodyPr/>
        <a:lstStyle/>
        <a:p>
          <a:endParaRPr lang="de-DE"/>
        </a:p>
      </dgm:t>
    </dgm:pt>
    <dgm:pt modelId="{6C47D4B8-E8BD-425D-AE0E-760B60222A03}" type="sibTrans" cxnId="{E441F7DC-5EEB-4A49-BE78-DAFBBBC5F2F8}">
      <dgm:prSet/>
      <dgm:spPr/>
      <dgm:t>
        <a:bodyPr/>
        <a:lstStyle/>
        <a:p>
          <a:endParaRPr lang="de-DE"/>
        </a:p>
      </dgm:t>
    </dgm:pt>
    <dgm:pt modelId="{2BAF2A2F-45A6-4664-8255-082F963CBDF7}">
      <dgm:prSet phldrT="[Text]" custT="1"/>
      <dgm:spPr/>
      <dgm:t>
        <a:bodyPr/>
        <a:lstStyle/>
        <a:p>
          <a:r>
            <a:rPr lang="de-DE" sz="1400" b="1">
              <a:solidFill>
                <a:srgbClr val="003C76"/>
              </a:solidFill>
            </a:rPr>
            <a:t>Operative Prostata-Entfernung</a:t>
          </a:r>
          <a:endParaRPr lang="de-DE" sz="1400" b="1" dirty="0">
            <a:solidFill>
              <a:srgbClr val="003C76"/>
            </a:solidFill>
          </a:endParaRPr>
        </a:p>
      </dgm:t>
    </dgm:pt>
    <dgm:pt modelId="{FD9A5399-805B-4CFE-8608-26B816E61D61}" type="parTrans" cxnId="{2B05171A-57BD-427B-B6D4-ABC3F96CA10F}">
      <dgm:prSet/>
      <dgm:spPr/>
      <dgm:t>
        <a:bodyPr/>
        <a:lstStyle/>
        <a:p>
          <a:endParaRPr lang="de-DE"/>
        </a:p>
      </dgm:t>
    </dgm:pt>
    <dgm:pt modelId="{9DB8F2FD-9E0F-473B-8DDC-D11F6C44C17C}" type="sibTrans" cxnId="{2B05171A-57BD-427B-B6D4-ABC3F96CA10F}">
      <dgm:prSet/>
      <dgm:spPr/>
      <dgm:t>
        <a:bodyPr/>
        <a:lstStyle/>
        <a:p>
          <a:endParaRPr lang="de-DE"/>
        </a:p>
      </dgm:t>
    </dgm:pt>
    <dgm:pt modelId="{9C14943B-A949-4215-B9C3-6F10F79BB13B}">
      <dgm:prSet phldrT="[Text]" custT="1"/>
      <dgm:spPr/>
      <dgm:t>
        <a:bodyPr/>
        <a:lstStyle/>
        <a:p>
          <a:r>
            <a:rPr lang="de-DE" sz="1400" b="1" dirty="0">
              <a:solidFill>
                <a:srgbClr val="003C76"/>
              </a:solidFill>
            </a:rPr>
            <a:t>Bestrahlung</a:t>
          </a:r>
        </a:p>
      </dgm:t>
    </dgm:pt>
    <dgm:pt modelId="{E6E0E4C7-6AEE-479F-AC3D-B9DD8A4B6093}" type="parTrans" cxnId="{446B10D4-E075-4727-A696-C1466101E49B}">
      <dgm:prSet/>
      <dgm:spPr/>
      <dgm:t>
        <a:bodyPr/>
        <a:lstStyle/>
        <a:p>
          <a:endParaRPr lang="de-DE"/>
        </a:p>
      </dgm:t>
    </dgm:pt>
    <dgm:pt modelId="{C7A0E317-9924-4EA3-86E8-D7A12E6266CE}" type="sibTrans" cxnId="{446B10D4-E075-4727-A696-C1466101E49B}">
      <dgm:prSet/>
      <dgm:spPr/>
      <dgm:t>
        <a:bodyPr/>
        <a:lstStyle/>
        <a:p>
          <a:endParaRPr lang="de-DE"/>
        </a:p>
      </dgm:t>
    </dgm:pt>
    <dgm:pt modelId="{F29D841F-DE69-4F6F-9061-E7971721D89D}">
      <dgm:prSet phldrT="[Text]" custT="1"/>
      <dgm:spPr/>
      <dgm:t>
        <a:bodyPr/>
        <a:lstStyle/>
        <a:p>
          <a:r>
            <a:rPr lang="de-DE" sz="1400" b="1" dirty="0">
              <a:solidFill>
                <a:srgbClr val="003C76"/>
              </a:solidFill>
            </a:rPr>
            <a:t>Operative Prostata-Entfernung</a:t>
          </a:r>
        </a:p>
      </dgm:t>
    </dgm:pt>
    <dgm:pt modelId="{92970940-BA5D-4458-92EC-B3F42223C450}" type="parTrans" cxnId="{50A9083B-6DB7-4C5A-BD69-00518391F36C}">
      <dgm:prSet/>
      <dgm:spPr/>
      <dgm:t>
        <a:bodyPr/>
        <a:lstStyle/>
        <a:p>
          <a:endParaRPr lang="de-DE"/>
        </a:p>
      </dgm:t>
    </dgm:pt>
    <dgm:pt modelId="{4B9B8BA7-AB8B-4D39-8A26-E36258597DCD}" type="sibTrans" cxnId="{50A9083B-6DB7-4C5A-BD69-00518391F36C}">
      <dgm:prSet/>
      <dgm:spPr/>
      <dgm:t>
        <a:bodyPr/>
        <a:lstStyle/>
        <a:p>
          <a:endParaRPr lang="de-DE"/>
        </a:p>
      </dgm:t>
    </dgm:pt>
    <dgm:pt modelId="{2B1B3797-5CB3-4450-A726-0B436F983D92}">
      <dgm:prSet phldrT="[Text]" custT="1"/>
      <dgm:spPr/>
      <dgm:t>
        <a:bodyPr/>
        <a:lstStyle/>
        <a:p>
          <a:r>
            <a:rPr lang="de-DE" sz="1400" b="1" dirty="0">
              <a:solidFill>
                <a:srgbClr val="003C76"/>
              </a:solidFill>
            </a:rPr>
            <a:t>Bestrahlung</a:t>
          </a:r>
        </a:p>
      </dgm:t>
    </dgm:pt>
    <dgm:pt modelId="{F2313045-E9E3-4D0B-B444-BC816DDC1B0A}" type="parTrans" cxnId="{539F8593-9F21-4DDD-9410-3025A94481BE}">
      <dgm:prSet/>
      <dgm:spPr/>
      <dgm:t>
        <a:bodyPr/>
        <a:lstStyle/>
        <a:p>
          <a:endParaRPr lang="de-DE"/>
        </a:p>
      </dgm:t>
    </dgm:pt>
    <dgm:pt modelId="{B628EADF-E822-49B3-8A50-9A39C54D6D21}" type="sibTrans" cxnId="{539F8593-9F21-4DDD-9410-3025A94481BE}">
      <dgm:prSet/>
      <dgm:spPr/>
      <dgm:t>
        <a:bodyPr/>
        <a:lstStyle/>
        <a:p>
          <a:endParaRPr lang="de-DE"/>
        </a:p>
      </dgm:t>
    </dgm:pt>
    <dgm:pt modelId="{EA0CE722-190B-4903-BDD7-D11B8E633021}" type="pres">
      <dgm:prSet presAssocID="{0D2516F9-36E8-43F7-8178-2A479A61C9CC}" presName="diagram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D9572294-9ECF-40E3-A7D0-153CC80A6544}" type="pres">
      <dgm:prSet presAssocID="{00A3F489-AE79-441E-AFB1-74C5B85ADB18}" presName="root" presStyleCnt="0"/>
      <dgm:spPr/>
    </dgm:pt>
    <dgm:pt modelId="{919C363B-BF1C-4769-9B78-FE349509328F}" type="pres">
      <dgm:prSet presAssocID="{00A3F489-AE79-441E-AFB1-74C5B85ADB18}" presName="rootComposite" presStyleCnt="0"/>
      <dgm:spPr/>
    </dgm:pt>
    <dgm:pt modelId="{DE55AABB-94E3-490E-A88C-F2955391CA07}" type="pres">
      <dgm:prSet presAssocID="{00A3F489-AE79-441E-AFB1-74C5B85ADB18}" presName="rootText" presStyleLbl="node1" presStyleIdx="0" presStyleCnt="3"/>
      <dgm:spPr/>
    </dgm:pt>
    <dgm:pt modelId="{E6CFE863-0F57-45B1-948C-9B6BAF8C7CE1}" type="pres">
      <dgm:prSet presAssocID="{00A3F489-AE79-441E-AFB1-74C5B85ADB18}" presName="rootConnector" presStyleLbl="node1" presStyleIdx="0" presStyleCnt="3"/>
      <dgm:spPr/>
    </dgm:pt>
    <dgm:pt modelId="{B63E1C90-46EF-4D73-A73D-CA1E51356E9A}" type="pres">
      <dgm:prSet presAssocID="{00A3F489-AE79-441E-AFB1-74C5B85ADB18}" presName="childShape" presStyleCnt="0"/>
      <dgm:spPr/>
    </dgm:pt>
    <dgm:pt modelId="{09BAD2D3-D226-4F56-8031-E6C2584976C5}" type="pres">
      <dgm:prSet presAssocID="{E739AE60-1174-437C-A0FA-BF4E99B047C3}" presName="Name13" presStyleLbl="parChTrans1D2" presStyleIdx="0" presStyleCnt="8"/>
      <dgm:spPr/>
    </dgm:pt>
    <dgm:pt modelId="{DF41455E-EFA7-4193-88A2-8024EB6E2A1C}" type="pres">
      <dgm:prSet presAssocID="{A3EB205A-7335-417D-8C0D-7D38B19603BA}" presName="childText" presStyleLbl="bgAcc1" presStyleIdx="0" presStyleCnt="8">
        <dgm:presLayoutVars>
          <dgm:bulletEnabled val="1"/>
        </dgm:presLayoutVars>
      </dgm:prSet>
      <dgm:spPr/>
    </dgm:pt>
    <dgm:pt modelId="{D9F3AD56-FBD4-4D24-AEA8-90DEBB22CB73}" type="pres">
      <dgm:prSet presAssocID="{3C7A37AD-7696-433D-878B-26CA31FF8D36}" presName="Name13" presStyleLbl="parChTrans1D2" presStyleIdx="1" presStyleCnt="8"/>
      <dgm:spPr/>
    </dgm:pt>
    <dgm:pt modelId="{44999A4B-8255-42FE-B911-7E45F44C2310}" type="pres">
      <dgm:prSet presAssocID="{26ABD6DE-4BBA-417C-828E-A953F5A131DA}" presName="childText" presStyleLbl="bgAcc1" presStyleIdx="1" presStyleCnt="8">
        <dgm:presLayoutVars>
          <dgm:bulletEnabled val="1"/>
        </dgm:presLayoutVars>
      </dgm:prSet>
      <dgm:spPr/>
    </dgm:pt>
    <dgm:pt modelId="{EA76B3C1-B6E7-407B-850D-C7AD52781F26}" type="pres">
      <dgm:prSet presAssocID="{0906F88E-847E-4F62-B076-A3FF580D98DF}" presName="Name13" presStyleLbl="parChTrans1D2" presStyleIdx="2" presStyleCnt="8"/>
      <dgm:spPr/>
    </dgm:pt>
    <dgm:pt modelId="{7EFD0A9B-D7A9-4FD8-B28B-9CE8F87ED1EA}" type="pres">
      <dgm:prSet presAssocID="{44A35BEF-2B08-498A-A112-64C1E5AAC70B}" presName="childText" presStyleLbl="bgAcc1" presStyleIdx="2" presStyleCnt="8">
        <dgm:presLayoutVars>
          <dgm:bulletEnabled val="1"/>
        </dgm:presLayoutVars>
      </dgm:prSet>
      <dgm:spPr/>
    </dgm:pt>
    <dgm:pt modelId="{987FD100-543B-4C70-ACF4-DEAD0F42AF1C}" type="pres">
      <dgm:prSet presAssocID="{787A8881-D0CD-433C-9882-933C5DE20F34}" presName="root" presStyleCnt="0"/>
      <dgm:spPr/>
    </dgm:pt>
    <dgm:pt modelId="{5D508F41-A856-444C-B80A-D0641159BF6E}" type="pres">
      <dgm:prSet presAssocID="{787A8881-D0CD-433C-9882-933C5DE20F34}" presName="rootComposite" presStyleCnt="0"/>
      <dgm:spPr/>
    </dgm:pt>
    <dgm:pt modelId="{0642A0FC-64D1-464E-8CD4-8587A3C42FE7}" type="pres">
      <dgm:prSet presAssocID="{787A8881-D0CD-433C-9882-933C5DE20F34}" presName="rootText" presStyleLbl="node1" presStyleIdx="1" presStyleCnt="3"/>
      <dgm:spPr/>
    </dgm:pt>
    <dgm:pt modelId="{7BB9488B-4A16-4F39-B11F-2D5F19449636}" type="pres">
      <dgm:prSet presAssocID="{787A8881-D0CD-433C-9882-933C5DE20F34}" presName="rootConnector" presStyleLbl="node1" presStyleIdx="1" presStyleCnt="3"/>
      <dgm:spPr/>
    </dgm:pt>
    <dgm:pt modelId="{8666E096-D699-4C9D-B176-9B41CB7FC01C}" type="pres">
      <dgm:prSet presAssocID="{787A8881-D0CD-433C-9882-933C5DE20F34}" presName="childShape" presStyleCnt="0"/>
      <dgm:spPr/>
    </dgm:pt>
    <dgm:pt modelId="{6395974D-D17A-4DC2-A7B3-66E8EC0027DA}" type="pres">
      <dgm:prSet presAssocID="{FD9A5399-805B-4CFE-8608-26B816E61D61}" presName="Name13" presStyleLbl="parChTrans1D2" presStyleIdx="3" presStyleCnt="8"/>
      <dgm:spPr/>
    </dgm:pt>
    <dgm:pt modelId="{BDF40D99-87A0-4261-9932-460B3851E4B0}" type="pres">
      <dgm:prSet presAssocID="{2BAF2A2F-45A6-4664-8255-082F963CBDF7}" presName="childText" presStyleLbl="bgAcc1" presStyleIdx="3" presStyleCnt="8">
        <dgm:presLayoutVars>
          <dgm:bulletEnabled val="1"/>
        </dgm:presLayoutVars>
      </dgm:prSet>
      <dgm:spPr/>
    </dgm:pt>
    <dgm:pt modelId="{25FC5CEF-B198-420B-9F23-171E535F4643}" type="pres">
      <dgm:prSet presAssocID="{E6E0E4C7-6AEE-479F-AC3D-B9DD8A4B6093}" presName="Name13" presStyleLbl="parChTrans1D2" presStyleIdx="4" presStyleCnt="8"/>
      <dgm:spPr/>
    </dgm:pt>
    <dgm:pt modelId="{AA6772D9-9A0F-4138-8C0E-C0C130C1B781}" type="pres">
      <dgm:prSet presAssocID="{9C14943B-A949-4215-B9C3-6F10F79BB13B}" presName="childText" presStyleLbl="bgAcc1" presStyleIdx="4" presStyleCnt="8">
        <dgm:presLayoutVars>
          <dgm:bulletEnabled val="1"/>
        </dgm:presLayoutVars>
      </dgm:prSet>
      <dgm:spPr/>
    </dgm:pt>
    <dgm:pt modelId="{4A73D403-F384-4338-9B01-7AB7260A4F7E}" type="pres">
      <dgm:prSet presAssocID="{CA6714CE-CED3-4C37-BB20-8E99A704C543}" presName="root" presStyleCnt="0"/>
      <dgm:spPr/>
    </dgm:pt>
    <dgm:pt modelId="{493333E6-8D73-4F6F-8390-32D2B924ADFA}" type="pres">
      <dgm:prSet presAssocID="{CA6714CE-CED3-4C37-BB20-8E99A704C543}" presName="rootComposite" presStyleCnt="0"/>
      <dgm:spPr/>
    </dgm:pt>
    <dgm:pt modelId="{BFD94402-3B84-47FD-A087-ACD3E5F67F16}" type="pres">
      <dgm:prSet presAssocID="{CA6714CE-CED3-4C37-BB20-8E99A704C543}" presName="rootText" presStyleLbl="node1" presStyleIdx="2" presStyleCnt="3"/>
      <dgm:spPr/>
    </dgm:pt>
    <dgm:pt modelId="{3B206625-4566-4FED-9207-610F30214115}" type="pres">
      <dgm:prSet presAssocID="{CA6714CE-CED3-4C37-BB20-8E99A704C543}" presName="rootConnector" presStyleLbl="node1" presStyleIdx="2" presStyleCnt="3"/>
      <dgm:spPr/>
    </dgm:pt>
    <dgm:pt modelId="{BFD4C4E4-000D-496B-90F0-E044E4C31A6F}" type="pres">
      <dgm:prSet presAssocID="{CA6714CE-CED3-4C37-BB20-8E99A704C543}" presName="childShape" presStyleCnt="0"/>
      <dgm:spPr/>
    </dgm:pt>
    <dgm:pt modelId="{12DF270E-78D5-4462-AF65-A8269158EB94}" type="pres">
      <dgm:prSet presAssocID="{8AE97119-D071-4F96-9019-2A87154A1761}" presName="Name13" presStyleLbl="parChTrans1D2" presStyleIdx="5" presStyleCnt="8"/>
      <dgm:spPr/>
    </dgm:pt>
    <dgm:pt modelId="{7DA4381C-52EB-481A-B109-A1FB2F2E0365}" type="pres">
      <dgm:prSet presAssocID="{D0EE089E-A3F3-4804-AEBC-B313C665609B}" presName="childText" presStyleLbl="bgAcc1" presStyleIdx="5" presStyleCnt="8">
        <dgm:presLayoutVars>
          <dgm:bulletEnabled val="1"/>
        </dgm:presLayoutVars>
      </dgm:prSet>
      <dgm:spPr/>
    </dgm:pt>
    <dgm:pt modelId="{F0012A88-327F-4E0A-89FD-83BA65DDE8A7}" type="pres">
      <dgm:prSet presAssocID="{92970940-BA5D-4458-92EC-B3F42223C450}" presName="Name13" presStyleLbl="parChTrans1D2" presStyleIdx="6" presStyleCnt="8"/>
      <dgm:spPr/>
    </dgm:pt>
    <dgm:pt modelId="{75D0D84E-A846-4EF1-A182-80695FDEBAEA}" type="pres">
      <dgm:prSet presAssocID="{F29D841F-DE69-4F6F-9061-E7971721D89D}" presName="childText" presStyleLbl="bgAcc1" presStyleIdx="6" presStyleCnt="8">
        <dgm:presLayoutVars>
          <dgm:bulletEnabled val="1"/>
        </dgm:presLayoutVars>
      </dgm:prSet>
      <dgm:spPr/>
    </dgm:pt>
    <dgm:pt modelId="{D823A3EF-6E9A-4197-B268-7972E365F054}" type="pres">
      <dgm:prSet presAssocID="{F2313045-E9E3-4D0B-B444-BC816DDC1B0A}" presName="Name13" presStyleLbl="parChTrans1D2" presStyleIdx="7" presStyleCnt="8"/>
      <dgm:spPr/>
    </dgm:pt>
    <dgm:pt modelId="{FE4325DB-36ED-4070-9496-FC47B2545D1D}" type="pres">
      <dgm:prSet presAssocID="{2B1B3797-5CB3-4450-A726-0B436F983D92}" presName="childText" presStyleLbl="bgAcc1" presStyleIdx="7" presStyleCnt="8">
        <dgm:presLayoutVars>
          <dgm:bulletEnabled val="1"/>
        </dgm:presLayoutVars>
      </dgm:prSet>
      <dgm:spPr/>
    </dgm:pt>
  </dgm:ptLst>
  <dgm:cxnLst>
    <dgm:cxn modelId="{A6F7DD14-F666-418F-BECD-A6DC6920ADBB}" srcId="{0D2516F9-36E8-43F7-8178-2A479A61C9CC}" destId="{CA6714CE-CED3-4C37-BB20-8E99A704C543}" srcOrd="2" destOrd="0" parTransId="{46E51098-8B4B-496F-82CE-86C1E2858374}" sibTransId="{43A0F979-237F-4A6F-9A0A-D1F4CB66773E}"/>
    <dgm:cxn modelId="{2B05171A-57BD-427B-B6D4-ABC3F96CA10F}" srcId="{787A8881-D0CD-433C-9882-933C5DE20F34}" destId="{2BAF2A2F-45A6-4664-8255-082F963CBDF7}" srcOrd="0" destOrd="0" parTransId="{FD9A5399-805B-4CFE-8608-26B816E61D61}" sibTransId="{9DB8F2FD-9E0F-473B-8DDC-D11F6C44C17C}"/>
    <dgm:cxn modelId="{8C901C1E-6D2D-4CE4-94F9-A9774FA08F88}" type="presOf" srcId="{0D2516F9-36E8-43F7-8178-2A479A61C9CC}" destId="{EA0CE722-190B-4903-BDD7-D11B8E633021}" srcOrd="0" destOrd="0" presId="urn:microsoft.com/office/officeart/2005/8/layout/hierarchy3"/>
    <dgm:cxn modelId="{5DBF7A1F-F407-4888-A9F3-33FB6E244367}" type="presOf" srcId="{E739AE60-1174-437C-A0FA-BF4E99B047C3}" destId="{09BAD2D3-D226-4F56-8031-E6C2584976C5}" srcOrd="0" destOrd="0" presId="urn:microsoft.com/office/officeart/2005/8/layout/hierarchy3"/>
    <dgm:cxn modelId="{D0260727-B5D6-4D9D-8784-1B55A0ACE27A}" type="presOf" srcId="{00A3F489-AE79-441E-AFB1-74C5B85ADB18}" destId="{DE55AABB-94E3-490E-A88C-F2955391CA07}" srcOrd="0" destOrd="0" presId="urn:microsoft.com/office/officeart/2005/8/layout/hierarchy3"/>
    <dgm:cxn modelId="{4EF49E31-7B3B-426F-B42C-E019DB2319ED}" type="presOf" srcId="{FD9A5399-805B-4CFE-8608-26B816E61D61}" destId="{6395974D-D17A-4DC2-A7B3-66E8EC0027DA}" srcOrd="0" destOrd="0" presId="urn:microsoft.com/office/officeart/2005/8/layout/hierarchy3"/>
    <dgm:cxn modelId="{50A9083B-6DB7-4C5A-BD69-00518391F36C}" srcId="{CA6714CE-CED3-4C37-BB20-8E99A704C543}" destId="{F29D841F-DE69-4F6F-9061-E7971721D89D}" srcOrd="1" destOrd="0" parTransId="{92970940-BA5D-4458-92EC-B3F42223C450}" sibTransId="{4B9B8BA7-AB8B-4D39-8A26-E36258597DCD}"/>
    <dgm:cxn modelId="{5AD35B3D-2641-449A-8DC3-5BC32E8DF85D}" type="presOf" srcId="{0906F88E-847E-4F62-B076-A3FF580D98DF}" destId="{EA76B3C1-B6E7-407B-850D-C7AD52781F26}" srcOrd="0" destOrd="0" presId="urn:microsoft.com/office/officeart/2005/8/layout/hierarchy3"/>
    <dgm:cxn modelId="{38FE7065-DA02-4AF2-A513-70660B8B4E7C}" srcId="{CA6714CE-CED3-4C37-BB20-8E99A704C543}" destId="{D0EE089E-A3F3-4804-AEBC-B313C665609B}" srcOrd="0" destOrd="0" parTransId="{8AE97119-D071-4F96-9019-2A87154A1761}" sibTransId="{EA7CD7C5-F9B3-45CA-858A-024DB6399A9D}"/>
    <dgm:cxn modelId="{EB14566A-B467-4F5E-B3FA-BF13A515E106}" type="presOf" srcId="{F2313045-E9E3-4D0B-B444-BC816DDC1B0A}" destId="{D823A3EF-6E9A-4197-B268-7972E365F054}" srcOrd="0" destOrd="0" presId="urn:microsoft.com/office/officeart/2005/8/layout/hierarchy3"/>
    <dgm:cxn modelId="{2B8C0E4B-239D-4680-ADFA-365A5F58F456}" type="presOf" srcId="{9C14943B-A949-4215-B9C3-6F10F79BB13B}" destId="{AA6772D9-9A0F-4138-8C0E-C0C130C1B781}" srcOrd="0" destOrd="0" presId="urn:microsoft.com/office/officeart/2005/8/layout/hierarchy3"/>
    <dgm:cxn modelId="{F14BC84D-3B83-4244-B166-9D2133891BCC}" type="presOf" srcId="{CA6714CE-CED3-4C37-BB20-8E99A704C543}" destId="{3B206625-4566-4FED-9207-610F30214115}" srcOrd="1" destOrd="0" presId="urn:microsoft.com/office/officeart/2005/8/layout/hierarchy3"/>
    <dgm:cxn modelId="{E84A5951-480D-4194-8BD1-53379A085982}" srcId="{00A3F489-AE79-441E-AFB1-74C5B85ADB18}" destId="{A3EB205A-7335-417D-8C0D-7D38B19603BA}" srcOrd="0" destOrd="0" parTransId="{E739AE60-1174-437C-A0FA-BF4E99B047C3}" sibTransId="{06F37383-589F-4B51-90E7-A4A48A88A9C2}"/>
    <dgm:cxn modelId="{9D23E353-A5DC-4667-A8F7-E5DC2EB6589F}" type="presOf" srcId="{F29D841F-DE69-4F6F-9061-E7971721D89D}" destId="{75D0D84E-A846-4EF1-A182-80695FDEBAEA}" srcOrd="0" destOrd="0" presId="urn:microsoft.com/office/officeart/2005/8/layout/hierarchy3"/>
    <dgm:cxn modelId="{108F6674-FE37-48E0-B267-B239E5DA91B6}" type="presOf" srcId="{8AE97119-D071-4F96-9019-2A87154A1761}" destId="{12DF270E-78D5-4462-AF65-A8269158EB94}" srcOrd="0" destOrd="0" presId="urn:microsoft.com/office/officeart/2005/8/layout/hierarchy3"/>
    <dgm:cxn modelId="{340A5156-BC5F-4879-8003-23ADC0767ED9}" type="presOf" srcId="{26ABD6DE-4BBA-417C-828E-A953F5A131DA}" destId="{44999A4B-8255-42FE-B911-7E45F44C2310}" srcOrd="0" destOrd="0" presId="urn:microsoft.com/office/officeart/2005/8/layout/hierarchy3"/>
    <dgm:cxn modelId="{8D99C27D-B0C4-4D01-846F-83B3163F3A8B}" srcId="{0D2516F9-36E8-43F7-8178-2A479A61C9CC}" destId="{00A3F489-AE79-441E-AFB1-74C5B85ADB18}" srcOrd="0" destOrd="0" parTransId="{CE76459C-FDCC-475F-8A55-A616D6CEE1E7}" sibTransId="{1F664FFA-97CF-4A2C-9624-90645E333DBF}"/>
    <dgm:cxn modelId="{8E6E0D81-1305-4ACA-B8A3-B06070058CE3}" srcId="{0D2516F9-36E8-43F7-8178-2A479A61C9CC}" destId="{787A8881-D0CD-433C-9882-933C5DE20F34}" srcOrd="1" destOrd="0" parTransId="{74FEB521-8F09-4DE9-BAA0-D5BAC2B0C43B}" sibTransId="{09DE215A-91C4-4781-B12A-020AFCA821BA}"/>
    <dgm:cxn modelId="{226EBD83-66AA-4D7B-8561-C7D4FE508751}" type="presOf" srcId="{787A8881-D0CD-433C-9882-933C5DE20F34}" destId="{7BB9488B-4A16-4F39-B11F-2D5F19449636}" srcOrd="1" destOrd="0" presId="urn:microsoft.com/office/officeart/2005/8/layout/hierarchy3"/>
    <dgm:cxn modelId="{6F91A090-28F0-4D24-BB8A-C3833D2CA27F}" type="presOf" srcId="{44A35BEF-2B08-498A-A112-64C1E5AAC70B}" destId="{7EFD0A9B-D7A9-4FD8-B28B-9CE8F87ED1EA}" srcOrd="0" destOrd="0" presId="urn:microsoft.com/office/officeart/2005/8/layout/hierarchy3"/>
    <dgm:cxn modelId="{539F8593-9F21-4DDD-9410-3025A94481BE}" srcId="{CA6714CE-CED3-4C37-BB20-8E99A704C543}" destId="{2B1B3797-5CB3-4450-A726-0B436F983D92}" srcOrd="2" destOrd="0" parTransId="{F2313045-E9E3-4D0B-B444-BC816DDC1B0A}" sibTransId="{B628EADF-E822-49B3-8A50-9A39C54D6D21}"/>
    <dgm:cxn modelId="{FBB47C94-7ED0-4C73-B561-20F4E832090E}" type="presOf" srcId="{3C7A37AD-7696-433D-878B-26CA31FF8D36}" destId="{D9F3AD56-FBD4-4D24-AEA8-90DEBB22CB73}" srcOrd="0" destOrd="0" presId="urn:microsoft.com/office/officeart/2005/8/layout/hierarchy3"/>
    <dgm:cxn modelId="{4B986796-4793-44DF-A664-6D63F0EBE9A4}" type="presOf" srcId="{2B1B3797-5CB3-4450-A726-0B436F983D92}" destId="{FE4325DB-36ED-4070-9496-FC47B2545D1D}" srcOrd="0" destOrd="0" presId="urn:microsoft.com/office/officeart/2005/8/layout/hierarchy3"/>
    <dgm:cxn modelId="{C71159AF-DE7A-4CD7-B42A-8F6BB0D6B759}" type="presOf" srcId="{787A8881-D0CD-433C-9882-933C5DE20F34}" destId="{0642A0FC-64D1-464E-8CD4-8587A3C42FE7}" srcOrd="0" destOrd="0" presId="urn:microsoft.com/office/officeart/2005/8/layout/hierarchy3"/>
    <dgm:cxn modelId="{4025ABB0-F934-4E8E-9FFF-4ADDF7D81F5F}" type="presOf" srcId="{2BAF2A2F-45A6-4664-8255-082F963CBDF7}" destId="{BDF40D99-87A0-4261-9932-460B3851E4B0}" srcOrd="0" destOrd="0" presId="urn:microsoft.com/office/officeart/2005/8/layout/hierarchy3"/>
    <dgm:cxn modelId="{51BA64B2-5152-43A8-823F-6104EA826AED}" type="presOf" srcId="{D0EE089E-A3F3-4804-AEBC-B313C665609B}" destId="{7DA4381C-52EB-481A-B109-A1FB2F2E0365}" srcOrd="0" destOrd="0" presId="urn:microsoft.com/office/officeart/2005/8/layout/hierarchy3"/>
    <dgm:cxn modelId="{5D5654B7-6737-44D9-A2F7-9D75FB68BF31}" type="presOf" srcId="{00A3F489-AE79-441E-AFB1-74C5B85ADB18}" destId="{E6CFE863-0F57-45B1-948C-9B6BAF8C7CE1}" srcOrd="1" destOrd="0" presId="urn:microsoft.com/office/officeart/2005/8/layout/hierarchy3"/>
    <dgm:cxn modelId="{F1A4A7D1-6BF7-48C8-9377-F3B8EE4DADE6}" type="presOf" srcId="{CA6714CE-CED3-4C37-BB20-8E99A704C543}" destId="{BFD94402-3B84-47FD-A087-ACD3E5F67F16}" srcOrd="0" destOrd="0" presId="urn:microsoft.com/office/officeart/2005/8/layout/hierarchy3"/>
    <dgm:cxn modelId="{B2DF3CD2-5610-4A5C-99D5-5E27B49E9961}" type="presOf" srcId="{92970940-BA5D-4458-92EC-B3F42223C450}" destId="{F0012A88-327F-4E0A-89FD-83BA65DDE8A7}" srcOrd="0" destOrd="0" presId="urn:microsoft.com/office/officeart/2005/8/layout/hierarchy3"/>
    <dgm:cxn modelId="{446B10D4-E075-4727-A696-C1466101E49B}" srcId="{787A8881-D0CD-433C-9882-933C5DE20F34}" destId="{9C14943B-A949-4215-B9C3-6F10F79BB13B}" srcOrd="1" destOrd="0" parTransId="{E6E0E4C7-6AEE-479F-AC3D-B9DD8A4B6093}" sibTransId="{C7A0E317-9924-4EA3-86E8-D7A12E6266CE}"/>
    <dgm:cxn modelId="{E441F7DC-5EEB-4A49-BE78-DAFBBBC5F2F8}" srcId="{00A3F489-AE79-441E-AFB1-74C5B85ADB18}" destId="{44A35BEF-2B08-498A-A112-64C1E5AAC70B}" srcOrd="2" destOrd="0" parTransId="{0906F88E-847E-4F62-B076-A3FF580D98DF}" sibTransId="{6C47D4B8-E8BD-425D-AE0E-760B60222A03}"/>
    <dgm:cxn modelId="{D5A3F5E5-55F6-4621-80F8-D340691ADD37}" srcId="{00A3F489-AE79-441E-AFB1-74C5B85ADB18}" destId="{26ABD6DE-4BBA-417C-828E-A953F5A131DA}" srcOrd="1" destOrd="0" parTransId="{3C7A37AD-7696-433D-878B-26CA31FF8D36}" sibTransId="{19600381-52E9-4B71-92A2-CDD56438AF90}"/>
    <dgm:cxn modelId="{EE5932E6-614F-401D-BC62-435F48155560}" type="presOf" srcId="{A3EB205A-7335-417D-8C0D-7D38B19603BA}" destId="{DF41455E-EFA7-4193-88A2-8024EB6E2A1C}" srcOrd="0" destOrd="0" presId="urn:microsoft.com/office/officeart/2005/8/layout/hierarchy3"/>
    <dgm:cxn modelId="{91B448F0-589E-4367-89D6-0234359349FE}" type="presOf" srcId="{E6E0E4C7-6AEE-479F-AC3D-B9DD8A4B6093}" destId="{25FC5CEF-B198-420B-9F23-171E535F4643}" srcOrd="0" destOrd="0" presId="urn:microsoft.com/office/officeart/2005/8/layout/hierarchy3"/>
    <dgm:cxn modelId="{9F8560EA-BA73-48EC-B3EF-D25BEE0AB786}" type="presParOf" srcId="{EA0CE722-190B-4903-BDD7-D11B8E633021}" destId="{D9572294-9ECF-40E3-A7D0-153CC80A6544}" srcOrd="0" destOrd="0" presId="urn:microsoft.com/office/officeart/2005/8/layout/hierarchy3"/>
    <dgm:cxn modelId="{905667BD-454A-43FD-B216-50166217B183}" type="presParOf" srcId="{D9572294-9ECF-40E3-A7D0-153CC80A6544}" destId="{919C363B-BF1C-4769-9B78-FE349509328F}" srcOrd="0" destOrd="0" presId="urn:microsoft.com/office/officeart/2005/8/layout/hierarchy3"/>
    <dgm:cxn modelId="{3525C91D-FA70-4DEB-95E9-DA83F17FF5D1}" type="presParOf" srcId="{919C363B-BF1C-4769-9B78-FE349509328F}" destId="{DE55AABB-94E3-490E-A88C-F2955391CA07}" srcOrd="0" destOrd="0" presId="urn:microsoft.com/office/officeart/2005/8/layout/hierarchy3"/>
    <dgm:cxn modelId="{2F227B89-EC0D-4AA8-9D58-1D8F65937D9F}" type="presParOf" srcId="{919C363B-BF1C-4769-9B78-FE349509328F}" destId="{E6CFE863-0F57-45B1-948C-9B6BAF8C7CE1}" srcOrd="1" destOrd="0" presId="urn:microsoft.com/office/officeart/2005/8/layout/hierarchy3"/>
    <dgm:cxn modelId="{FF481996-5533-45E3-8416-B5BB043A08A8}" type="presParOf" srcId="{D9572294-9ECF-40E3-A7D0-153CC80A6544}" destId="{B63E1C90-46EF-4D73-A73D-CA1E51356E9A}" srcOrd="1" destOrd="0" presId="urn:microsoft.com/office/officeart/2005/8/layout/hierarchy3"/>
    <dgm:cxn modelId="{0BD22C0D-E51D-45F6-936D-F1C220B25417}" type="presParOf" srcId="{B63E1C90-46EF-4D73-A73D-CA1E51356E9A}" destId="{09BAD2D3-D226-4F56-8031-E6C2584976C5}" srcOrd="0" destOrd="0" presId="urn:microsoft.com/office/officeart/2005/8/layout/hierarchy3"/>
    <dgm:cxn modelId="{773C80B6-1FEC-4B21-936A-68FE447D69E3}" type="presParOf" srcId="{B63E1C90-46EF-4D73-A73D-CA1E51356E9A}" destId="{DF41455E-EFA7-4193-88A2-8024EB6E2A1C}" srcOrd="1" destOrd="0" presId="urn:microsoft.com/office/officeart/2005/8/layout/hierarchy3"/>
    <dgm:cxn modelId="{BA34D325-96F1-4B45-BCDD-D2DF8A31741C}" type="presParOf" srcId="{B63E1C90-46EF-4D73-A73D-CA1E51356E9A}" destId="{D9F3AD56-FBD4-4D24-AEA8-90DEBB22CB73}" srcOrd="2" destOrd="0" presId="urn:microsoft.com/office/officeart/2005/8/layout/hierarchy3"/>
    <dgm:cxn modelId="{1A1AABD3-8723-4C68-90DC-2AAA88A0AF17}" type="presParOf" srcId="{B63E1C90-46EF-4D73-A73D-CA1E51356E9A}" destId="{44999A4B-8255-42FE-B911-7E45F44C2310}" srcOrd="3" destOrd="0" presId="urn:microsoft.com/office/officeart/2005/8/layout/hierarchy3"/>
    <dgm:cxn modelId="{CF581DD9-0EE5-44C9-A228-C69B82F856C2}" type="presParOf" srcId="{B63E1C90-46EF-4D73-A73D-CA1E51356E9A}" destId="{EA76B3C1-B6E7-407B-850D-C7AD52781F26}" srcOrd="4" destOrd="0" presId="urn:microsoft.com/office/officeart/2005/8/layout/hierarchy3"/>
    <dgm:cxn modelId="{72F25ED6-3C26-4CEE-932C-9C99EA7F84B1}" type="presParOf" srcId="{B63E1C90-46EF-4D73-A73D-CA1E51356E9A}" destId="{7EFD0A9B-D7A9-4FD8-B28B-9CE8F87ED1EA}" srcOrd="5" destOrd="0" presId="urn:microsoft.com/office/officeart/2005/8/layout/hierarchy3"/>
    <dgm:cxn modelId="{E46C1708-580E-405C-B1D2-BAD625EDAD2F}" type="presParOf" srcId="{EA0CE722-190B-4903-BDD7-D11B8E633021}" destId="{987FD100-543B-4C70-ACF4-DEAD0F42AF1C}" srcOrd="1" destOrd="0" presId="urn:microsoft.com/office/officeart/2005/8/layout/hierarchy3"/>
    <dgm:cxn modelId="{472B4086-A786-4FB8-997D-58E131080EC9}" type="presParOf" srcId="{987FD100-543B-4C70-ACF4-DEAD0F42AF1C}" destId="{5D508F41-A856-444C-B80A-D0641159BF6E}" srcOrd="0" destOrd="0" presId="urn:microsoft.com/office/officeart/2005/8/layout/hierarchy3"/>
    <dgm:cxn modelId="{F8E5B10A-9580-40D8-B75B-2624084D7533}" type="presParOf" srcId="{5D508F41-A856-444C-B80A-D0641159BF6E}" destId="{0642A0FC-64D1-464E-8CD4-8587A3C42FE7}" srcOrd="0" destOrd="0" presId="urn:microsoft.com/office/officeart/2005/8/layout/hierarchy3"/>
    <dgm:cxn modelId="{3D4294E2-1E22-45AE-BED2-41C75CF716D9}" type="presParOf" srcId="{5D508F41-A856-444C-B80A-D0641159BF6E}" destId="{7BB9488B-4A16-4F39-B11F-2D5F19449636}" srcOrd="1" destOrd="0" presId="urn:microsoft.com/office/officeart/2005/8/layout/hierarchy3"/>
    <dgm:cxn modelId="{22361032-6933-4C6E-B513-7D34447C3A2B}" type="presParOf" srcId="{987FD100-543B-4C70-ACF4-DEAD0F42AF1C}" destId="{8666E096-D699-4C9D-B176-9B41CB7FC01C}" srcOrd="1" destOrd="0" presId="urn:microsoft.com/office/officeart/2005/8/layout/hierarchy3"/>
    <dgm:cxn modelId="{3B60D0DB-3F82-4D2C-BA0A-646ACD63A8E7}" type="presParOf" srcId="{8666E096-D699-4C9D-B176-9B41CB7FC01C}" destId="{6395974D-D17A-4DC2-A7B3-66E8EC0027DA}" srcOrd="0" destOrd="0" presId="urn:microsoft.com/office/officeart/2005/8/layout/hierarchy3"/>
    <dgm:cxn modelId="{02458FA0-AD0B-4CCB-8712-59C1C39CE7FD}" type="presParOf" srcId="{8666E096-D699-4C9D-B176-9B41CB7FC01C}" destId="{BDF40D99-87A0-4261-9932-460B3851E4B0}" srcOrd="1" destOrd="0" presId="urn:microsoft.com/office/officeart/2005/8/layout/hierarchy3"/>
    <dgm:cxn modelId="{6F150639-5E43-458E-9A8D-8237F476C3B6}" type="presParOf" srcId="{8666E096-D699-4C9D-B176-9B41CB7FC01C}" destId="{25FC5CEF-B198-420B-9F23-171E535F4643}" srcOrd="2" destOrd="0" presId="urn:microsoft.com/office/officeart/2005/8/layout/hierarchy3"/>
    <dgm:cxn modelId="{B9F7EAC1-5A81-4FDA-891E-7A2AC08A850E}" type="presParOf" srcId="{8666E096-D699-4C9D-B176-9B41CB7FC01C}" destId="{AA6772D9-9A0F-4138-8C0E-C0C130C1B781}" srcOrd="3" destOrd="0" presId="urn:microsoft.com/office/officeart/2005/8/layout/hierarchy3"/>
    <dgm:cxn modelId="{772BDAEE-F54B-4BBA-8953-23A43C50AA40}" type="presParOf" srcId="{EA0CE722-190B-4903-BDD7-D11B8E633021}" destId="{4A73D403-F384-4338-9B01-7AB7260A4F7E}" srcOrd="2" destOrd="0" presId="urn:microsoft.com/office/officeart/2005/8/layout/hierarchy3"/>
    <dgm:cxn modelId="{63A11FE5-F834-4AB1-A0FE-C837C5A53D52}" type="presParOf" srcId="{4A73D403-F384-4338-9B01-7AB7260A4F7E}" destId="{493333E6-8D73-4F6F-8390-32D2B924ADFA}" srcOrd="0" destOrd="0" presId="urn:microsoft.com/office/officeart/2005/8/layout/hierarchy3"/>
    <dgm:cxn modelId="{80E74E51-4EE7-4723-8AC8-A214DF8EFE20}" type="presParOf" srcId="{493333E6-8D73-4F6F-8390-32D2B924ADFA}" destId="{BFD94402-3B84-47FD-A087-ACD3E5F67F16}" srcOrd="0" destOrd="0" presId="urn:microsoft.com/office/officeart/2005/8/layout/hierarchy3"/>
    <dgm:cxn modelId="{76C77735-4484-4C88-BAA3-C0F9BB60EBAD}" type="presParOf" srcId="{493333E6-8D73-4F6F-8390-32D2B924ADFA}" destId="{3B206625-4566-4FED-9207-610F30214115}" srcOrd="1" destOrd="0" presId="urn:microsoft.com/office/officeart/2005/8/layout/hierarchy3"/>
    <dgm:cxn modelId="{A086956F-C91A-4064-A721-D9F80594BB75}" type="presParOf" srcId="{4A73D403-F384-4338-9B01-7AB7260A4F7E}" destId="{BFD4C4E4-000D-496B-90F0-E044E4C31A6F}" srcOrd="1" destOrd="0" presId="urn:microsoft.com/office/officeart/2005/8/layout/hierarchy3"/>
    <dgm:cxn modelId="{5CE7343B-1139-425E-9202-4517D27ED869}" type="presParOf" srcId="{BFD4C4E4-000D-496B-90F0-E044E4C31A6F}" destId="{12DF270E-78D5-4462-AF65-A8269158EB94}" srcOrd="0" destOrd="0" presId="urn:microsoft.com/office/officeart/2005/8/layout/hierarchy3"/>
    <dgm:cxn modelId="{26C3874F-4435-4137-BC15-D84F772A3812}" type="presParOf" srcId="{BFD4C4E4-000D-496B-90F0-E044E4C31A6F}" destId="{7DA4381C-52EB-481A-B109-A1FB2F2E0365}" srcOrd="1" destOrd="0" presId="urn:microsoft.com/office/officeart/2005/8/layout/hierarchy3"/>
    <dgm:cxn modelId="{AAA8A1E3-BCFC-4B24-9E69-C3F385AD1CA7}" type="presParOf" srcId="{BFD4C4E4-000D-496B-90F0-E044E4C31A6F}" destId="{F0012A88-327F-4E0A-89FD-83BA65DDE8A7}" srcOrd="2" destOrd="0" presId="urn:microsoft.com/office/officeart/2005/8/layout/hierarchy3"/>
    <dgm:cxn modelId="{ED315016-A4C5-4E37-B73A-61ECF2B765C3}" type="presParOf" srcId="{BFD4C4E4-000D-496B-90F0-E044E4C31A6F}" destId="{75D0D84E-A846-4EF1-A182-80695FDEBAEA}" srcOrd="3" destOrd="0" presId="urn:microsoft.com/office/officeart/2005/8/layout/hierarchy3"/>
    <dgm:cxn modelId="{C9351AF1-363F-4D7E-9838-FA8D970073C3}" type="presParOf" srcId="{BFD4C4E4-000D-496B-90F0-E044E4C31A6F}" destId="{D823A3EF-6E9A-4197-B268-7972E365F054}" srcOrd="4" destOrd="0" presId="urn:microsoft.com/office/officeart/2005/8/layout/hierarchy3"/>
    <dgm:cxn modelId="{62899669-F17C-4744-A8C8-D13BB6990CCB}" type="presParOf" srcId="{BFD4C4E4-000D-496B-90F0-E044E4C31A6F}" destId="{FE4325DB-36ED-4070-9496-FC47B2545D1D}" srcOrd="5" destOrd="0" presId="urn:microsoft.com/office/officeart/2005/8/layout/hierarchy3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  <a:ext uri="{C62137D5-CB1D-491B-B009-E17868A290BF}">
      <dgm14:recolorImg xmlns:dgm14="http://schemas.microsoft.com/office/drawing/2010/diagram" val="1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E55AABB-94E3-490E-A88C-F2955391CA07}">
      <dsp:nvSpPr>
        <dsp:cNvPr id="0" name=""/>
        <dsp:cNvSpPr/>
      </dsp:nvSpPr>
      <dsp:spPr>
        <a:xfrm>
          <a:off x="2017216" y="173"/>
          <a:ext cx="1982390" cy="991195"/>
        </a:xfrm>
        <a:prstGeom prst="roundRect">
          <a:avLst>
            <a:gd name="adj" fmla="val 10000"/>
          </a:avLst>
        </a:prstGeom>
        <a:solidFill>
          <a:srgbClr val="AEC3DC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prstMaterial="plastic">
          <a:bevelT w="120900" h="88900"/>
          <a:bevelB w="88900" h="31750" prst="angle"/>
        </a:sp3d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0960" tIns="40640" rIns="60960" bIns="40640" numCol="1" spcCol="1270" anchor="ctr" anchorCtr="0">
          <a:noAutofit/>
        </a:bodyPr>
        <a:lstStyle/>
        <a:p>
          <a:pPr marL="0" lvl="0" indent="0" algn="ctr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3200" kern="1200" dirty="0">
              <a:solidFill>
                <a:srgbClr val="003C76"/>
              </a:solidFill>
            </a:rPr>
            <a:t>Niedriges Risiko</a:t>
          </a:r>
        </a:p>
      </dsp:txBody>
      <dsp:txXfrm>
        <a:off x="2046247" y="29204"/>
        <a:ext cx="1924328" cy="933133"/>
      </dsp:txXfrm>
    </dsp:sp>
    <dsp:sp modelId="{09BAD2D3-D226-4F56-8031-E6C2584976C5}">
      <dsp:nvSpPr>
        <dsp:cNvPr id="0" name=""/>
        <dsp:cNvSpPr/>
      </dsp:nvSpPr>
      <dsp:spPr>
        <a:xfrm>
          <a:off x="2215455" y="991368"/>
          <a:ext cx="198239" cy="74339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43396"/>
              </a:lnTo>
              <a:lnTo>
                <a:pt x="198239" y="743396"/>
              </a:lnTo>
            </a:path>
          </a:pathLst>
        </a:custGeom>
        <a:noFill/>
        <a:ln w="254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  <a:scene3d>
          <a:camera prst="orthographicFront"/>
          <a:lightRig rig="flat" dir="t"/>
        </a:scene3d>
        <a:sp3d prstMaterial="matte"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F41455E-EFA7-4193-88A2-8024EB6E2A1C}">
      <dsp:nvSpPr>
        <dsp:cNvPr id="0" name=""/>
        <dsp:cNvSpPr/>
      </dsp:nvSpPr>
      <dsp:spPr>
        <a:xfrm>
          <a:off x="2413694" y="1239167"/>
          <a:ext cx="1585912" cy="991195"/>
        </a:xfrm>
        <a:prstGeom prst="roundRect">
          <a:avLst>
            <a:gd name="adj" fmla="val 10000"/>
          </a:avLst>
        </a:prstGeom>
        <a:solidFill>
          <a:schemeClr val="dk1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dk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b="1" kern="1200" dirty="0">
              <a:solidFill>
                <a:srgbClr val="003C76"/>
              </a:solidFill>
            </a:rPr>
            <a:t>Aktive Überwachung</a:t>
          </a:r>
        </a:p>
      </dsp:txBody>
      <dsp:txXfrm>
        <a:off x="2442725" y="1268198"/>
        <a:ext cx="1527850" cy="933133"/>
      </dsp:txXfrm>
    </dsp:sp>
    <dsp:sp modelId="{D9F3AD56-FBD4-4D24-AEA8-90DEBB22CB73}">
      <dsp:nvSpPr>
        <dsp:cNvPr id="0" name=""/>
        <dsp:cNvSpPr/>
      </dsp:nvSpPr>
      <dsp:spPr>
        <a:xfrm>
          <a:off x="2215455" y="991368"/>
          <a:ext cx="198239" cy="198239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982390"/>
              </a:lnTo>
              <a:lnTo>
                <a:pt x="198239" y="1982390"/>
              </a:lnTo>
            </a:path>
          </a:pathLst>
        </a:custGeom>
        <a:noFill/>
        <a:ln w="254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  <a:scene3d>
          <a:camera prst="orthographicFront"/>
          <a:lightRig rig="flat" dir="t"/>
        </a:scene3d>
        <a:sp3d prstMaterial="matte"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4999A4B-8255-42FE-B911-7E45F44C2310}">
      <dsp:nvSpPr>
        <dsp:cNvPr id="0" name=""/>
        <dsp:cNvSpPr/>
      </dsp:nvSpPr>
      <dsp:spPr>
        <a:xfrm>
          <a:off x="2413694" y="2478161"/>
          <a:ext cx="1585912" cy="991195"/>
        </a:xfrm>
        <a:prstGeom prst="roundRect">
          <a:avLst>
            <a:gd name="adj" fmla="val 10000"/>
          </a:avLst>
        </a:prstGeom>
        <a:solidFill>
          <a:schemeClr val="dk1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dk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b="1" kern="1200">
              <a:solidFill>
                <a:srgbClr val="003C76"/>
              </a:solidFill>
            </a:rPr>
            <a:t>Operative Prostata-Entfernung</a:t>
          </a:r>
          <a:endParaRPr lang="de-DE" sz="1400" b="1" kern="1200" dirty="0">
            <a:solidFill>
              <a:srgbClr val="003C76"/>
            </a:solidFill>
          </a:endParaRPr>
        </a:p>
      </dsp:txBody>
      <dsp:txXfrm>
        <a:off x="2442725" y="2507192"/>
        <a:ext cx="1527850" cy="933133"/>
      </dsp:txXfrm>
    </dsp:sp>
    <dsp:sp modelId="{EA76B3C1-B6E7-407B-850D-C7AD52781F26}">
      <dsp:nvSpPr>
        <dsp:cNvPr id="0" name=""/>
        <dsp:cNvSpPr/>
      </dsp:nvSpPr>
      <dsp:spPr>
        <a:xfrm>
          <a:off x="2215455" y="991368"/>
          <a:ext cx="198239" cy="322138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221384"/>
              </a:lnTo>
              <a:lnTo>
                <a:pt x="198239" y="3221384"/>
              </a:lnTo>
            </a:path>
          </a:pathLst>
        </a:custGeom>
        <a:noFill/>
        <a:ln w="254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  <a:scene3d>
          <a:camera prst="orthographicFront"/>
          <a:lightRig rig="flat" dir="t"/>
        </a:scene3d>
        <a:sp3d prstMaterial="matte"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EFD0A9B-D7A9-4FD8-B28B-9CE8F87ED1EA}">
      <dsp:nvSpPr>
        <dsp:cNvPr id="0" name=""/>
        <dsp:cNvSpPr/>
      </dsp:nvSpPr>
      <dsp:spPr>
        <a:xfrm>
          <a:off x="2413694" y="3717156"/>
          <a:ext cx="1585912" cy="991195"/>
        </a:xfrm>
        <a:prstGeom prst="roundRect">
          <a:avLst>
            <a:gd name="adj" fmla="val 10000"/>
          </a:avLst>
        </a:prstGeom>
        <a:solidFill>
          <a:schemeClr val="dk1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dk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b="1" kern="1200" dirty="0">
              <a:solidFill>
                <a:srgbClr val="003C76"/>
              </a:solidFill>
            </a:rPr>
            <a:t>Bestrahlung</a:t>
          </a:r>
        </a:p>
      </dsp:txBody>
      <dsp:txXfrm>
        <a:off x="2442725" y="3746187"/>
        <a:ext cx="1527850" cy="933133"/>
      </dsp:txXfrm>
    </dsp:sp>
    <dsp:sp modelId="{0642A0FC-64D1-464E-8CD4-8587A3C42FE7}">
      <dsp:nvSpPr>
        <dsp:cNvPr id="0" name=""/>
        <dsp:cNvSpPr/>
      </dsp:nvSpPr>
      <dsp:spPr>
        <a:xfrm>
          <a:off x="4495204" y="173"/>
          <a:ext cx="1982390" cy="991195"/>
        </a:xfrm>
        <a:prstGeom prst="roundRect">
          <a:avLst>
            <a:gd name="adj" fmla="val 10000"/>
          </a:avLst>
        </a:prstGeom>
        <a:solidFill>
          <a:srgbClr val="AEC3DC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prstMaterial="plastic">
          <a:bevelT w="120900" h="88900"/>
          <a:bevelB w="88900" h="31750" prst="angle"/>
        </a:sp3d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0960" tIns="40640" rIns="60960" bIns="40640" numCol="1" spcCol="1270" anchor="ctr" anchorCtr="0">
          <a:noAutofit/>
        </a:bodyPr>
        <a:lstStyle/>
        <a:p>
          <a:pPr marL="0" lvl="0" indent="0" algn="ctr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3200" kern="1200" dirty="0">
              <a:solidFill>
                <a:srgbClr val="003C76"/>
              </a:solidFill>
            </a:rPr>
            <a:t>Mittleres Risiko</a:t>
          </a:r>
        </a:p>
      </dsp:txBody>
      <dsp:txXfrm>
        <a:off x="4524235" y="29204"/>
        <a:ext cx="1924328" cy="933133"/>
      </dsp:txXfrm>
    </dsp:sp>
    <dsp:sp modelId="{6395974D-D17A-4DC2-A7B3-66E8EC0027DA}">
      <dsp:nvSpPr>
        <dsp:cNvPr id="0" name=""/>
        <dsp:cNvSpPr/>
      </dsp:nvSpPr>
      <dsp:spPr>
        <a:xfrm>
          <a:off x="4693443" y="991368"/>
          <a:ext cx="198239" cy="74339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43396"/>
              </a:lnTo>
              <a:lnTo>
                <a:pt x="198239" y="743396"/>
              </a:lnTo>
            </a:path>
          </a:pathLst>
        </a:custGeom>
        <a:noFill/>
        <a:ln w="254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  <a:scene3d>
          <a:camera prst="orthographicFront"/>
          <a:lightRig rig="flat" dir="t"/>
        </a:scene3d>
        <a:sp3d prstMaterial="matte"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DF40D99-87A0-4261-9932-460B3851E4B0}">
      <dsp:nvSpPr>
        <dsp:cNvPr id="0" name=""/>
        <dsp:cNvSpPr/>
      </dsp:nvSpPr>
      <dsp:spPr>
        <a:xfrm>
          <a:off x="4891682" y="1239167"/>
          <a:ext cx="1585912" cy="991195"/>
        </a:xfrm>
        <a:prstGeom prst="roundRect">
          <a:avLst>
            <a:gd name="adj" fmla="val 10000"/>
          </a:avLst>
        </a:prstGeom>
        <a:solidFill>
          <a:schemeClr val="dk1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dk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b="1" kern="1200">
              <a:solidFill>
                <a:srgbClr val="003C76"/>
              </a:solidFill>
            </a:rPr>
            <a:t>Operative Prostata-Entfernung</a:t>
          </a:r>
          <a:endParaRPr lang="de-DE" sz="1400" b="1" kern="1200" dirty="0">
            <a:solidFill>
              <a:srgbClr val="003C76"/>
            </a:solidFill>
          </a:endParaRPr>
        </a:p>
      </dsp:txBody>
      <dsp:txXfrm>
        <a:off x="4920713" y="1268198"/>
        <a:ext cx="1527850" cy="933133"/>
      </dsp:txXfrm>
    </dsp:sp>
    <dsp:sp modelId="{25FC5CEF-B198-420B-9F23-171E535F4643}">
      <dsp:nvSpPr>
        <dsp:cNvPr id="0" name=""/>
        <dsp:cNvSpPr/>
      </dsp:nvSpPr>
      <dsp:spPr>
        <a:xfrm>
          <a:off x="4693443" y="991368"/>
          <a:ext cx="198239" cy="198239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982390"/>
              </a:lnTo>
              <a:lnTo>
                <a:pt x="198239" y="1982390"/>
              </a:lnTo>
            </a:path>
          </a:pathLst>
        </a:custGeom>
        <a:noFill/>
        <a:ln w="254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  <a:scene3d>
          <a:camera prst="orthographicFront"/>
          <a:lightRig rig="flat" dir="t"/>
        </a:scene3d>
        <a:sp3d prstMaterial="matte"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A6772D9-9A0F-4138-8C0E-C0C130C1B781}">
      <dsp:nvSpPr>
        <dsp:cNvPr id="0" name=""/>
        <dsp:cNvSpPr/>
      </dsp:nvSpPr>
      <dsp:spPr>
        <a:xfrm>
          <a:off x="4891682" y="2478161"/>
          <a:ext cx="1585912" cy="991195"/>
        </a:xfrm>
        <a:prstGeom prst="roundRect">
          <a:avLst>
            <a:gd name="adj" fmla="val 10000"/>
          </a:avLst>
        </a:prstGeom>
        <a:solidFill>
          <a:schemeClr val="dk1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dk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b="1" kern="1200" dirty="0">
              <a:solidFill>
                <a:srgbClr val="003C76"/>
              </a:solidFill>
            </a:rPr>
            <a:t>Bestrahlung</a:t>
          </a:r>
        </a:p>
      </dsp:txBody>
      <dsp:txXfrm>
        <a:off x="4920713" y="2507192"/>
        <a:ext cx="1527850" cy="933133"/>
      </dsp:txXfrm>
    </dsp:sp>
    <dsp:sp modelId="{BFD94402-3B84-47FD-A087-ACD3E5F67F16}">
      <dsp:nvSpPr>
        <dsp:cNvPr id="0" name=""/>
        <dsp:cNvSpPr/>
      </dsp:nvSpPr>
      <dsp:spPr>
        <a:xfrm>
          <a:off x="6973192" y="173"/>
          <a:ext cx="1982390" cy="991195"/>
        </a:xfrm>
        <a:prstGeom prst="roundRect">
          <a:avLst>
            <a:gd name="adj" fmla="val 10000"/>
          </a:avLst>
        </a:prstGeom>
        <a:solidFill>
          <a:srgbClr val="AEC3DC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prstMaterial="plastic">
          <a:bevelT w="120900" h="88900"/>
          <a:bevelB w="88900" h="31750" prst="angle"/>
        </a:sp3d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0960" tIns="40640" rIns="60960" bIns="40640" numCol="1" spcCol="1270" anchor="ctr" anchorCtr="0">
          <a:noAutofit/>
        </a:bodyPr>
        <a:lstStyle/>
        <a:p>
          <a:pPr marL="0" lvl="0" indent="0" algn="ctr" defTabSz="1422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3200" kern="1200" dirty="0">
              <a:solidFill>
                <a:srgbClr val="003C76"/>
              </a:solidFill>
            </a:rPr>
            <a:t>Hohes Risiko</a:t>
          </a:r>
        </a:p>
      </dsp:txBody>
      <dsp:txXfrm>
        <a:off x="7002223" y="29204"/>
        <a:ext cx="1924328" cy="933133"/>
      </dsp:txXfrm>
    </dsp:sp>
    <dsp:sp modelId="{12DF270E-78D5-4462-AF65-A8269158EB94}">
      <dsp:nvSpPr>
        <dsp:cNvPr id="0" name=""/>
        <dsp:cNvSpPr/>
      </dsp:nvSpPr>
      <dsp:spPr>
        <a:xfrm>
          <a:off x="7171432" y="991368"/>
          <a:ext cx="198239" cy="74339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743396"/>
              </a:lnTo>
              <a:lnTo>
                <a:pt x="198239" y="743396"/>
              </a:lnTo>
            </a:path>
          </a:pathLst>
        </a:custGeom>
        <a:noFill/>
        <a:ln w="254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  <a:scene3d>
          <a:camera prst="orthographicFront"/>
          <a:lightRig rig="flat" dir="t"/>
        </a:scene3d>
        <a:sp3d prstMaterial="matte"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DA4381C-52EB-481A-B109-A1FB2F2E0365}">
      <dsp:nvSpPr>
        <dsp:cNvPr id="0" name=""/>
        <dsp:cNvSpPr/>
      </dsp:nvSpPr>
      <dsp:spPr>
        <a:xfrm>
          <a:off x="7369671" y="1239167"/>
          <a:ext cx="1585912" cy="991195"/>
        </a:xfrm>
        <a:prstGeom prst="roundRect">
          <a:avLst>
            <a:gd name="adj" fmla="val 10000"/>
          </a:avLst>
        </a:prstGeom>
        <a:solidFill>
          <a:schemeClr val="dk1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dk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b="1" kern="1200" dirty="0" err="1">
              <a:solidFill>
                <a:srgbClr val="003C76"/>
              </a:solidFill>
            </a:rPr>
            <a:t>Staging</a:t>
          </a:r>
          <a:r>
            <a:rPr lang="de-DE" sz="1400" b="1" kern="1200" dirty="0">
              <a:solidFill>
                <a:srgbClr val="003C76"/>
              </a:solidFill>
            </a:rPr>
            <a:t> CT + Skelett-szintigraphie / PSMA-PET</a:t>
          </a:r>
        </a:p>
      </dsp:txBody>
      <dsp:txXfrm>
        <a:off x="7398702" y="1268198"/>
        <a:ext cx="1527850" cy="933133"/>
      </dsp:txXfrm>
    </dsp:sp>
    <dsp:sp modelId="{F0012A88-327F-4E0A-89FD-83BA65DDE8A7}">
      <dsp:nvSpPr>
        <dsp:cNvPr id="0" name=""/>
        <dsp:cNvSpPr/>
      </dsp:nvSpPr>
      <dsp:spPr>
        <a:xfrm>
          <a:off x="7171432" y="991368"/>
          <a:ext cx="198239" cy="198239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982390"/>
              </a:lnTo>
              <a:lnTo>
                <a:pt x="198239" y="1982390"/>
              </a:lnTo>
            </a:path>
          </a:pathLst>
        </a:custGeom>
        <a:noFill/>
        <a:ln w="254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  <a:scene3d>
          <a:camera prst="orthographicFront"/>
          <a:lightRig rig="flat" dir="t"/>
        </a:scene3d>
        <a:sp3d prstMaterial="matte"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5D0D84E-A846-4EF1-A182-80695FDEBAEA}">
      <dsp:nvSpPr>
        <dsp:cNvPr id="0" name=""/>
        <dsp:cNvSpPr/>
      </dsp:nvSpPr>
      <dsp:spPr>
        <a:xfrm>
          <a:off x="7369671" y="2478161"/>
          <a:ext cx="1585912" cy="991195"/>
        </a:xfrm>
        <a:prstGeom prst="roundRect">
          <a:avLst>
            <a:gd name="adj" fmla="val 10000"/>
          </a:avLst>
        </a:prstGeom>
        <a:solidFill>
          <a:schemeClr val="dk1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dk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b="1" kern="1200" dirty="0">
              <a:solidFill>
                <a:srgbClr val="003C76"/>
              </a:solidFill>
            </a:rPr>
            <a:t>Operative Prostata-Entfernung</a:t>
          </a:r>
        </a:p>
      </dsp:txBody>
      <dsp:txXfrm>
        <a:off x="7398702" y="2507192"/>
        <a:ext cx="1527850" cy="933133"/>
      </dsp:txXfrm>
    </dsp:sp>
    <dsp:sp modelId="{D823A3EF-6E9A-4197-B268-7972E365F054}">
      <dsp:nvSpPr>
        <dsp:cNvPr id="0" name=""/>
        <dsp:cNvSpPr/>
      </dsp:nvSpPr>
      <dsp:spPr>
        <a:xfrm>
          <a:off x="7171432" y="991368"/>
          <a:ext cx="198239" cy="322138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221384"/>
              </a:lnTo>
              <a:lnTo>
                <a:pt x="198239" y="3221384"/>
              </a:lnTo>
            </a:path>
          </a:pathLst>
        </a:custGeom>
        <a:noFill/>
        <a:ln w="254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  <a:scene3d>
          <a:camera prst="orthographicFront"/>
          <a:lightRig rig="flat" dir="t"/>
        </a:scene3d>
        <a:sp3d prstMaterial="matte"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E4325DB-36ED-4070-9496-FC47B2545D1D}">
      <dsp:nvSpPr>
        <dsp:cNvPr id="0" name=""/>
        <dsp:cNvSpPr/>
      </dsp:nvSpPr>
      <dsp:spPr>
        <a:xfrm>
          <a:off x="7369671" y="3717156"/>
          <a:ext cx="1585912" cy="991195"/>
        </a:xfrm>
        <a:prstGeom prst="roundRect">
          <a:avLst>
            <a:gd name="adj" fmla="val 10000"/>
          </a:avLst>
        </a:prstGeom>
        <a:solidFill>
          <a:schemeClr val="dk1">
            <a:alpha val="90000"/>
            <a:tint val="40000"/>
            <a:hueOff val="0"/>
            <a:satOff val="0"/>
            <a:lumOff val="0"/>
            <a:alphaOff val="0"/>
          </a:schemeClr>
        </a:solidFill>
        <a:ln w="9525" cap="flat" cmpd="sng" algn="ctr">
          <a:solidFill>
            <a:schemeClr val="dk1">
              <a:hueOff val="0"/>
              <a:satOff val="0"/>
              <a:lumOff val="0"/>
              <a:alphaOff val="0"/>
            </a:schemeClr>
          </a:solidFill>
          <a:prstDash val="solid"/>
        </a:ln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/>
          <a:lightRig rig="flat" dir="t"/>
        </a:scene3d>
        <a:sp3d z="-190500" extrusionH="12700" prstMaterial="plastic">
          <a:bevelT w="50800" h="50800"/>
        </a:sp3d>
      </dsp:spPr>
      <dsp:style>
        <a:lnRef idx="1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  <dsp:txBody>
        <a:bodyPr spcFirstLastPara="0" vert="horz" wrap="square" lIns="26670" tIns="17780" rIns="2667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400" b="1" kern="1200" dirty="0">
              <a:solidFill>
                <a:srgbClr val="003C76"/>
              </a:solidFill>
            </a:rPr>
            <a:t>Bestrahlung</a:t>
          </a:r>
        </a:p>
      </dsp:txBody>
      <dsp:txXfrm>
        <a:off x="7398702" y="3746187"/>
        <a:ext cx="1527850" cy="933133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3">
  <dgm:title val=""/>
  <dgm:desc val=""/>
  <dgm:catLst>
    <dgm:cat type="hierarchy" pri="7000"/>
    <dgm:cat type="list" pri="23000"/>
    <dgm:cat type="relationship" pri="15000"/>
    <dgm:cat type="convert" pri="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</dgm:ptLst>
      <dgm:cxnLst>
        <dgm:cxn modelId="4" srcId="0" destId="1" srcOrd="0" destOrd="0"/>
        <dgm:cxn modelId="5" srcId="1" destId="11" srcOrd="0" destOrd="0"/>
        <dgm:cxn modelId="6" srcId="1" destId="12" srcOrd="1" destOrd="0"/>
        <dgm:cxn modelId="7" srcId="0" destId="2" srcOrd="1" destOrd="0"/>
        <dgm:cxn modelId="8" srcId="2" destId="21" srcOrd="0" destOrd="0"/>
        <dgm:cxn modelId="9" srcId="2" destId="2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forName="rootText" op="equ" val="65"/>
      <dgm:constr type="primFontSz" for="des" forName="childText" op="equ" val="65"/>
      <dgm:constr type="w" for="des" forName="rootComposite" refType="w"/>
      <dgm:constr type="h" for="des" forName="rootComposite" refType="w" fact="0.5"/>
      <dgm:constr type="w" for="des" forName="childText" refType="w" refFor="des" refForName="rootComposite" fact="0.8"/>
      <dgm:constr type="h" for="des" forName="childText" refType="h" refFor="des" refForName="rootComposite"/>
      <dgm:constr type="sibSp" refType="w" refFor="des" refForName="rootComposite" fact="0.25"/>
      <dgm:constr type="sibSp" for="des" forName="childShape" refType="h" refFor="des" refForName="childText" fact="0.25"/>
      <dgm:constr type="sp" for="des" forName="root" refType="h" refFor="des" refForName="childText" fact="0.25"/>
    </dgm:constrLst>
    <dgm:ruleLst/>
    <dgm:forEach name="Name3" axis="ch">
      <dgm:forEach name="Name4" axis="self" ptType="node" cnt="1">
        <dgm:layoutNode name="root">
          <dgm:choose name="Name5">
            <dgm:if name="Name6" func="var" arg="dir" op="equ" val="norm">
              <dgm:alg type="hierRoot">
                <dgm:param type="hierAlign" val="tL"/>
              </dgm:alg>
            </dgm:if>
            <dgm:else name="Name7">
              <dgm:alg type="hierRoot">
                <dgm:param type="hierAlign" val="tR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>
            <dgm:constr type="alignOff" val="0.2"/>
          </dgm:constrLst>
          <dgm:ruleLst/>
          <dgm:layoutNode name="rootComposite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8">
              <dgm:if name="Name9" func="var" arg="dir" op="equ" val="norm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l" for="ch" forName="rootConnector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if>
              <dgm:else name="Name10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r" for="ch" forName="rootConnector" refType="w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else>
            </dgm:choose>
            <dgm:ruleLst/>
            <dgm:layoutNode name="rootText" styleLbl="node1"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 ptType="node" cnt="1"/>
              <dgm:constrLst>
                <dgm:constr type="tMarg" refType="primFontSz" fact="0.1"/>
                <dgm:constr type="bMarg" refType="primFontSz" fact="0.1"/>
                <dgm:constr type="lMarg" refType="primFontSz" fact="0.15"/>
                <dgm:constr type="rMarg" refType="primFontSz" fact="0.15"/>
              </dgm:constrLst>
              <dgm:ruleLst>
                <dgm:rule type="primFontSz" val="5" fact="NaN" max="NaN"/>
              </dgm:ruleLst>
            </dgm:layoutNode>
            <dgm:layoutNode name="rootConnector" moveWith="rootText">
              <dgm:alg type="sp"/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self" ptType="node" cnt="1"/>
              <dgm:constrLst/>
              <dgm:ruleLst/>
            </dgm:layoutNode>
          </dgm:layoutNode>
          <dgm:layoutNode name="childShape">
            <dgm:alg type="hierChild">
              <dgm:param type="chAlign" val="l"/>
              <dgm:param type="linDir" val="fromT"/>
            </dgm:alg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11" axis="ch">
              <dgm:forEach name="Name12" axis="self" ptType="parTrans" cnt="1">
                <dgm:layoutNode name="Name13">
                  <dgm:choose name="Name14">
                    <dgm:if name="Name15" func="var" arg="dir" op="equ" val="norm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L"/>
                      </dgm:alg>
                    </dgm:if>
                    <dgm:else name="Name16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7" axis="self" ptType="node">
                <dgm:layoutNode name="childText" styleLbl="bgAcc1">
                  <dgm:varLst>
                    <dgm:bulletEnabled val="1"/>
                  </dgm:varLst>
                  <dgm:alg type="tx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self desOrSelf" ptType="node node" st="1 1" cnt="1 0"/>
                  <dgm:constrLst>
                    <dgm:constr type="tMarg" refType="primFontSz" fact="0.1"/>
                    <dgm:constr type="bMarg" refType="primFontSz" fact="0.1"/>
                    <dgm:constr type="lMarg" refType="primFontSz" fact="0.15"/>
                    <dgm:constr type="rMarg" refType="primFontSz" fact="0.15"/>
                  </dgm:constrLst>
                  <dgm:ruleLst>
                    <dgm:rule type="primFontSz" val="5" fact="NaN" max="NaN"/>
                  </dgm:ruleLst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3d1">
  <dgm:title val=""/>
  <dgm:desc val=""/>
  <dgm:catLst>
    <dgm:cat type="3D" pri="111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flat" dir="t"/>
    </dgm:scene3d>
    <dgm:sp3d z="127000" prstMaterial="plastic">
      <a:bevelT w="88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flat" dir="t"/>
    </dgm:scene3d>
    <dgm:sp3d prstMaterial="plastic">
      <a:bevelT w="88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flat" dir="t"/>
    </dgm:scene3d>
    <dgm:sp3d z="-190500" prstMaterial="plastic">
      <a:bevelT w="88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flat" dir="t"/>
    </dgm:scene3d>
    <dgm:sp3d z="-80000" prstMaterial="plastic">
      <a:bevelT w="50800" h="50800"/>
      <a:bevelB w="25400" h="2540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flat" dir="t"/>
    </dgm:scene3d>
    <dgm:sp3d z="127000" prstMaterial="plastic">
      <a:bevelT w="50800" h="50800"/>
      <a:bevelB w="25400" h="2540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flat" dir="t"/>
    </dgm:scene3d>
    <dgm:sp3d z="-190500" prstMaterial="plastic">
      <a:bevelT w="50800" h="50800"/>
      <a:bevelB w="25400" h="25400" prst="angle"/>
    </dgm:sp3d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flat" dir="t"/>
    </dgm:scene3d>
    <dgm:sp3d z="-40000" prstMaterial="matte"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 z="127000" prstMaterial="matte"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flat" dir="t"/>
    </dgm:scene3d>
    <dgm:sp3d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flat" dir="t"/>
    </dgm:scene3d>
    <dgm:sp3d z="-10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flat" dir="t"/>
    </dgm:scene3d>
    <dgm:sp3d z="-6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flat" dir="t"/>
    </dgm:scene3d>
    <dgm:sp3d z="-6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flat" dir="t"/>
    </dgm:scene3d>
    <dgm:sp3d z="-60000" prstMaterial="plastic">
      <a:bevelT w="120900" h="88900"/>
      <a:bevelB w="88900" h="31750" prst="angle"/>
    </dgm:sp3d>
    <dgm:txPr/>
    <dgm:style>
      <a:lnRef idx="0">
        <a:scrgbClr r="0" g="0" b="0"/>
      </a:lnRef>
      <a:fillRef idx="3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flat" dir="t"/>
    </dgm:scene3d>
    <dgm:sp3d prstMaterial="matte"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conFgAcc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AlignAcc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1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FgAcc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AlignAcc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BgAcc1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FollowNode1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FollowNode1">
    <dgm:scene3d>
      <a:camera prst="orthographicFront"/>
      <a:lightRig rig="flat" dir="t"/>
    </dgm:scene3d>
    <dgm:sp3d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FollowNode1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0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2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3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4">
    <dgm:scene3d>
      <a:camera prst="orthographicFront"/>
      <a:lightRig rig="flat" dir="t"/>
    </dgm:scene3d>
    <dgm:sp3d z="190500" extrusionH="12700" prstMaterial="plastic">
      <a:bevelT w="50800" h="50800"/>
    </dgm:sp3d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Shp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flat" dir="t"/>
    </dgm:scene3d>
    <dgm:sp3d z="-190500" extrusionH="12700" prstMaterial="plastic">
      <a:bevelT w="50800" h="508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flat" dir="t"/>
    </dgm:scene3d>
    <dgm:sp3d z="-190500" extrusionH="12700" prstMaterial="matte"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z="190500" prstMaterial="plastic">
      <a:bevelT w="120900" h="88900"/>
      <a:bevelB w="88900" h="31750" prst="angle"/>
    </dgm:sp3d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>
            <a:extLst>
              <a:ext uri="{FF2B5EF4-FFF2-40B4-BE49-F238E27FC236}">
                <a16:creationId xmlns:a16="http://schemas.microsoft.com/office/drawing/2014/main" id="{754F1539-B74F-58D6-1476-8C6E36E014C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3713" cy="339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charset="0"/>
                <a:ea typeface="ＭＳ Ｐゴシック" pitchFamily="34" charset="-128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3DFBE81-287B-7B5C-B264-46F4EEA95206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621338" y="0"/>
            <a:ext cx="4303712" cy="339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charset="0"/>
                <a:ea typeface="ＭＳ Ｐゴシック" pitchFamily="34" charset="-128"/>
              </a:defRPr>
            </a:lvl1pPr>
          </a:lstStyle>
          <a:p>
            <a:pPr>
              <a:defRPr/>
            </a:pPr>
            <a:fld id="{28DC132B-7DD0-42B3-A48C-81A2BCE63C59}" type="datetimeFigureOut">
              <a:rPr lang="de-DE"/>
              <a:pPr>
                <a:defRPr/>
              </a:pPr>
              <a:t>11.10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8400B34-C3CF-7AE5-CBC6-7453E2BF5D79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456363"/>
            <a:ext cx="4303713" cy="339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charset="0"/>
                <a:ea typeface="ＭＳ Ｐゴシック" pitchFamily="34" charset="-128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8ED59D6D-916F-C3A8-5D65-38C895A6FF71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621338" y="6456363"/>
            <a:ext cx="4303712" cy="3397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220F0CEC-61FA-4826-968A-E0A8C000E5BA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Rectangle 2">
            <a:extLst>
              <a:ext uri="{FF2B5EF4-FFF2-40B4-BE49-F238E27FC236}">
                <a16:creationId xmlns:a16="http://schemas.microsoft.com/office/drawing/2014/main" id="{DA4289F8-52ED-AD33-A4BC-B1EEF84E04A8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4303713" cy="33972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171" name="Rectangle 3">
            <a:extLst>
              <a:ext uri="{FF2B5EF4-FFF2-40B4-BE49-F238E27FC236}">
                <a16:creationId xmlns:a16="http://schemas.microsoft.com/office/drawing/2014/main" id="{58389A5F-DD0E-44A5-F261-633CF1B87B08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5621338" y="0"/>
            <a:ext cx="4303712" cy="33972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ＭＳ Ｐゴシック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076" name="Rectangle 4">
            <a:extLst>
              <a:ext uri="{FF2B5EF4-FFF2-40B4-BE49-F238E27FC236}">
                <a16:creationId xmlns:a16="http://schemas.microsoft.com/office/drawing/2014/main" id="{5A791931-3BCB-5809-B605-4388F24EF133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697163" y="509588"/>
            <a:ext cx="4532312" cy="25495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7173" name="Rectangle 5">
            <a:extLst>
              <a:ext uri="{FF2B5EF4-FFF2-40B4-BE49-F238E27FC236}">
                <a16:creationId xmlns:a16="http://schemas.microsoft.com/office/drawing/2014/main" id="{E9B84DEE-BE90-DD68-255F-E86E269D4B2F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92188" y="3228975"/>
            <a:ext cx="7942262" cy="305911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noProof="0"/>
              <a:t>Textmasterformate durch Klicken bearbeiten</a:t>
            </a:r>
          </a:p>
          <a:p>
            <a:pPr lvl="1"/>
            <a:r>
              <a:rPr lang="de-DE" altLang="de-DE" noProof="0"/>
              <a:t>Zweite Ebene</a:t>
            </a:r>
          </a:p>
          <a:p>
            <a:pPr lvl="2"/>
            <a:r>
              <a:rPr lang="de-DE" altLang="de-DE" noProof="0"/>
              <a:t>Dritte Ebene</a:t>
            </a:r>
          </a:p>
          <a:p>
            <a:pPr lvl="3"/>
            <a:r>
              <a:rPr lang="de-DE" altLang="de-DE" noProof="0"/>
              <a:t>Vierte Ebene</a:t>
            </a:r>
          </a:p>
          <a:p>
            <a:pPr lvl="4"/>
            <a:r>
              <a:rPr lang="de-DE" altLang="de-DE" noProof="0"/>
              <a:t>Fünfte Ebene</a:t>
            </a:r>
          </a:p>
        </p:txBody>
      </p:sp>
      <p:sp>
        <p:nvSpPr>
          <p:cNvPr id="7174" name="Rectangle 6">
            <a:extLst>
              <a:ext uri="{FF2B5EF4-FFF2-40B4-BE49-F238E27FC236}">
                <a16:creationId xmlns:a16="http://schemas.microsoft.com/office/drawing/2014/main" id="{5046BF68-55AD-E2BC-A2D1-0E5301DD36A5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6456363"/>
            <a:ext cx="4303713" cy="33972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ＭＳ Ｐゴシック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175" name="Rectangle 7">
            <a:extLst>
              <a:ext uri="{FF2B5EF4-FFF2-40B4-BE49-F238E27FC236}">
                <a16:creationId xmlns:a16="http://schemas.microsoft.com/office/drawing/2014/main" id="{39F9963F-75FC-90C9-2EF4-059CB394F773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5621338" y="6456363"/>
            <a:ext cx="4303712" cy="339725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670830C8-8219-4CE7-842B-E1B78961F716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MS PGothic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B9133ED9-83A1-8070-21D1-C1ADBC295E6B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B2F8DB-4887-4267-8E3E-501254070C6D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941021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34950CD5-CA87-9DF3-B4EA-05CB16E36C56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2E1289-6C15-4AD7-BF53-0CD28C704236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400355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839200" y="919163"/>
            <a:ext cx="2743200" cy="5548312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09600" y="919163"/>
            <a:ext cx="8026400" cy="5548312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F5C8E315-736F-00C1-BCF4-8913B7FBFF14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D1F90C-5BD5-49DE-9FAD-491FB6EB9FE9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9879053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enutzerdefiniertes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Rectangle 6">
            <a:extLst>
              <a:ext uri="{FF2B5EF4-FFF2-40B4-BE49-F238E27FC236}">
                <a16:creationId xmlns:a16="http://schemas.microsoft.com/office/drawing/2014/main" id="{90F4C3E3-C179-1564-2CAA-25F7227CDE12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7AF2CC-F22C-4341-BBFF-10BA0D3A5E34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103938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747AA9B9-6305-2753-169A-9C2826289B36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A76108-F988-4EF5-96F2-4D2389D29813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214989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0071EBE1-C9DA-A3AF-6A87-4494CF2F7AED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46823BE-0C7F-4B8F-AD8A-42161252F88C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23896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09600" y="1758951"/>
            <a:ext cx="5384800" cy="47085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97600" y="1758951"/>
            <a:ext cx="5384800" cy="47085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D987BA81-6934-1E01-5F61-50BE1F3C11F1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676044-0DBB-4D2C-A6BB-D5D6BC6D9C95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545388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FC9BB8E-17BC-E393-A02B-93A6B76FAA54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FF68DA-5740-4DF2-AF88-0956A5FF09AA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479760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Rectangle 6">
            <a:extLst>
              <a:ext uri="{FF2B5EF4-FFF2-40B4-BE49-F238E27FC236}">
                <a16:creationId xmlns:a16="http://schemas.microsoft.com/office/drawing/2014/main" id="{CA3F98C9-63CE-4F38-C667-EB9BC980CC80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27125F9-6213-429D-8ACD-5F6FDBA82E1A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42709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6">
            <a:extLst>
              <a:ext uri="{FF2B5EF4-FFF2-40B4-BE49-F238E27FC236}">
                <a16:creationId xmlns:a16="http://schemas.microsoft.com/office/drawing/2014/main" id="{74710A81-4767-5B24-8793-39E6A7AE878F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E0BD5CA-E5EA-47FE-85D1-6BB8B578A70F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975945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E421E0F6-E145-F54E-5835-2D07E2348966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F11C33-E71E-4E5D-BA70-C25BC9CB2973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050066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0F9B1CB1-F62F-02A8-771F-523F895F69B5}"/>
              </a:ext>
            </a:extLst>
          </p:cNvPr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62B522-A6DA-4C9B-B510-0B27CFAC09DD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385382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jpe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>
            <a:extLst>
              <a:ext uri="{FF2B5EF4-FFF2-40B4-BE49-F238E27FC236}">
                <a16:creationId xmlns:a16="http://schemas.microsoft.com/office/drawing/2014/main" id="{0D5AE8D4-8937-A030-54D6-969D9370DF98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919163"/>
            <a:ext cx="10972800" cy="868362"/>
          </a:xfrm>
          <a:prstGeom prst="rect">
            <a:avLst/>
          </a:prstGeom>
          <a:solidFill>
            <a:srgbClr val="80A1C9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M&amp;M Konferenz 13.03.2017</a:t>
            </a:r>
          </a:p>
        </p:txBody>
      </p:sp>
      <p:sp>
        <p:nvSpPr>
          <p:cNvPr id="2051" name="Rectangle 3">
            <a:extLst>
              <a:ext uri="{FF2B5EF4-FFF2-40B4-BE49-F238E27FC236}">
                <a16:creationId xmlns:a16="http://schemas.microsoft.com/office/drawing/2014/main" id="{579C9AA1-62A4-B57F-857A-1CD279667C09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758951"/>
            <a:ext cx="10972800" cy="4708525"/>
          </a:xfrm>
          <a:prstGeom prst="rect">
            <a:avLst/>
          </a:prstGeom>
          <a:solidFill>
            <a:srgbClr val="AEC3DC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Patientin Kästel Teresa geb. 03.10.1958</a:t>
            </a:r>
          </a:p>
          <a:p>
            <a:pPr lvl="0"/>
            <a:endParaRPr lang="de-DE" altLang="de-DE"/>
          </a:p>
          <a:p>
            <a:pPr lvl="0"/>
            <a:r>
              <a:rPr lang="de-DE" altLang="de-DE"/>
              <a:t>Diagnose</a:t>
            </a:r>
          </a:p>
          <a:p>
            <a:pPr lvl="1"/>
            <a:r>
              <a:rPr lang="de-DE" altLang="de-DE"/>
              <a:t>Urosepsis (Klebsiella pneumoniae) </a:t>
            </a:r>
          </a:p>
          <a:p>
            <a:pPr lvl="1"/>
            <a:endParaRPr lang="de-DE" altLang="de-DE"/>
          </a:p>
          <a:p>
            <a:pPr lvl="1"/>
            <a:r>
              <a:rPr lang="de-DE" altLang="de-DE"/>
              <a:t>Z.n. offener Nierenteilresektion li am 04.10.2016 (cRCC pT1, R0, G1)</a:t>
            </a:r>
          </a:p>
          <a:p>
            <a:pPr lvl="1"/>
            <a:r>
              <a:rPr lang="de-DE" altLang="de-DE"/>
              <a:t>Z.n. DJ Einlage li + Drainageeinlage li am 16.12.2016 bei Urinom</a:t>
            </a:r>
          </a:p>
          <a:p>
            <a:pPr lvl="1"/>
            <a:r>
              <a:rPr lang="de-DE" altLang="de-DE"/>
              <a:t>Z.n. transabdominaler Nierenfreilegung und Defektverschluss am 19.01.2017</a:t>
            </a:r>
          </a:p>
          <a:p>
            <a:pPr lvl="1"/>
            <a:r>
              <a:rPr lang="de-DE" altLang="de-DE"/>
              <a:t>	mit DJ-Einlage</a:t>
            </a:r>
          </a:p>
          <a:p>
            <a:pPr lvl="0"/>
            <a:r>
              <a:rPr lang="de-DE" altLang="de-DE"/>
              <a:t>Therapie</a:t>
            </a:r>
          </a:p>
          <a:p>
            <a:pPr lvl="1"/>
            <a:r>
              <a:rPr lang="de-DE" altLang="de-DE"/>
              <a:t>DJ-Wechsel li am 17.02.2017</a:t>
            </a:r>
          </a:p>
          <a:p>
            <a:pPr lvl="0"/>
            <a:endParaRPr lang="de-DE" altLang="de-DE"/>
          </a:p>
          <a:p>
            <a:pPr lvl="1"/>
            <a:endParaRPr lang="de-DE" altLang="de-DE"/>
          </a:p>
          <a:p>
            <a:pPr lvl="1"/>
            <a:endParaRPr lang="de-DE" altLang="de-DE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5D5DBB69-C8E0-33CE-356E-8FAB132A72F5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11184467" y="6438900"/>
            <a:ext cx="397933" cy="249238"/>
          </a:xfrm>
          <a:prstGeom prst="rect">
            <a:avLst/>
          </a:prstGeom>
          <a:solidFill>
            <a:srgbClr val="C1002B"/>
          </a:solidFill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800"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A2479692-B4A3-4322-A5BD-A98DD4E463D2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  <p:sp>
        <p:nvSpPr>
          <p:cNvPr id="2053" name="Line 8">
            <a:extLst>
              <a:ext uri="{FF2B5EF4-FFF2-40B4-BE49-F238E27FC236}">
                <a16:creationId xmlns:a16="http://schemas.microsoft.com/office/drawing/2014/main" id="{ABFC9133-B58E-9252-311D-747BF2C15E9A}"/>
              </a:ext>
            </a:extLst>
          </p:cNvPr>
          <p:cNvSpPr>
            <a:spLocks noChangeShapeType="1"/>
          </p:cNvSpPr>
          <p:nvPr userDrawn="1"/>
        </p:nvSpPr>
        <p:spPr bwMode="auto">
          <a:xfrm>
            <a:off x="624418" y="1763713"/>
            <a:ext cx="10943167" cy="0"/>
          </a:xfrm>
          <a:prstGeom prst="line">
            <a:avLst/>
          </a:prstGeom>
          <a:noFill/>
          <a:ln w="9525">
            <a:solidFill>
              <a:srgbClr val="003366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pic>
        <p:nvPicPr>
          <p:cNvPr id="2054" name="Picture 12" descr="JGU_Uni_medizin_Logo_4c">
            <a:extLst>
              <a:ext uri="{FF2B5EF4-FFF2-40B4-BE49-F238E27FC236}">
                <a16:creationId xmlns:a16="http://schemas.microsoft.com/office/drawing/2014/main" id="{8E704A1E-7646-FA6D-7D55-E59D7E17B6A7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14">
            <a:lum bright="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55544" y="188913"/>
            <a:ext cx="3174332" cy="506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33" name="Text Box 9">
            <a:extLst>
              <a:ext uri="{FF2B5EF4-FFF2-40B4-BE49-F238E27FC236}">
                <a16:creationId xmlns:a16="http://schemas.microsoft.com/office/drawing/2014/main" id="{212AF63F-05EA-D899-8B92-F9F03D053FDD}"/>
              </a:ext>
            </a:extLst>
          </p:cNvPr>
          <p:cNvSpPr txBox="1">
            <a:spLocks noChangeArrowheads="1"/>
          </p:cNvSpPr>
          <p:nvPr userDrawn="1"/>
        </p:nvSpPr>
        <p:spPr bwMode="auto">
          <a:xfrm>
            <a:off x="8387515" y="489298"/>
            <a:ext cx="2770981" cy="230832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de-DE" altLang="de-DE" sz="900" dirty="0">
                <a:solidFill>
                  <a:srgbClr val="003C76"/>
                </a:solidFill>
              </a:rPr>
              <a:t>Klinik und Poliklinik für Urologie und Kinderurologi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1" r:id="rId2"/>
    <p:sldLayoutId id="2147483672" r:id="rId3"/>
    <p:sldLayoutId id="2147483673" r:id="rId4"/>
    <p:sldLayoutId id="2147483674" r:id="rId5"/>
    <p:sldLayoutId id="2147483675" r:id="rId6"/>
    <p:sldLayoutId id="2147483676" r:id="rId7"/>
    <p:sldLayoutId id="2147483677" r:id="rId8"/>
    <p:sldLayoutId id="2147483678" r:id="rId9"/>
    <p:sldLayoutId id="2147483679" r:id="rId10"/>
    <p:sldLayoutId id="2147483680" r:id="rId11"/>
    <p:sldLayoutId id="2147483681" r:id="rId12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C76"/>
          </a:solidFill>
          <a:latin typeface="+mj-lt"/>
          <a:ea typeface="MS PGothic" pitchFamily="34" charset="-128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C76"/>
          </a:solidFill>
          <a:latin typeface="Arial" charset="0"/>
          <a:ea typeface="MS PGothic" pitchFamily="34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C76"/>
          </a:solidFill>
          <a:latin typeface="Arial" charset="0"/>
          <a:ea typeface="MS PGothic" pitchFamily="34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C76"/>
          </a:solidFill>
          <a:latin typeface="Arial" charset="0"/>
          <a:ea typeface="MS PGothic" pitchFamily="34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003C76"/>
          </a:solidFill>
          <a:latin typeface="Arial" charset="0"/>
          <a:ea typeface="MS PGothic" pitchFamily="34" charset="-128"/>
        </a:defRPr>
      </a:lvl5pPr>
      <a:lvl6pPr marL="457200" algn="l" rtl="0" fontAlgn="base">
        <a:spcBef>
          <a:spcPct val="0"/>
        </a:spcBef>
        <a:spcAft>
          <a:spcPct val="0"/>
        </a:spcAft>
        <a:defRPr sz="3200" b="1">
          <a:solidFill>
            <a:srgbClr val="003C76"/>
          </a:solidFill>
          <a:latin typeface="Arial" charset="0"/>
          <a:ea typeface="ＭＳ Ｐゴシック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200" b="1">
          <a:solidFill>
            <a:srgbClr val="003C76"/>
          </a:solidFill>
          <a:latin typeface="Arial" charset="0"/>
          <a:ea typeface="ＭＳ Ｐゴシック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200" b="1">
          <a:solidFill>
            <a:srgbClr val="003C76"/>
          </a:solidFill>
          <a:latin typeface="Arial" charset="0"/>
          <a:ea typeface="ＭＳ Ｐゴシック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200" b="1">
          <a:solidFill>
            <a:srgbClr val="003C76"/>
          </a:solidFill>
          <a:latin typeface="Arial" charset="0"/>
          <a:ea typeface="ＭＳ Ｐゴシック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rgbClr val="990033"/>
        </a:buClr>
        <a:buFont typeface="Wingdings" panose="05000000000000000000" pitchFamily="2" charset="2"/>
        <a:buChar char="§"/>
        <a:defRPr sz="2200">
          <a:solidFill>
            <a:srgbClr val="003C76"/>
          </a:solidFill>
          <a:latin typeface="+mn-lt"/>
          <a:ea typeface="MS PGothic" pitchFamily="34" charset="-128"/>
          <a:cs typeface="+mn-cs"/>
        </a:defRPr>
      </a:lvl1pPr>
      <a:lvl2pPr marL="400050" indent="-285750" algn="l" rtl="0" eaLnBrk="0" fontAlgn="base" hangingPunct="0">
        <a:spcBef>
          <a:spcPct val="20000"/>
        </a:spcBef>
        <a:spcAft>
          <a:spcPct val="0"/>
        </a:spcAft>
        <a:buClr>
          <a:srgbClr val="990033"/>
        </a:buClr>
        <a:buFont typeface="Arial" panose="020B0604020202020204" pitchFamily="34" charset="0"/>
        <a:buChar char="•"/>
        <a:defRPr>
          <a:solidFill>
            <a:srgbClr val="003C76"/>
          </a:solidFill>
          <a:latin typeface="+mn-lt"/>
          <a:ea typeface="MS PGothic" pitchFamily="34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rgbClr val="990033"/>
        </a:buClr>
        <a:buFont typeface="Wingdings" panose="05000000000000000000" pitchFamily="2" charset="2"/>
        <a:buChar char="§"/>
        <a:defRPr sz="1200">
          <a:solidFill>
            <a:srgbClr val="003C76"/>
          </a:solidFill>
          <a:latin typeface="+mn-lt"/>
          <a:ea typeface="MS PGothic" pitchFamily="34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lr>
          <a:srgbClr val="C1002B"/>
        </a:buClr>
        <a:buFont typeface="Wingdings" panose="05000000000000000000" pitchFamily="2" charset="2"/>
        <a:buChar char="§"/>
        <a:defRPr sz="800">
          <a:solidFill>
            <a:srgbClr val="003C76"/>
          </a:solidFill>
          <a:latin typeface="+mn-lt"/>
          <a:ea typeface="MS PGothic" pitchFamily="34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lr>
          <a:srgbClr val="990033"/>
        </a:buClr>
        <a:buFont typeface="Wingdings" panose="05000000000000000000" pitchFamily="2" charset="2"/>
        <a:defRPr sz="1200">
          <a:solidFill>
            <a:srgbClr val="003C76"/>
          </a:solidFill>
          <a:latin typeface="+mn-lt"/>
          <a:ea typeface="MS PGothic" pitchFamily="34" charset="-128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lr>
          <a:srgbClr val="990033"/>
        </a:buClr>
        <a:buFont typeface="Wingdings" charset="0"/>
        <a:defRPr sz="1200">
          <a:solidFill>
            <a:srgbClr val="003C76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lr>
          <a:srgbClr val="990033"/>
        </a:buClr>
        <a:buFont typeface="Wingdings" charset="0"/>
        <a:defRPr sz="1200">
          <a:solidFill>
            <a:srgbClr val="003C76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lr>
          <a:srgbClr val="990033"/>
        </a:buClr>
        <a:buFont typeface="Wingdings" charset="0"/>
        <a:defRPr sz="1200">
          <a:solidFill>
            <a:srgbClr val="003C76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lr>
          <a:srgbClr val="990033"/>
        </a:buClr>
        <a:buFont typeface="Wingdings" charset="0"/>
        <a:defRPr sz="1200">
          <a:solidFill>
            <a:srgbClr val="003C76"/>
          </a:solidFill>
          <a:latin typeface="+mn-lt"/>
          <a:ea typeface="+mn-ea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diagramLayout" Target="../diagrams/layout1.xml"/><Relationship Id="rId7" Type="http://schemas.openxmlformats.org/officeDocument/2006/relationships/image" Target="../media/image3.png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Relationship Id="rId9" Type="http://schemas.openxmlformats.org/officeDocument/2006/relationships/image" Target="../media/image5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4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3.png"/><Relationship Id="rId5" Type="http://schemas.openxmlformats.org/officeDocument/2006/relationships/hyperlink" Target="https://www.youtube.com/watch?v=u9-m68NJzPs" TargetMode="External"/><Relationship Id="rId4" Type="http://schemas.openxmlformats.org/officeDocument/2006/relationships/image" Target="../media/image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0A753C3-2854-A481-50D6-198CD96601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14400" y="1958975"/>
            <a:ext cx="10363200" cy="1470025"/>
          </a:xfrm>
          <a:noFill/>
        </p:spPr>
        <p:txBody>
          <a:bodyPr/>
          <a:lstStyle/>
          <a:p>
            <a:pPr algn="ctr">
              <a:lnSpc>
                <a:spcPct val="150000"/>
              </a:lnSpc>
            </a:pPr>
            <a:r>
              <a:rPr lang="de-DE" sz="4000" dirty="0"/>
              <a:t>Die transrektale Biopsie der Prostata</a:t>
            </a:r>
          </a:p>
        </p:txBody>
      </p:sp>
      <p:sp>
        <p:nvSpPr>
          <p:cNvPr id="8" name="Titel 1">
            <a:extLst>
              <a:ext uri="{FF2B5EF4-FFF2-40B4-BE49-F238E27FC236}">
                <a16:creationId xmlns:a16="http://schemas.microsoft.com/office/drawing/2014/main" id="{18CCBF23-F1B9-B0B5-E0ED-CE1E0D1E2EFB}"/>
              </a:ext>
            </a:extLst>
          </p:cNvPr>
          <p:cNvSpPr txBox="1">
            <a:spLocks/>
          </p:cNvSpPr>
          <p:nvPr/>
        </p:nvSpPr>
        <p:spPr bwMode="auto">
          <a:xfrm>
            <a:off x="914400" y="3068960"/>
            <a:ext cx="10363200" cy="1470025"/>
          </a:xfrm>
          <a:prstGeom prst="rect">
            <a:avLst/>
          </a:prstGeom>
          <a:noFill/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003C76"/>
                </a:solidFill>
                <a:latin typeface="+mj-lt"/>
                <a:ea typeface="MS PGothic" pitchFamily="34" charset="-128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003C76"/>
                </a:solidFill>
                <a:latin typeface="Arial" charset="0"/>
                <a:ea typeface="MS PGothic" pitchFamily="34" charset="-128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003C76"/>
                </a:solidFill>
                <a:latin typeface="Arial" charset="0"/>
                <a:ea typeface="MS PGothic" pitchFamily="34" charset="-128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003C76"/>
                </a:solidFill>
                <a:latin typeface="Arial" charset="0"/>
                <a:ea typeface="MS PGothic" pitchFamily="34" charset="-128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003C76"/>
                </a:solidFill>
                <a:latin typeface="Arial" charset="0"/>
                <a:ea typeface="MS PGothic" pitchFamily="34" charset="-128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003C76"/>
                </a:solidFill>
                <a:latin typeface="Arial" charset="0"/>
                <a:ea typeface="ＭＳ Ｐゴシック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003C76"/>
                </a:solidFill>
                <a:latin typeface="Arial" charset="0"/>
                <a:ea typeface="ＭＳ Ｐゴシック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003C76"/>
                </a:solidFill>
                <a:latin typeface="Arial" charset="0"/>
                <a:ea typeface="ＭＳ Ｐゴシック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003C76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lnSpc>
                <a:spcPct val="150000"/>
              </a:lnSpc>
            </a:pPr>
            <a:r>
              <a:rPr lang="de-DE" sz="2800" kern="0" dirty="0"/>
              <a:t>Ablauf, Risiken, Ausblick</a:t>
            </a:r>
          </a:p>
        </p:txBody>
      </p:sp>
      <p:pic>
        <p:nvPicPr>
          <p:cNvPr id="9" name="Grafik 8" descr="Blaue Schleife und Schnurrbart">
            <a:extLst>
              <a:ext uri="{FF2B5EF4-FFF2-40B4-BE49-F238E27FC236}">
                <a16:creationId xmlns:a16="http://schemas.microsoft.com/office/drawing/2014/main" id="{2F4BDB41-3A8C-7C25-A7EA-8625248D00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04512" y="5829266"/>
            <a:ext cx="1327076" cy="884717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5ECE0D24-BDE3-6396-27F5-AA03CCEE64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449" y="25316"/>
            <a:ext cx="1453902" cy="1622790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212875B9-DF84-D581-7E54-A2219C9996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7449" y="5091192"/>
            <a:ext cx="1544772" cy="1622791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C84ED256-9ACA-09BC-CFCA-FF5D8CF9AB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56744" y="5751935"/>
            <a:ext cx="2381068" cy="9620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505101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Nach dem Eingriff ...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DDB54DA-E3A6-4325-2C2C-F125AA729C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285750" indent="-285750" algn="just">
              <a:lnSpc>
                <a:spcPct val="100000"/>
              </a:lnSpc>
              <a:spcAft>
                <a:spcPts val="1600"/>
              </a:spcAft>
            </a:pPr>
            <a:r>
              <a:rPr lang="de-DE" sz="2400" dirty="0"/>
              <a:t>Stationärer Aufenthalt von einem Tag zur Überwachung.</a:t>
            </a:r>
          </a:p>
          <a:p>
            <a:pPr marL="285750" indent="-285750" algn="just">
              <a:lnSpc>
                <a:spcPct val="100000"/>
              </a:lnSpc>
              <a:spcAft>
                <a:spcPts val="1600"/>
              </a:spcAft>
            </a:pPr>
            <a:r>
              <a:rPr lang="de-DE" sz="2400" b="1" dirty="0"/>
              <a:t>Der </a:t>
            </a:r>
            <a:r>
              <a:rPr lang="de-DE" sz="2400" b="1" dirty="0" err="1"/>
              <a:t>feingewebliche</a:t>
            </a:r>
            <a:r>
              <a:rPr lang="de-DE" sz="2400" b="1" dirty="0"/>
              <a:t> Befund ist bei Entlassung häufig noch nicht vorliegend! </a:t>
            </a:r>
          </a:p>
          <a:p>
            <a:pPr marL="285750" indent="-285750" algn="just">
              <a:lnSpc>
                <a:spcPct val="100000"/>
              </a:lnSpc>
              <a:spcAft>
                <a:spcPts val="1600"/>
              </a:spcAft>
            </a:pPr>
            <a:r>
              <a:rPr lang="de-DE" sz="2400" dirty="0"/>
              <a:t>In der Regel 2-3-tägige prophylaktische antibiotische Therapie zu Hause.</a:t>
            </a:r>
          </a:p>
          <a:p>
            <a:pPr marL="285750" indent="-285750" algn="just">
              <a:lnSpc>
                <a:spcPct val="100000"/>
              </a:lnSpc>
              <a:spcAft>
                <a:spcPts val="1600"/>
              </a:spcAft>
            </a:pPr>
            <a:r>
              <a:rPr lang="de-DE" sz="2400" dirty="0"/>
              <a:t>Besprechung des Pathologiebefundes beim niedergelassenen Urologen </a:t>
            </a:r>
            <a:r>
              <a:rPr lang="de-DE" sz="2400" b="1" dirty="0"/>
              <a:t>ca. 2 Wochen </a:t>
            </a:r>
            <a:r>
              <a:rPr lang="de-DE" sz="2400" dirty="0"/>
              <a:t>nach Biopsie </a:t>
            </a:r>
            <a:r>
              <a:rPr lang="de-DE" sz="2400" dirty="0">
                <a:sym typeface="Wingdings" panose="05000000000000000000" pitchFamily="2" charset="2"/>
              </a:rPr>
              <a:t> frühzeitige Terminvereinbarung.</a:t>
            </a:r>
          </a:p>
          <a:p>
            <a:pPr marL="285750" indent="-285750" algn="just">
              <a:lnSpc>
                <a:spcPct val="100000"/>
              </a:lnSpc>
              <a:spcAft>
                <a:spcPts val="1600"/>
              </a:spcAft>
            </a:pPr>
            <a:r>
              <a:rPr lang="de-DE" sz="2400" dirty="0">
                <a:sym typeface="Wingdings" panose="05000000000000000000" pitchFamily="2" charset="2"/>
              </a:rPr>
              <a:t>Bei </a:t>
            </a:r>
            <a:r>
              <a:rPr lang="de-DE" sz="2400" b="1" dirty="0">
                <a:sym typeface="Wingdings" panose="05000000000000000000" pitchFamily="2" charset="2"/>
              </a:rPr>
              <a:t>Fieber, Schüttelfrost </a:t>
            </a:r>
            <a:r>
              <a:rPr lang="de-DE" sz="2400" dirty="0">
                <a:sym typeface="Wingdings" panose="05000000000000000000" pitchFamily="2" charset="2"/>
              </a:rPr>
              <a:t>oder </a:t>
            </a:r>
            <a:r>
              <a:rPr lang="de-DE" sz="2400" b="1" dirty="0">
                <a:sym typeface="Wingdings" panose="05000000000000000000" pitchFamily="2" charset="2"/>
              </a:rPr>
              <a:t>starkem Blut im Urin </a:t>
            </a:r>
            <a:r>
              <a:rPr lang="de-DE" sz="2400" dirty="0">
                <a:sym typeface="Wingdings" panose="05000000000000000000" pitchFamily="2" charset="2"/>
              </a:rPr>
              <a:t>ist eine erneute Vorstellung im Krankenhaus </a:t>
            </a:r>
            <a:r>
              <a:rPr lang="de-DE" sz="2400" b="1" dirty="0">
                <a:sym typeface="Wingdings" panose="05000000000000000000" pitchFamily="2" charset="2"/>
              </a:rPr>
              <a:t>umgehend</a:t>
            </a:r>
            <a:r>
              <a:rPr lang="de-DE" sz="2400" dirty="0">
                <a:sym typeface="Wingdings" panose="05000000000000000000" pitchFamily="2" charset="2"/>
              </a:rPr>
              <a:t> erforderlich!</a:t>
            </a:r>
            <a:endParaRPr lang="de-DE" sz="2400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67476"/>
            <a:ext cx="397933" cy="249238"/>
          </a:xfrm>
        </p:spPr>
        <p:txBody>
          <a:bodyPr/>
          <a:lstStyle/>
          <a:p>
            <a:pPr>
              <a:defRPr/>
            </a:pPr>
            <a:fld id="{9DA76108-F988-4EF5-96F2-4D2389D29813}" type="slidenum">
              <a:rPr lang="de-DE" altLang="de-DE" smtClean="0"/>
              <a:pPr>
                <a:defRPr/>
              </a:pPr>
              <a:t>10</a:t>
            </a:fld>
            <a:endParaRPr lang="de-DE" altLang="de-DE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F3EF094B-2BC4-97F6-C5C1-F7CFA01974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A88507EB-79B0-BE85-733D-1294D43FB3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60889F80-8C7F-DB04-31D4-D8433D260C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425739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 animBg="1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dirty="0"/>
              <a:t>Ausblick je nach histologischem Befund</a:t>
            </a:r>
          </a:p>
        </p:txBody>
      </p:sp>
      <p:graphicFrame>
        <p:nvGraphicFramePr>
          <p:cNvPr id="5" name="Inhaltsplatzhalter 4">
            <a:extLst>
              <a:ext uri="{FF2B5EF4-FFF2-40B4-BE49-F238E27FC236}">
                <a16:creationId xmlns:a16="http://schemas.microsoft.com/office/drawing/2014/main" id="{FC219F13-A8CB-37F4-518F-650AE12F1B2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609001740"/>
              </p:ext>
            </p:extLst>
          </p:nvPr>
        </p:nvGraphicFramePr>
        <p:xfrm>
          <a:off x="609600" y="1882100"/>
          <a:ext cx="10972800" cy="470852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67476"/>
            <a:ext cx="397933" cy="249238"/>
          </a:xfrm>
        </p:spPr>
        <p:txBody>
          <a:bodyPr/>
          <a:lstStyle/>
          <a:p>
            <a:pPr>
              <a:defRPr/>
            </a:pPr>
            <a:fld id="{9DA76108-F988-4EF5-96F2-4D2389D29813}" type="slidenum">
              <a:rPr lang="de-DE" altLang="de-DE" smtClean="0"/>
              <a:pPr>
                <a:defRPr/>
              </a:pPr>
              <a:t>11</a:t>
            </a:fld>
            <a:endParaRPr lang="de-DE" altLang="de-DE"/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4CEC9F6F-9D74-7198-E284-37C85E8D26F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FAC34715-1B21-BC6B-89E9-45387764EFF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11862510-F04D-CEE0-793E-E15CB537F18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58442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5" grpId="0">
        <p:bldAsOne/>
      </p:bldGraphic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0A753C3-2854-A481-50D6-198CD96601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14400" y="2302816"/>
            <a:ext cx="10363200" cy="2160240"/>
          </a:xfrm>
          <a:noFill/>
        </p:spPr>
        <p:txBody>
          <a:bodyPr/>
          <a:lstStyle/>
          <a:p>
            <a:pPr algn="ctr">
              <a:lnSpc>
                <a:spcPct val="150000"/>
              </a:lnSpc>
            </a:pPr>
            <a:r>
              <a:rPr lang="en" sz="4000" b="1" dirty="0"/>
              <a:t>Alles Gute für Ihre </a:t>
            </a:r>
            <a:r>
              <a:rPr lang="de-DE" sz="4000" b="1" dirty="0"/>
              <a:t>Biopsie</a:t>
            </a:r>
            <a:r>
              <a:rPr lang="en" sz="4000" b="1" dirty="0"/>
              <a:t> und </a:t>
            </a:r>
            <a:br>
              <a:rPr lang="en" sz="4000" b="1" dirty="0"/>
            </a:br>
            <a:r>
              <a:rPr lang="en" sz="4000" b="1" dirty="0"/>
              <a:t>eine gute Genesung!</a:t>
            </a:r>
            <a:endParaRPr lang="de-DE" sz="4000" dirty="0"/>
          </a:p>
        </p:txBody>
      </p:sp>
      <p:pic>
        <p:nvPicPr>
          <p:cNvPr id="4" name="Grafik 3" descr="Blaue Schleife und Schnurrbart">
            <a:extLst>
              <a:ext uri="{FF2B5EF4-FFF2-40B4-BE49-F238E27FC236}">
                <a16:creationId xmlns:a16="http://schemas.microsoft.com/office/drawing/2014/main" id="{8E737E8B-34C1-A774-F86A-671F840287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04512" y="5829266"/>
            <a:ext cx="1327076" cy="884717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C4D3DDCB-5B5D-96D1-C58B-DF8A95F93E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449" y="25316"/>
            <a:ext cx="1453902" cy="162279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02B76035-5C88-53E7-8B41-AA2469EEBD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7449" y="5091192"/>
            <a:ext cx="1544772" cy="1622791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79ABD4C7-C16A-F317-04AE-33DDC6DCDA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56744" y="5751935"/>
            <a:ext cx="2381068" cy="9620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0937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Was sind die Funktionen der Prostata?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DDB54DA-E3A6-4325-2C2C-F125AA729C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de-DE" sz="2800" dirty="0"/>
              <a:t>Sie bildet den hauptsächlichen Anteil der Samenflüssigkeit.</a:t>
            </a:r>
          </a:p>
          <a:p>
            <a:endParaRPr lang="de-DE" sz="2800" dirty="0"/>
          </a:p>
          <a:p>
            <a:r>
              <a:rPr lang="de-DE" sz="2800" dirty="0"/>
              <a:t>Das Sekret der Prostata fördert die Beweglichkeit der Spermien und verflüssigt das Ejakulat.</a:t>
            </a:r>
          </a:p>
          <a:p>
            <a:endParaRPr lang="de-DE" sz="2800" dirty="0"/>
          </a:p>
          <a:p>
            <a:r>
              <a:rPr lang="de-DE" sz="2800" dirty="0"/>
              <a:t>Der PSA-Wert wird ausschließlich von Drüsenzellen der Prostata gebildet und dient daher als spezifischer Marker der Prostata.</a:t>
            </a:r>
          </a:p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67476"/>
            <a:ext cx="397933" cy="249238"/>
          </a:xfrm>
        </p:spPr>
        <p:txBody>
          <a:bodyPr/>
          <a:lstStyle/>
          <a:p>
            <a:pPr>
              <a:defRPr/>
            </a:pPr>
            <a:fld id="{9DA76108-F988-4EF5-96F2-4D2389D29813}" type="slidenum">
              <a:rPr lang="de-DE" altLang="de-DE" smtClean="0"/>
              <a:pPr>
                <a:defRPr/>
              </a:pPr>
              <a:t>2</a:t>
            </a:fld>
            <a:endParaRPr lang="de-DE" altLang="de-DE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84A2819D-F3C5-3F27-DD42-DC7895332B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3E0CD9C6-D776-A06F-A1E6-A0BB2164F5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9A4156EA-E881-0EA3-5F7D-3E0FCB8599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34353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Anatomie der Prostata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DDB54DA-E3A6-4325-2C2C-F125AA729C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285750" indent="-285750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Die Prostata  umgibt die Harnröhre unterhalb der Prostata und ist von einer Kapsel straffem Bindegewebe umschlossen.</a:t>
            </a:r>
          </a:p>
          <a:p>
            <a:pPr marL="285750" indent="-285750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Grob wird die Prostata in 3 Etagen eingeteilt: Basis (direkt unterhalb der Blase); Mitte; Apex (Prostataspitze).</a:t>
            </a:r>
          </a:p>
          <a:p>
            <a:pPr marL="285750" indent="-285750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Sie wird in mehrere Zonen unterteilt, wobei die </a:t>
            </a:r>
            <a:r>
              <a:rPr lang="de-DE" sz="2800" dirty="0" err="1"/>
              <a:t>Transitionalzellzone</a:t>
            </a:r>
            <a:r>
              <a:rPr lang="de-DE" sz="2800" dirty="0"/>
              <a:t> den Hauptteil der Harnröhre umgibt.</a:t>
            </a:r>
          </a:p>
          <a:p>
            <a:pPr marL="285750" indent="-285750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Die Samenblasen liegen der Prostata hinten auf und führen ihr Sekret durch die Prostata in die Harnröhre.</a:t>
            </a:r>
          </a:p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67476"/>
            <a:ext cx="397933" cy="249238"/>
          </a:xfrm>
        </p:spPr>
        <p:txBody>
          <a:bodyPr/>
          <a:lstStyle/>
          <a:p>
            <a:pPr>
              <a:defRPr/>
            </a:pPr>
            <a:fld id="{9DA76108-F988-4EF5-96F2-4D2389D29813}" type="slidenum">
              <a:rPr lang="de-DE" altLang="de-DE" smtClean="0"/>
              <a:pPr>
                <a:defRPr/>
              </a:pPr>
              <a:t>3</a:t>
            </a:fld>
            <a:endParaRPr lang="de-DE" altLang="de-DE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2B001872-2EE8-5787-22D0-7A2BFA7F3C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B2C642E5-0AD8-0D76-A655-A3AFC52662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F3F4117D-E1D9-2AE4-9B14-2F13611A6E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42994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Das Prostatakarzinom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DDB54DA-E3A6-4325-2C2C-F125AA729C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285750" indent="-285750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Bei suspektem Tastbefund oder einem kontrolliert hohem PSA-Wert ist eine Abklärung mittels Biopsie der Prostata empfehlenswert.</a:t>
            </a:r>
          </a:p>
          <a:p>
            <a:pPr marL="285750" indent="-285750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Die meisten Prostatatumore liegen in den Außenbereichen der Prostata (periphere Zone).</a:t>
            </a:r>
          </a:p>
          <a:p>
            <a:pPr marL="285750" indent="-285750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Zur weiteren Abklärung und besseren Lokalisation eines Prostatakarzinoms, sollte ein MRT der Prostata erfolgen.</a:t>
            </a:r>
          </a:p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67476"/>
            <a:ext cx="397933" cy="249238"/>
          </a:xfrm>
        </p:spPr>
        <p:txBody>
          <a:bodyPr/>
          <a:lstStyle/>
          <a:p>
            <a:pPr>
              <a:defRPr/>
            </a:pPr>
            <a:fld id="{9DA76108-F988-4EF5-96F2-4D2389D29813}" type="slidenum">
              <a:rPr lang="de-DE" altLang="de-DE" smtClean="0"/>
              <a:pPr>
                <a:defRPr/>
              </a:pPr>
              <a:t>4</a:t>
            </a:fld>
            <a:endParaRPr lang="de-DE" altLang="de-DE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380512F8-41A9-8D7B-64B8-C02E288B38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3D369D74-0C9F-DF19-A040-2637995B33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0F1C0615-F34A-4E1F-F54F-D689AF1A64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60286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Was sind Risikofaktoren eines Prostatakarzinoms</a:t>
            </a:r>
            <a:r>
              <a:rPr lang="en" dirty="0"/>
              <a:t>?</a:t>
            </a:r>
            <a:endParaRPr lang="de-DE" dirty="0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DDB54DA-E3A6-4325-2C2C-F125AA729C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285750" indent="-285750" algn="just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Hauptrisikofaktor für die Entstehung von Prostatakarzinomen ist das </a:t>
            </a:r>
            <a:r>
              <a:rPr lang="de-DE" sz="2800" b="1" dirty="0"/>
              <a:t>Rauchen</a:t>
            </a:r>
            <a:r>
              <a:rPr lang="de-DE" sz="2800" dirty="0"/>
              <a:t>.  </a:t>
            </a:r>
            <a:endParaRPr lang="de-DE" sz="2800" b="1" dirty="0"/>
          </a:p>
          <a:p>
            <a:pPr marL="285750" indent="-285750" algn="just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Das Risiko, an Prostatakrebs zu erkranken, steigt mit </a:t>
            </a:r>
            <a:r>
              <a:rPr lang="de-DE" sz="2800" b="1" dirty="0"/>
              <a:t>zunehmendem Alter</a:t>
            </a:r>
            <a:r>
              <a:rPr lang="de-DE" sz="2800" dirty="0"/>
              <a:t>.  </a:t>
            </a:r>
          </a:p>
          <a:p>
            <a:pPr marL="285750" indent="-285750" algn="just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Die Prostatagröße ist kein Risikofaktor für ein Prostatakarzinom.</a:t>
            </a:r>
          </a:p>
          <a:p>
            <a:pPr marL="285750" indent="-285750" algn="just">
              <a:lnSpc>
                <a:spcPct val="100000"/>
              </a:lnSpc>
              <a:spcAft>
                <a:spcPts val="1600"/>
              </a:spcAft>
            </a:pPr>
            <a:r>
              <a:rPr lang="de-DE" sz="2800" dirty="0"/>
              <a:t>Es besteht eine </a:t>
            </a:r>
            <a:r>
              <a:rPr lang="de-DE" sz="2800" b="1" dirty="0"/>
              <a:t>familiäre Häufung </a:t>
            </a:r>
            <a:r>
              <a:rPr lang="de-DE" sz="2800" dirty="0"/>
              <a:t>bei direkten Familienangehörigen. Ist der Vater betroffen </a:t>
            </a:r>
            <a:r>
              <a:rPr lang="de-DE" sz="2800" dirty="0">
                <a:sym typeface="Wingdings" panose="05000000000000000000" pitchFamily="2" charset="2"/>
              </a:rPr>
              <a:t> 2-fach erhöhtes Risiko. Ist der Bruder betroffen  3-fach erhöhtes Risiko.</a:t>
            </a:r>
            <a:endParaRPr lang="de-DE" sz="3600" dirty="0"/>
          </a:p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67476"/>
            <a:ext cx="397933" cy="249238"/>
          </a:xfrm>
        </p:spPr>
        <p:txBody>
          <a:bodyPr/>
          <a:lstStyle/>
          <a:p>
            <a:pPr>
              <a:defRPr/>
            </a:pPr>
            <a:fld id="{9DA76108-F988-4EF5-96F2-4D2389D29813}" type="slidenum">
              <a:rPr lang="de-DE" altLang="de-DE" smtClean="0"/>
              <a:pPr>
                <a:defRPr/>
              </a:pPr>
              <a:t>5</a:t>
            </a:fld>
            <a:endParaRPr lang="de-DE" altLang="de-DE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949A4E2E-5462-9201-0E61-9EA16774C3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55FB91D7-FF31-1691-2317-82F282DCB4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9F035F3D-F417-A1EE-EAE4-8B0FA04F7E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18686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 animBg="1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" dirty="0"/>
              <a:t>Gibt es Anzeichen von </a:t>
            </a:r>
            <a:r>
              <a:rPr lang="de-DE" dirty="0"/>
              <a:t>Prostata</a:t>
            </a:r>
            <a:r>
              <a:rPr lang="en" dirty="0"/>
              <a:t>krebs?</a:t>
            </a:r>
            <a:endParaRPr lang="de-DE" dirty="0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DDB54DA-E3A6-4325-2C2C-F125AA729C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algn="l"/>
            <a:r>
              <a:rPr lang="de-DE" sz="2800" dirty="0"/>
              <a:t>Häufig gibt es </a:t>
            </a:r>
            <a:r>
              <a:rPr lang="de-DE" sz="2800" b="1" dirty="0"/>
              <a:t>keine spürbaren Warnsignale </a:t>
            </a:r>
            <a:r>
              <a:rPr lang="de-DE" sz="2800" dirty="0"/>
              <a:t>eines Prostatakarzinoms, daher ist die </a:t>
            </a:r>
            <a:r>
              <a:rPr lang="de-DE" sz="2800" b="1" dirty="0"/>
              <a:t>Vorsorgeuntersuchung wichtig.</a:t>
            </a:r>
          </a:p>
          <a:p>
            <a:pPr lvl="0" algn="l"/>
            <a:endParaRPr lang="de-DE" sz="2800" dirty="0"/>
          </a:p>
          <a:p>
            <a:r>
              <a:rPr lang="de-DE" sz="2800" dirty="0"/>
              <a:t>Manchmal wird bei Patienten mit problematischem Wasserlassen ein Prostatakarzinom erkannt.</a:t>
            </a:r>
          </a:p>
          <a:p>
            <a:pPr marL="285750" lvl="0" indent="-285750" algn="l">
              <a:buFont typeface="Arial" panose="020B0604020202020204" pitchFamily="34" charset="0"/>
              <a:buChar char="•"/>
            </a:pPr>
            <a:endParaRPr lang="de-DE" sz="2800" dirty="0"/>
          </a:p>
          <a:p>
            <a:r>
              <a:rPr lang="de-DE" sz="2800" dirty="0"/>
              <a:t>Bei fortgeschrittenen Prostatakarzinomen können </a:t>
            </a:r>
            <a:r>
              <a:rPr lang="de-DE" sz="2800" b="1" dirty="0"/>
              <a:t>sichtbares Blut im Urin </a:t>
            </a:r>
            <a:r>
              <a:rPr lang="de-DE" sz="2800" dirty="0"/>
              <a:t>oder sogar </a:t>
            </a:r>
            <a:r>
              <a:rPr lang="de-DE" sz="2800" b="1" dirty="0"/>
              <a:t>Knochenschmerzen im Rumpfskelett </a:t>
            </a:r>
            <a:r>
              <a:rPr lang="de-DE" sz="2800" dirty="0"/>
              <a:t>späte Warnsignale sein.</a:t>
            </a:r>
            <a:endParaRPr lang="de-DE" sz="3600" dirty="0"/>
          </a:p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67476"/>
            <a:ext cx="397933" cy="249238"/>
          </a:xfrm>
        </p:spPr>
        <p:txBody>
          <a:bodyPr/>
          <a:lstStyle/>
          <a:p>
            <a:pPr>
              <a:defRPr/>
            </a:pPr>
            <a:fld id="{9DA76108-F988-4EF5-96F2-4D2389D29813}" type="slidenum">
              <a:rPr lang="de-DE" altLang="de-DE" smtClean="0"/>
              <a:pPr>
                <a:defRPr/>
              </a:pPr>
              <a:t>6</a:t>
            </a:fld>
            <a:endParaRPr lang="de-DE" altLang="de-DE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DA504A15-406D-915C-1313-5FC8D45AC5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669A70A6-A568-6E1C-98EB-39B46BE475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B1B2B288-9F31-6CB8-5224-0715F4303A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726705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 animBg="1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dirty="0"/>
              <a:t>Sicherung eines Prostatakarzinoms? </a:t>
            </a:r>
            <a:r>
              <a:rPr lang="de-DE" dirty="0">
                <a:sym typeface="Wingdings" panose="05000000000000000000" pitchFamily="2" charset="2"/>
              </a:rPr>
              <a:t></a:t>
            </a:r>
            <a:r>
              <a:rPr lang="de-DE" dirty="0"/>
              <a:t> Biopsie!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DDB54DA-E3A6-4325-2C2C-F125AA729C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900" lvl="0" indent="-342900" algn="l">
              <a:buFont typeface="Arial" panose="020B0604020202020204" pitchFamily="34" charset="0"/>
              <a:buChar char="•"/>
            </a:pPr>
            <a:endParaRPr lang="de-DE" sz="2800" dirty="0"/>
          </a:p>
          <a:p>
            <a:pPr lvl="0" algn="l"/>
            <a:r>
              <a:rPr lang="de-DE" sz="2800" dirty="0"/>
              <a:t>MRT der Prostata zur Erkennung auffälliger Areale </a:t>
            </a:r>
            <a:r>
              <a:rPr lang="de-DE" sz="2800" dirty="0">
                <a:sym typeface="Wingdings" panose="05000000000000000000" pitchFamily="2" charset="2"/>
              </a:rPr>
              <a:t> </a:t>
            </a:r>
            <a:r>
              <a:rPr lang="de-DE" sz="2800" b="1" dirty="0">
                <a:sym typeface="Wingdings" panose="05000000000000000000" pitchFamily="2" charset="2"/>
              </a:rPr>
              <a:t>gezielte Biopsien </a:t>
            </a:r>
            <a:r>
              <a:rPr lang="de-DE" sz="2800" dirty="0">
                <a:sym typeface="Wingdings" panose="05000000000000000000" pitchFamily="2" charset="2"/>
              </a:rPr>
              <a:t>(i.d.R. 2-4 Proben pro Läsion).</a:t>
            </a:r>
            <a:endParaRPr lang="de-DE" sz="2800" b="1" dirty="0">
              <a:sym typeface="Wingdings" panose="05000000000000000000" pitchFamily="2" charset="2"/>
            </a:endParaRPr>
          </a:p>
          <a:p>
            <a:pPr marL="342900" lvl="0" indent="-342900" algn="l">
              <a:buFont typeface="Arial" panose="020B0604020202020204" pitchFamily="34" charset="0"/>
              <a:buChar char="•"/>
            </a:pPr>
            <a:endParaRPr lang="de-DE" sz="2800" b="1" dirty="0">
              <a:sym typeface="Wingdings" panose="05000000000000000000" pitchFamily="2" charset="2"/>
            </a:endParaRPr>
          </a:p>
          <a:p>
            <a:pPr lvl="0" algn="l"/>
            <a:r>
              <a:rPr lang="de-DE" sz="2800" dirty="0">
                <a:sym typeface="Wingdings" panose="05000000000000000000" pitchFamily="2" charset="2"/>
              </a:rPr>
              <a:t>Zusätzlich </a:t>
            </a:r>
            <a:r>
              <a:rPr lang="de-DE" sz="2800" b="1" dirty="0">
                <a:sym typeface="Wingdings" panose="05000000000000000000" pitchFamily="2" charset="2"/>
              </a:rPr>
              <a:t>12 randomisierte Biopsien.</a:t>
            </a:r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67476"/>
            <a:ext cx="397933" cy="249238"/>
          </a:xfrm>
        </p:spPr>
        <p:txBody>
          <a:bodyPr/>
          <a:lstStyle/>
          <a:p>
            <a:pPr>
              <a:defRPr/>
            </a:pPr>
            <a:fld id="{9DA76108-F988-4EF5-96F2-4D2389D29813}" type="slidenum">
              <a:rPr lang="de-DE" altLang="de-DE" smtClean="0"/>
              <a:pPr>
                <a:defRPr/>
              </a:pPr>
              <a:t>7</a:t>
            </a:fld>
            <a:endParaRPr lang="de-DE" altLang="de-DE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742D882C-4C56-DC9F-1915-D1BBB49910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22E182C6-DD14-C436-EC05-DBA5D8BDAA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8BBC543F-78B8-BAF5-3736-EC522936D6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201120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 animBg="1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919163"/>
            <a:ext cx="10972800" cy="868362"/>
          </a:xfrm>
        </p:spPr>
        <p:txBody>
          <a:bodyPr wrap="square" anchor="ctr">
            <a:norm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dirty="0"/>
              <a:t>Ablauf der Prostatabiopsie</a:t>
            </a:r>
          </a:p>
        </p:txBody>
      </p:sp>
      <p:pic>
        <p:nvPicPr>
          <p:cNvPr id="5" name="Prostatabiopsie_geschnitten">
            <a:hlinkClick r:id="" action="ppaction://media"/>
            <a:extLst>
              <a:ext uri="{FF2B5EF4-FFF2-40B4-BE49-F238E27FC236}">
                <a16:creationId xmlns:a16="http://schemas.microsoft.com/office/drawing/2014/main" id="{A232AAA3-4143-32AA-C1F1-12EAD571F536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910642" y="1787525"/>
            <a:ext cx="8370711" cy="4708525"/>
          </a:xfrm>
          <a:prstGeom prst="rect">
            <a:avLst/>
          </a:prstGeom>
          <a:noFill/>
        </p:spPr>
      </p:pic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38900"/>
            <a:ext cx="397933" cy="249238"/>
          </a:xfrm>
        </p:spPr>
        <p:txBody>
          <a:bodyPr wrap="square" anchor="t">
            <a:normAutofit/>
          </a:bodyPr>
          <a:lstStyle/>
          <a:p>
            <a:pPr>
              <a:spcAft>
                <a:spcPts val="600"/>
              </a:spcAft>
              <a:defRPr/>
            </a:pPr>
            <a:fld id="{9DA76108-F988-4EF5-96F2-4D2389D29813}" type="slidenum">
              <a:rPr lang="de-DE" altLang="de-DE" smtClean="0"/>
              <a:pPr>
                <a:spcAft>
                  <a:spcPts val="600"/>
                </a:spcAft>
                <a:defRPr/>
              </a:pPr>
              <a:t>8</a:t>
            </a:fld>
            <a:endParaRPr lang="de-DE" altLang="de-DE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12FB120E-CA8D-3ABE-F453-DE3032AC8E9E}"/>
              </a:ext>
            </a:extLst>
          </p:cNvPr>
          <p:cNvSpPr txBox="1"/>
          <p:nvPr/>
        </p:nvSpPr>
        <p:spPr>
          <a:xfrm>
            <a:off x="1910643" y="6588110"/>
            <a:ext cx="83707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solidFill>
                  <a:srgbClr val="003C76"/>
                </a:solidFill>
              </a:rPr>
              <a:t>Takeda </a:t>
            </a:r>
            <a:r>
              <a:rPr lang="de-DE" sz="800" dirty="0" err="1">
                <a:solidFill>
                  <a:srgbClr val="003C76"/>
                </a:solidFill>
              </a:rPr>
              <a:t>Pharma</a:t>
            </a:r>
            <a:r>
              <a:rPr lang="de-DE" sz="800" dirty="0">
                <a:solidFill>
                  <a:srgbClr val="003C76"/>
                </a:solidFill>
              </a:rPr>
              <a:t> Deutschland, </a:t>
            </a:r>
            <a:r>
              <a:rPr lang="de-DE" sz="800" dirty="0" err="1">
                <a:solidFill>
                  <a:srgbClr val="003C76"/>
                </a:solidFill>
              </a:rPr>
              <a:t>modified</a:t>
            </a:r>
            <a:r>
              <a:rPr lang="de-DE" sz="800" dirty="0">
                <a:solidFill>
                  <a:srgbClr val="003C76"/>
                </a:solidFill>
              </a:rPr>
              <a:t> </a:t>
            </a:r>
            <a:r>
              <a:rPr lang="de-DE" sz="800" dirty="0" err="1">
                <a:solidFill>
                  <a:srgbClr val="003C76"/>
                </a:solidFill>
              </a:rPr>
              <a:t>from</a:t>
            </a:r>
            <a:r>
              <a:rPr lang="de-DE" sz="800" dirty="0">
                <a:solidFill>
                  <a:srgbClr val="003C76"/>
                </a:solidFill>
              </a:rPr>
              <a:t> „Prostata-Stanzbiopsie – Gewebeentnahme aus der Prostata“, </a:t>
            </a:r>
            <a:r>
              <a:rPr lang="de-DE" sz="800" dirty="0">
                <a:solidFill>
                  <a:srgbClr val="003C76"/>
                </a:solidFill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ww.youtube.com/watch?v=u9-m68NJzPs</a:t>
            </a:r>
            <a:r>
              <a:rPr lang="de-DE" sz="800" dirty="0">
                <a:solidFill>
                  <a:srgbClr val="003C76"/>
                </a:solidFill>
              </a:rPr>
              <a:t>, 2018 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713ED113-65C0-89DC-4EAD-E1F9A2D610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9BF32E20-4627-D6B5-4513-42775FF2FA4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D503F772-880A-6BC7-C753-F8BE48AFB71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68966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5547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100000">
                <p:cTn id="1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3B18F7-7B99-C1F5-5113-3CFBA5920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dirty="0"/>
              <a:t>Was sind die Risiken bei der Biopsie?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DDB54DA-E3A6-4325-2C2C-F125AA729C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de-DE" sz="2800" dirty="0"/>
              <a:t>Leicht blutiger bis blutiger Urin (bis 14 Tage nach der OP).</a:t>
            </a:r>
          </a:p>
          <a:p>
            <a:pPr marL="342900" lvl="0" indent="-342900" algn="l">
              <a:buFont typeface="Arial" panose="020B0604020202020204" pitchFamily="34" charset="0"/>
              <a:buChar char="•"/>
            </a:pPr>
            <a:endParaRPr lang="de-DE" sz="2800" dirty="0"/>
          </a:p>
          <a:p>
            <a:r>
              <a:rPr lang="de-DE" sz="2800" dirty="0"/>
              <a:t>Fieber/Sepsis/</a:t>
            </a:r>
            <a:r>
              <a:rPr lang="de-DE" sz="2800" dirty="0" err="1"/>
              <a:t>Abzesse</a:t>
            </a:r>
            <a:r>
              <a:rPr lang="de-DE" sz="2800" dirty="0"/>
              <a:t> durchverschleppte Darmkeime.</a:t>
            </a:r>
          </a:p>
          <a:p>
            <a:pPr marL="342900" lvl="0" indent="-342900" algn="l">
              <a:buFont typeface="Arial" panose="020B0604020202020204" pitchFamily="34" charset="0"/>
              <a:buChar char="•"/>
            </a:pPr>
            <a:endParaRPr lang="de-DE" sz="2800" dirty="0"/>
          </a:p>
          <a:p>
            <a:r>
              <a:rPr lang="de-DE" sz="2800" dirty="0"/>
              <a:t>Verletzung der Harnröhre/Enddarm/Blase.</a:t>
            </a:r>
          </a:p>
          <a:p>
            <a:pPr marL="342900" lvl="0" indent="-342900" algn="l">
              <a:buFont typeface="Arial" panose="020B0604020202020204" pitchFamily="34" charset="0"/>
              <a:buChar char="•"/>
            </a:pPr>
            <a:endParaRPr lang="de-DE" sz="2800" dirty="0"/>
          </a:p>
          <a:p>
            <a:r>
              <a:rPr lang="de-DE" sz="2800" dirty="0"/>
              <a:t>Schmerzen beim Wasserlassen.</a:t>
            </a:r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E0C921F-AF42-4252-8141-14175673C5D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>
          <a:xfrm>
            <a:off x="11184467" y="6467476"/>
            <a:ext cx="397933" cy="249238"/>
          </a:xfrm>
        </p:spPr>
        <p:txBody>
          <a:bodyPr/>
          <a:lstStyle/>
          <a:p>
            <a:pPr>
              <a:defRPr/>
            </a:pPr>
            <a:fld id="{9DA76108-F988-4EF5-96F2-4D2389D29813}" type="slidenum">
              <a:rPr lang="de-DE" altLang="de-DE" smtClean="0"/>
              <a:pPr>
                <a:defRPr/>
              </a:pPr>
              <a:t>9</a:t>
            </a:fld>
            <a:endParaRPr lang="de-DE" altLang="de-DE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6227B7A9-057E-0A53-4FCC-F5AEB9953A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" y="6769"/>
            <a:ext cx="662438" cy="739388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AE7C04F8-FD5F-21D6-6385-8BE5013E53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480" y="20830"/>
            <a:ext cx="703840" cy="739388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9822C850-B83C-6BE4-22B1-FDEEE4A51B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62762" y="321882"/>
            <a:ext cx="1084881" cy="43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0143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 animBg="1"/>
    </p:bldLst>
  </p:timing>
</p:sld>
</file>

<file path=ppt/theme/theme1.xml><?xml version="1.0" encoding="utf-8"?>
<a:theme xmlns:a="http://schemas.openxmlformats.org/drawingml/2006/main" name="1_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-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9</Words>
  <Application>Microsoft Office PowerPoint</Application>
  <PresentationFormat>Breitbild</PresentationFormat>
  <Paragraphs>72</Paragraphs>
  <Slides>12</Slides>
  <Notes>0</Notes>
  <HiddenSlides>0</HiddenSlides>
  <MMClips>1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2</vt:i4>
      </vt:variant>
    </vt:vector>
  </HeadingPairs>
  <TitlesOfParts>
    <vt:vector size="15" baseType="lpstr">
      <vt:lpstr>Arial</vt:lpstr>
      <vt:lpstr>Wingdings</vt:lpstr>
      <vt:lpstr>1_Standarddesign</vt:lpstr>
      <vt:lpstr>Die transrektale Biopsie der Prostata</vt:lpstr>
      <vt:lpstr>Was sind die Funktionen der Prostata?</vt:lpstr>
      <vt:lpstr>Anatomie der Prostata</vt:lpstr>
      <vt:lpstr>Das Prostatakarzinom</vt:lpstr>
      <vt:lpstr>Was sind Risikofaktoren eines Prostatakarzinoms?</vt:lpstr>
      <vt:lpstr>Gibt es Anzeichen von Prostatakrebs?</vt:lpstr>
      <vt:lpstr>Sicherung eines Prostatakarzinoms?  Biopsie!</vt:lpstr>
      <vt:lpstr>Ablauf der Prostatabiopsie</vt:lpstr>
      <vt:lpstr>Was sind die Risiken bei der Biopsie?</vt:lpstr>
      <vt:lpstr>Nach dem Eingriff ...</vt:lpstr>
      <vt:lpstr>Ausblick je nach histologischem Befund</vt:lpstr>
      <vt:lpstr>Alles Gute für Ihre Biopsie und  eine gute Genesung!</vt:lpstr>
    </vt:vector>
  </TitlesOfParts>
  <Company>Uniklinik Main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hae0c</dc:creator>
  <cp:lastModifiedBy>Maximilian Haack</cp:lastModifiedBy>
  <cp:revision>135</cp:revision>
  <cp:lastPrinted>2017-06-29T11:30:32Z</cp:lastPrinted>
  <dcterms:created xsi:type="dcterms:W3CDTF">2009-03-04T16:17:31Z</dcterms:created>
  <dcterms:modified xsi:type="dcterms:W3CDTF">2023-10-11T08:49:12Z</dcterms:modified>
</cp:coreProperties>
</file>